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2"/>
  </p:notesMasterIdLst>
  <p:sldIdLst>
    <p:sldId id="256" r:id="rId2"/>
    <p:sldId id="273" r:id="rId3"/>
    <p:sldId id="259" r:id="rId4"/>
    <p:sldId id="260" r:id="rId5"/>
    <p:sldId id="261" r:id="rId6"/>
    <p:sldId id="284" r:id="rId7"/>
    <p:sldId id="291" r:id="rId8"/>
    <p:sldId id="289" r:id="rId9"/>
    <p:sldId id="277" r:id="rId10"/>
    <p:sldId id="276" r:id="rId11"/>
    <p:sldId id="285" r:id="rId12"/>
    <p:sldId id="278" r:id="rId13"/>
    <p:sldId id="279" r:id="rId14"/>
    <p:sldId id="266" r:id="rId15"/>
    <p:sldId id="267" r:id="rId16"/>
    <p:sldId id="286" r:id="rId17"/>
    <p:sldId id="271" r:id="rId18"/>
    <p:sldId id="287" r:id="rId19"/>
    <p:sldId id="292" r:id="rId20"/>
    <p:sldId id="293" r:id="rId21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27102A9-8310-4765-A935-A1911B00CA55}" styleName="Style léger 1 - Accentuation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9" autoAdjust="0"/>
    <p:restoredTop sz="94280" autoAdjust="0"/>
  </p:normalViewPr>
  <p:slideViewPr>
    <p:cSldViewPr snapToGrid="0">
      <p:cViewPr varScale="1">
        <p:scale>
          <a:sx n="75" d="100"/>
          <a:sy n="75" d="100"/>
        </p:scale>
        <p:origin x="7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0DBC32A-FEEE-4339-B0C3-F3ACAED2CC88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fr-FR"/>
        </a:p>
      </dgm:t>
    </dgm:pt>
    <dgm:pt modelId="{2A717364-0791-49DE-8C4B-F7666A6CC551}">
      <dgm:prSet phldrT="[Texte]"/>
      <dgm:spPr>
        <a:solidFill>
          <a:srgbClr val="FF9900"/>
        </a:solidFill>
      </dgm:spPr>
      <dgm:t>
        <a:bodyPr/>
        <a:lstStyle/>
        <a:p>
          <a:r>
            <a:rPr lang="fr-FR" dirty="0" err="1"/>
            <a:t>Recovery</a:t>
          </a:r>
          <a:endParaRPr lang="fr-FR" dirty="0"/>
        </a:p>
      </dgm:t>
    </dgm:pt>
    <dgm:pt modelId="{427C4EC9-4F5D-4699-A915-820ECB711695}" type="parTrans" cxnId="{84F1FF8D-7799-4C59-9CB2-6DD963920AF9}">
      <dgm:prSet/>
      <dgm:spPr/>
      <dgm:t>
        <a:bodyPr/>
        <a:lstStyle/>
        <a:p>
          <a:endParaRPr lang="fr-FR"/>
        </a:p>
      </dgm:t>
    </dgm:pt>
    <dgm:pt modelId="{88F4BE9A-8363-40C4-AC4A-BC02E6DE000B}" type="sibTrans" cxnId="{84F1FF8D-7799-4C59-9CB2-6DD963920AF9}">
      <dgm:prSet/>
      <dgm:spPr/>
      <dgm:t>
        <a:bodyPr/>
        <a:lstStyle/>
        <a:p>
          <a:endParaRPr lang="fr-FR"/>
        </a:p>
      </dgm:t>
    </dgm:pt>
    <dgm:pt modelId="{933B85CF-F20C-4CC2-B637-55F7C5347C8F}">
      <dgm:prSet phldrT="[Texte]"/>
      <dgm:spPr>
        <a:solidFill>
          <a:srgbClr val="FF0000"/>
        </a:solidFill>
      </dgm:spPr>
      <dgm:t>
        <a:bodyPr/>
        <a:lstStyle/>
        <a:p>
          <a:r>
            <a:rPr lang="fr-FR" dirty="0"/>
            <a:t>Transfer</a:t>
          </a:r>
        </a:p>
      </dgm:t>
    </dgm:pt>
    <dgm:pt modelId="{DAEEC165-7B80-44F3-B32C-AD1729F78B13}" type="parTrans" cxnId="{F3739E1E-F62D-4EB0-B1E4-947EAEAC1B97}">
      <dgm:prSet/>
      <dgm:spPr/>
      <dgm:t>
        <a:bodyPr/>
        <a:lstStyle/>
        <a:p>
          <a:endParaRPr lang="fr-FR"/>
        </a:p>
      </dgm:t>
    </dgm:pt>
    <dgm:pt modelId="{9500DCF0-F65F-404C-95C2-8FBE1BDA22DF}" type="sibTrans" cxnId="{F3739E1E-F62D-4EB0-B1E4-947EAEAC1B97}">
      <dgm:prSet/>
      <dgm:spPr/>
      <dgm:t>
        <a:bodyPr/>
        <a:lstStyle/>
        <a:p>
          <a:endParaRPr lang="fr-FR"/>
        </a:p>
      </dgm:t>
    </dgm:pt>
    <dgm:pt modelId="{3680FF23-AA6A-4913-B580-1876A835A9D0}">
      <dgm:prSet phldrT="[Texte]"/>
      <dgm:spPr>
        <a:solidFill>
          <a:srgbClr val="92D050"/>
        </a:solidFill>
      </dgm:spPr>
      <dgm:t>
        <a:bodyPr/>
        <a:lstStyle/>
        <a:p>
          <a:r>
            <a:rPr lang="fr-FR" dirty="0" err="1"/>
            <a:t>Recovery</a:t>
          </a:r>
          <a:r>
            <a:rPr lang="fr-FR" dirty="0"/>
            <a:t> box</a:t>
          </a:r>
        </a:p>
      </dgm:t>
    </dgm:pt>
    <dgm:pt modelId="{4EE83B5F-5093-4C62-B2C3-F75037F60147}" type="parTrans" cxnId="{7E927289-6D98-420B-8A1C-173CE6353D4D}">
      <dgm:prSet/>
      <dgm:spPr/>
      <dgm:t>
        <a:bodyPr/>
        <a:lstStyle/>
        <a:p>
          <a:endParaRPr lang="fr-FR"/>
        </a:p>
      </dgm:t>
    </dgm:pt>
    <dgm:pt modelId="{C4F2164B-09CE-4E4E-A578-269B44AFDCE9}" type="sibTrans" cxnId="{7E927289-6D98-420B-8A1C-173CE6353D4D}">
      <dgm:prSet/>
      <dgm:spPr/>
      <dgm:t>
        <a:bodyPr/>
        <a:lstStyle/>
        <a:p>
          <a:endParaRPr lang="fr-FR"/>
        </a:p>
      </dgm:t>
    </dgm:pt>
    <dgm:pt modelId="{2AC728C0-56D5-4BCC-9016-C99A0A9CCBE1}" type="pres">
      <dgm:prSet presAssocID="{B0DBC32A-FEEE-4339-B0C3-F3ACAED2CC88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962088DA-9B81-4BDE-AE49-3BA510CB2001}" type="pres">
      <dgm:prSet presAssocID="{2A717364-0791-49DE-8C4B-F7666A6CC551}" presName="hierRoot1" presStyleCnt="0">
        <dgm:presLayoutVars>
          <dgm:hierBranch val="init"/>
        </dgm:presLayoutVars>
      </dgm:prSet>
      <dgm:spPr/>
    </dgm:pt>
    <dgm:pt modelId="{AC4D519C-68E1-4837-B0E9-F78C94B93A66}" type="pres">
      <dgm:prSet presAssocID="{2A717364-0791-49DE-8C4B-F7666A6CC551}" presName="rootComposite1" presStyleCnt="0"/>
      <dgm:spPr/>
    </dgm:pt>
    <dgm:pt modelId="{039725C4-E9F5-41EE-8380-ADEF207E1E7D}" type="pres">
      <dgm:prSet presAssocID="{2A717364-0791-49DE-8C4B-F7666A6CC551}" presName="rootText1" presStyleLbl="node0" presStyleIdx="0" presStyleCnt="1">
        <dgm:presLayoutVars>
          <dgm:chPref val="3"/>
        </dgm:presLayoutVars>
      </dgm:prSet>
      <dgm:spPr/>
    </dgm:pt>
    <dgm:pt modelId="{EB86FBF5-6764-44EB-BD40-7EACF825EA23}" type="pres">
      <dgm:prSet presAssocID="{2A717364-0791-49DE-8C4B-F7666A6CC551}" presName="rootConnector1" presStyleLbl="node1" presStyleIdx="0" presStyleCnt="0"/>
      <dgm:spPr/>
    </dgm:pt>
    <dgm:pt modelId="{8DE1E923-C0CA-4EF3-9581-0FA56EE8A9C5}" type="pres">
      <dgm:prSet presAssocID="{2A717364-0791-49DE-8C4B-F7666A6CC551}" presName="hierChild2" presStyleCnt="0"/>
      <dgm:spPr/>
    </dgm:pt>
    <dgm:pt modelId="{08EF2953-B376-44D7-ACA5-E51EFAF99DEF}" type="pres">
      <dgm:prSet presAssocID="{DAEEC165-7B80-44F3-B32C-AD1729F78B13}" presName="Name37" presStyleLbl="parChTrans1D2" presStyleIdx="0" presStyleCnt="2"/>
      <dgm:spPr/>
    </dgm:pt>
    <dgm:pt modelId="{7BC08FB2-5CC5-4FB4-83D7-16AE6226D710}" type="pres">
      <dgm:prSet presAssocID="{933B85CF-F20C-4CC2-B637-55F7C5347C8F}" presName="hierRoot2" presStyleCnt="0">
        <dgm:presLayoutVars>
          <dgm:hierBranch val="init"/>
        </dgm:presLayoutVars>
      </dgm:prSet>
      <dgm:spPr/>
    </dgm:pt>
    <dgm:pt modelId="{33CEF88D-56BC-4676-94B3-FF58EB6861CE}" type="pres">
      <dgm:prSet presAssocID="{933B85CF-F20C-4CC2-B637-55F7C5347C8F}" presName="rootComposite" presStyleCnt="0"/>
      <dgm:spPr/>
    </dgm:pt>
    <dgm:pt modelId="{A441B396-EA70-4381-9AA6-6C936547D053}" type="pres">
      <dgm:prSet presAssocID="{933B85CF-F20C-4CC2-B637-55F7C5347C8F}" presName="rootText" presStyleLbl="node2" presStyleIdx="0" presStyleCnt="2">
        <dgm:presLayoutVars>
          <dgm:chPref val="3"/>
        </dgm:presLayoutVars>
      </dgm:prSet>
      <dgm:spPr/>
    </dgm:pt>
    <dgm:pt modelId="{F46E70D4-2D0A-4811-9EEE-1084752667E4}" type="pres">
      <dgm:prSet presAssocID="{933B85CF-F20C-4CC2-B637-55F7C5347C8F}" presName="rootConnector" presStyleLbl="node2" presStyleIdx="0" presStyleCnt="2"/>
      <dgm:spPr/>
    </dgm:pt>
    <dgm:pt modelId="{F78C2010-9442-4E4E-BBFA-08A078C39F8C}" type="pres">
      <dgm:prSet presAssocID="{933B85CF-F20C-4CC2-B637-55F7C5347C8F}" presName="hierChild4" presStyleCnt="0"/>
      <dgm:spPr/>
    </dgm:pt>
    <dgm:pt modelId="{8265803E-0325-4688-B8C9-1081D5E0146E}" type="pres">
      <dgm:prSet presAssocID="{933B85CF-F20C-4CC2-B637-55F7C5347C8F}" presName="hierChild5" presStyleCnt="0"/>
      <dgm:spPr/>
    </dgm:pt>
    <dgm:pt modelId="{570B54B0-D309-4B20-BA51-3A8EAFFF8841}" type="pres">
      <dgm:prSet presAssocID="{4EE83B5F-5093-4C62-B2C3-F75037F60147}" presName="Name37" presStyleLbl="parChTrans1D2" presStyleIdx="1" presStyleCnt="2"/>
      <dgm:spPr/>
    </dgm:pt>
    <dgm:pt modelId="{76895D85-5495-4274-8B3D-5D0751E26D8A}" type="pres">
      <dgm:prSet presAssocID="{3680FF23-AA6A-4913-B580-1876A835A9D0}" presName="hierRoot2" presStyleCnt="0">
        <dgm:presLayoutVars>
          <dgm:hierBranch val="init"/>
        </dgm:presLayoutVars>
      </dgm:prSet>
      <dgm:spPr/>
    </dgm:pt>
    <dgm:pt modelId="{664CEDBE-EFEE-4EE9-B386-0F2CFA08E145}" type="pres">
      <dgm:prSet presAssocID="{3680FF23-AA6A-4913-B580-1876A835A9D0}" presName="rootComposite" presStyleCnt="0"/>
      <dgm:spPr/>
    </dgm:pt>
    <dgm:pt modelId="{93051E59-9173-4954-82C7-83087060739B}" type="pres">
      <dgm:prSet presAssocID="{3680FF23-AA6A-4913-B580-1876A835A9D0}" presName="rootText" presStyleLbl="node2" presStyleIdx="1" presStyleCnt="2">
        <dgm:presLayoutVars>
          <dgm:chPref val="3"/>
        </dgm:presLayoutVars>
      </dgm:prSet>
      <dgm:spPr/>
    </dgm:pt>
    <dgm:pt modelId="{56B76DB6-3EFC-486F-AEBE-14BF07115C09}" type="pres">
      <dgm:prSet presAssocID="{3680FF23-AA6A-4913-B580-1876A835A9D0}" presName="rootConnector" presStyleLbl="node2" presStyleIdx="1" presStyleCnt="2"/>
      <dgm:spPr/>
    </dgm:pt>
    <dgm:pt modelId="{2A9FEC7B-BD38-4F7F-892A-6EA09E30C83D}" type="pres">
      <dgm:prSet presAssocID="{3680FF23-AA6A-4913-B580-1876A835A9D0}" presName="hierChild4" presStyleCnt="0"/>
      <dgm:spPr/>
    </dgm:pt>
    <dgm:pt modelId="{57B628B5-0E3E-4317-AE8A-4826518C67D5}" type="pres">
      <dgm:prSet presAssocID="{3680FF23-AA6A-4913-B580-1876A835A9D0}" presName="hierChild5" presStyleCnt="0"/>
      <dgm:spPr/>
    </dgm:pt>
    <dgm:pt modelId="{E5B4395C-068D-4442-A339-71DC870D7393}" type="pres">
      <dgm:prSet presAssocID="{2A717364-0791-49DE-8C4B-F7666A6CC551}" presName="hierChild3" presStyleCnt="0"/>
      <dgm:spPr/>
    </dgm:pt>
  </dgm:ptLst>
  <dgm:cxnLst>
    <dgm:cxn modelId="{1C9C0F01-EAA7-49D1-B21A-EB1A1C8D2B9B}" type="presOf" srcId="{B0DBC32A-FEEE-4339-B0C3-F3ACAED2CC88}" destId="{2AC728C0-56D5-4BCC-9016-C99A0A9CCBE1}" srcOrd="0" destOrd="0" presId="urn:microsoft.com/office/officeart/2005/8/layout/orgChart1"/>
    <dgm:cxn modelId="{F3739E1E-F62D-4EB0-B1E4-947EAEAC1B97}" srcId="{2A717364-0791-49DE-8C4B-F7666A6CC551}" destId="{933B85CF-F20C-4CC2-B637-55F7C5347C8F}" srcOrd="0" destOrd="0" parTransId="{DAEEC165-7B80-44F3-B32C-AD1729F78B13}" sibTransId="{9500DCF0-F65F-404C-95C2-8FBE1BDA22DF}"/>
    <dgm:cxn modelId="{A90F1327-1705-442A-88FE-8E0B85898251}" type="presOf" srcId="{2A717364-0791-49DE-8C4B-F7666A6CC551}" destId="{039725C4-E9F5-41EE-8380-ADEF207E1E7D}" srcOrd="0" destOrd="0" presId="urn:microsoft.com/office/officeart/2005/8/layout/orgChart1"/>
    <dgm:cxn modelId="{58B7FE42-CF6C-4AA5-87B3-CA26B21D1CAD}" type="presOf" srcId="{3680FF23-AA6A-4913-B580-1876A835A9D0}" destId="{56B76DB6-3EFC-486F-AEBE-14BF07115C09}" srcOrd="1" destOrd="0" presId="urn:microsoft.com/office/officeart/2005/8/layout/orgChart1"/>
    <dgm:cxn modelId="{8421E170-6ECF-4BB5-97B7-FA606CD5E36E}" type="presOf" srcId="{DAEEC165-7B80-44F3-B32C-AD1729F78B13}" destId="{08EF2953-B376-44D7-ACA5-E51EFAF99DEF}" srcOrd="0" destOrd="0" presId="urn:microsoft.com/office/officeart/2005/8/layout/orgChart1"/>
    <dgm:cxn modelId="{7F74667B-C5EF-4163-A948-C838E0B0B54F}" type="presOf" srcId="{4EE83B5F-5093-4C62-B2C3-F75037F60147}" destId="{570B54B0-D309-4B20-BA51-3A8EAFFF8841}" srcOrd="0" destOrd="0" presId="urn:microsoft.com/office/officeart/2005/8/layout/orgChart1"/>
    <dgm:cxn modelId="{7E927289-6D98-420B-8A1C-173CE6353D4D}" srcId="{2A717364-0791-49DE-8C4B-F7666A6CC551}" destId="{3680FF23-AA6A-4913-B580-1876A835A9D0}" srcOrd="1" destOrd="0" parTransId="{4EE83B5F-5093-4C62-B2C3-F75037F60147}" sibTransId="{C4F2164B-09CE-4E4E-A578-269B44AFDCE9}"/>
    <dgm:cxn modelId="{16A52E8B-C57A-4339-ACBE-F31C36D01A3D}" type="presOf" srcId="{933B85CF-F20C-4CC2-B637-55F7C5347C8F}" destId="{A441B396-EA70-4381-9AA6-6C936547D053}" srcOrd="0" destOrd="0" presId="urn:microsoft.com/office/officeart/2005/8/layout/orgChart1"/>
    <dgm:cxn modelId="{84F1FF8D-7799-4C59-9CB2-6DD963920AF9}" srcId="{B0DBC32A-FEEE-4339-B0C3-F3ACAED2CC88}" destId="{2A717364-0791-49DE-8C4B-F7666A6CC551}" srcOrd="0" destOrd="0" parTransId="{427C4EC9-4F5D-4699-A915-820ECB711695}" sibTransId="{88F4BE9A-8363-40C4-AC4A-BC02E6DE000B}"/>
    <dgm:cxn modelId="{DD0D658F-764A-42C9-8FF0-5AC43B7EB27E}" type="presOf" srcId="{933B85CF-F20C-4CC2-B637-55F7C5347C8F}" destId="{F46E70D4-2D0A-4811-9EEE-1084752667E4}" srcOrd="1" destOrd="0" presId="urn:microsoft.com/office/officeart/2005/8/layout/orgChart1"/>
    <dgm:cxn modelId="{0F7C07B5-A699-4390-A218-38D36B33A466}" type="presOf" srcId="{2A717364-0791-49DE-8C4B-F7666A6CC551}" destId="{EB86FBF5-6764-44EB-BD40-7EACF825EA23}" srcOrd="1" destOrd="0" presId="urn:microsoft.com/office/officeart/2005/8/layout/orgChart1"/>
    <dgm:cxn modelId="{772669BC-5689-4F3C-9D1B-C23CFE0FC8F0}" type="presOf" srcId="{3680FF23-AA6A-4913-B580-1876A835A9D0}" destId="{93051E59-9173-4954-82C7-83087060739B}" srcOrd="0" destOrd="0" presId="urn:microsoft.com/office/officeart/2005/8/layout/orgChart1"/>
    <dgm:cxn modelId="{33600A75-3AEF-439B-BA30-DB3D4D0E7005}" type="presParOf" srcId="{2AC728C0-56D5-4BCC-9016-C99A0A9CCBE1}" destId="{962088DA-9B81-4BDE-AE49-3BA510CB2001}" srcOrd="0" destOrd="0" presId="urn:microsoft.com/office/officeart/2005/8/layout/orgChart1"/>
    <dgm:cxn modelId="{40119E6F-E835-4532-B984-F675CD1D81AD}" type="presParOf" srcId="{962088DA-9B81-4BDE-AE49-3BA510CB2001}" destId="{AC4D519C-68E1-4837-B0E9-F78C94B93A66}" srcOrd="0" destOrd="0" presId="urn:microsoft.com/office/officeart/2005/8/layout/orgChart1"/>
    <dgm:cxn modelId="{37D81198-CAFE-4AD3-8BD9-AB6BAB11A873}" type="presParOf" srcId="{AC4D519C-68E1-4837-B0E9-F78C94B93A66}" destId="{039725C4-E9F5-41EE-8380-ADEF207E1E7D}" srcOrd="0" destOrd="0" presId="urn:microsoft.com/office/officeart/2005/8/layout/orgChart1"/>
    <dgm:cxn modelId="{D8DC7C55-E883-49BC-8D38-289C5114954A}" type="presParOf" srcId="{AC4D519C-68E1-4837-B0E9-F78C94B93A66}" destId="{EB86FBF5-6764-44EB-BD40-7EACF825EA23}" srcOrd="1" destOrd="0" presId="urn:microsoft.com/office/officeart/2005/8/layout/orgChart1"/>
    <dgm:cxn modelId="{4BB32CC3-95B2-4B4E-B43C-8B77A04D8ACB}" type="presParOf" srcId="{962088DA-9B81-4BDE-AE49-3BA510CB2001}" destId="{8DE1E923-C0CA-4EF3-9581-0FA56EE8A9C5}" srcOrd="1" destOrd="0" presId="urn:microsoft.com/office/officeart/2005/8/layout/orgChart1"/>
    <dgm:cxn modelId="{1A00A6C0-2EC8-4D8B-B8AD-7D1314761032}" type="presParOf" srcId="{8DE1E923-C0CA-4EF3-9581-0FA56EE8A9C5}" destId="{08EF2953-B376-44D7-ACA5-E51EFAF99DEF}" srcOrd="0" destOrd="0" presId="urn:microsoft.com/office/officeart/2005/8/layout/orgChart1"/>
    <dgm:cxn modelId="{D5BD1CF4-32D9-467A-8E20-C2ECE197A5A8}" type="presParOf" srcId="{8DE1E923-C0CA-4EF3-9581-0FA56EE8A9C5}" destId="{7BC08FB2-5CC5-4FB4-83D7-16AE6226D710}" srcOrd="1" destOrd="0" presId="urn:microsoft.com/office/officeart/2005/8/layout/orgChart1"/>
    <dgm:cxn modelId="{40BAF8FE-D22E-4402-A28B-E84E5F5FE8E6}" type="presParOf" srcId="{7BC08FB2-5CC5-4FB4-83D7-16AE6226D710}" destId="{33CEF88D-56BC-4676-94B3-FF58EB6861CE}" srcOrd="0" destOrd="0" presId="urn:microsoft.com/office/officeart/2005/8/layout/orgChart1"/>
    <dgm:cxn modelId="{E97F06E2-7A0C-4831-8AB2-720AF3AE166C}" type="presParOf" srcId="{33CEF88D-56BC-4676-94B3-FF58EB6861CE}" destId="{A441B396-EA70-4381-9AA6-6C936547D053}" srcOrd="0" destOrd="0" presId="urn:microsoft.com/office/officeart/2005/8/layout/orgChart1"/>
    <dgm:cxn modelId="{86D10438-F42F-4FFA-9537-6997F48683C8}" type="presParOf" srcId="{33CEF88D-56BC-4676-94B3-FF58EB6861CE}" destId="{F46E70D4-2D0A-4811-9EEE-1084752667E4}" srcOrd="1" destOrd="0" presId="urn:microsoft.com/office/officeart/2005/8/layout/orgChart1"/>
    <dgm:cxn modelId="{23FE5C22-F303-4A3E-9F27-CCEBDFA42675}" type="presParOf" srcId="{7BC08FB2-5CC5-4FB4-83D7-16AE6226D710}" destId="{F78C2010-9442-4E4E-BBFA-08A078C39F8C}" srcOrd="1" destOrd="0" presId="urn:microsoft.com/office/officeart/2005/8/layout/orgChart1"/>
    <dgm:cxn modelId="{FF2F653A-3973-44FA-9C99-385991CE2F55}" type="presParOf" srcId="{7BC08FB2-5CC5-4FB4-83D7-16AE6226D710}" destId="{8265803E-0325-4688-B8C9-1081D5E0146E}" srcOrd="2" destOrd="0" presId="urn:microsoft.com/office/officeart/2005/8/layout/orgChart1"/>
    <dgm:cxn modelId="{A429210C-C032-4F96-B53B-4ED44D32620F}" type="presParOf" srcId="{8DE1E923-C0CA-4EF3-9581-0FA56EE8A9C5}" destId="{570B54B0-D309-4B20-BA51-3A8EAFFF8841}" srcOrd="2" destOrd="0" presId="urn:microsoft.com/office/officeart/2005/8/layout/orgChart1"/>
    <dgm:cxn modelId="{65C28C77-8D8B-4BDA-A285-5A6DAE73673B}" type="presParOf" srcId="{8DE1E923-C0CA-4EF3-9581-0FA56EE8A9C5}" destId="{76895D85-5495-4274-8B3D-5D0751E26D8A}" srcOrd="3" destOrd="0" presId="urn:microsoft.com/office/officeart/2005/8/layout/orgChart1"/>
    <dgm:cxn modelId="{62974F70-20A0-400A-BF4E-F03AA80E90F5}" type="presParOf" srcId="{76895D85-5495-4274-8B3D-5D0751E26D8A}" destId="{664CEDBE-EFEE-4EE9-B386-0F2CFA08E145}" srcOrd="0" destOrd="0" presId="urn:microsoft.com/office/officeart/2005/8/layout/orgChart1"/>
    <dgm:cxn modelId="{9636BA53-725A-4B03-8BDB-290164830528}" type="presParOf" srcId="{664CEDBE-EFEE-4EE9-B386-0F2CFA08E145}" destId="{93051E59-9173-4954-82C7-83087060739B}" srcOrd="0" destOrd="0" presId="urn:microsoft.com/office/officeart/2005/8/layout/orgChart1"/>
    <dgm:cxn modelId="{3410DC90-8EE0-4927-B9F8-00B2A991CA5C}" type="presParOf" srcId="{664CEDBE-EFEE-4EE9-B386-0F2CFA08E145}" destId="{56B76DB6-3EFC-486F-AEBE-14BF07115C09}" srcOrd="1" destOrd="0" presId="urn:microsoft.com/office/officeart/2005/8/layout/orgChart1"/>
    <dgm:cxn modelId="{C3A1985E-9578-46FD-9E03-B9B1BE350F83}" type="presParOf" srcId="{76895D85-5495-4274-8B3D-5D0751E26D8A}" destId="{2A9FEC7B-BD38-4F7F-892A-6EA09E30C83D}" srcOrd="1" destOrd="0" presId="urn:microsoft.com/office/officeart/2005/8/layout/orgChart1"/>
    <dgm:cxn modelId="{A28F8C17-212B-4CB6-A5AE-34CEA2BFE516}" type="presParOf" srcId="{76895D85-5495-4274-8B3D-5D0751E26D8A}" destId="{57B628B5-0E3E-4317-AE8A-4826518C67D5}" srcOrd="2" destOrd="0" presId="urn:microsoft.com/office/officeart/2005/8/layout/orgChart1"/>
    <dgm:cxn modelId="{B2B307F4-3E80-41F8-810A-1E0BA77467C6}" type="presParOf" srcId="{962088DA-9B81-4BDE-AE49-3BA510CB2001}" destId="{E5B4395C-068D-4442-A339-71DC870D7393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40C24801-94B7-4A57-9B7D-5F71444535AD}" type="doc">
      <dgm:prSet loTypeId="urn:microsoft.com/office/officeart/2005/8/layout/hProcess11" loCatId="process" qsTypeId="urn:microsoft.com/office/officeart/2005/8/quickstyle/simple1" qsCatId="simple" csTypeId="urn:microsoft.com/office/officeart/2005/8/colors/accent1_2" csCatId="accent1" phldr="1"/>
      <dgm:spPr/>
    </dgm:pt>
    <dgm:pt modelId="{E496F8C2-5C83-4F50-BD69-78D3B2CD67D0}">
      <dgm:prSet phldrT="[Texte]"/>
      <dgm:spPr/>
      <dgm:t>
        <a:bodyPr/>
        <a:lstStyle/>
        <a:p>
          <a:endParaRPr lang="fr-FR" b="1" dirty="0"/>
        </a:p>
      </dgm:t>
    </dgm:pt>
    <dgm:pt modelId="{AA339A52-B54C-442B-9C71-21EB107BA0E3}" type="parTrans" cxnId="{9E90AC1C-46D0-4614-A190-99A174FABAF8}">
      <dgm:prSet/>
      <dgm:spPr/>
      <dgm:t>
        <a:bodyPr/>
        <a:lstStyle/>
        <a:p>
          <a:endParaRPr lang="fr-FR"/>
        </a:p>
      </dgm:t>
    </dgm:pt>
    <dgm:pt modelId="{B9F55BBD-DA01-4B5C-9A32-2DC2FDE1EF01}" type="sibTrans" cxnId="{9E90AC1C-46D0-4614-A190-99A174FABAF8}">
      <dgm:prSet/>
      <dgm:spPr/>
      <dgm:t>
        <a:bodyPr/>
        <a:lstStyle/>
        <a:p>
          <a:endParaRPr lang="fr-FR"/>
        </a:p>
      </dgm:t>
    </dgm:pt>
    <dgm:pt modelId="{31B0F5EA-3831-4E72-B3CB-13F87BFBDE78}">
      <dgm:prSet phldrT="[Texte]" custT="1"/>
      <dgm:spPr/>
      <dgm:t>
        <a:bodyPr/>
        <a:lstStyle/>
        <a:p>
          <a:endParaRPr lang="fr-FR" sz="1600" b="1" dirty="0"/>
        </a:p>
      </dgm:t>
    </dgm:pt>
    <dgm:pt modelId="{09F38C1F-E9E0-4D71-BEAC-C8CF95DFC2FA}" type="parTrans" cxnId="{DDA59073-E14B-439D-B989-768F455FD98D}">
      <dgm:prSet/>
      <dgm:spPr/>
      <dgm:t>
        <a:bodyPr/>
        <a:lstStyle/>
        <a:p>
          <a:endParaRPr lang="fr-FR"/>
        </a:p>
      </dgm:t>
    </dgm:pt>
    <dgm:pt modelId="{488D3F11-A555-4833-8A7C-61FFBA1C3D34}" type="sibTrans" cxnId="{DDA59073-E14B-439D-B989-768F455FD98D}">
      <dgm:prSet/>
      <dgm:spPr/>
      <dgm:t>
        <a:bodyPr/>
        <a:lstStyle/>
        <a:p>
          <a:endParaRPr lang="fr-FR"/>
        </a:p>
      </dgm:t>
    </dgm:pt>
    <dgm:pt modelId="{02D4E1F2-26B3-43B5-8EEB-75F6E9CC5DA1}">
      <dgm:prSet phldrT="[Texte]" custT="1"/>
      <dgm:spPr/>
      <dgm:t>
        <a:bodyPr/>
        <a:lstStyle/>
        <a:p>
          <a:endParaRPr lang="fr-FR" sz="1800" dirty="0"/>
        </a:p>
      </dgm:t>
    </dgm:pt>
    <dgm:pt modelId="{1DF2D02F-44F0-4B9C-8003-268D122069CE}" type="parTrans" cxnId="{6731801A-BCA2-42C9-A17A-DACA2293F2C5}">
      <dgm:prSet/>
      <dgm:spPr/>
      <dgm:t>
        <a:bodyPr/>
        <a:lstStyle/>
        <a:p>
          <a:endParaRPr lang="fr-FR"/>
        </a:p>
      </dgm:t>
    </dgm:pt>
    <dgm:pt modelId="{A28046F4-27BB-4AC0-A22A-F733C8948880}" type="sibTrans" cxnId="{6731801A-BCA2-42C9-A17A-DACA2293F2C5}">
      <dgm:prSet/>
      <dgm:spPr/>
      <dgm:t>
        <a:bodyPr/>
        <a:lstStyle/>
        <a:p>
          <a:endParaRPr lang="fr-FR"/>
        </a:p>
      </dgm:t>
    </dgm:pt>
    <dgm:pt modelId="{99D4859D-C334-43D5-8A83-F8CCCDE10804}">
      <dgm:prSet phldrT="[Texte]" custT="1"/>
      <dgm:spPr/>
      <dgm:t>
        <a:bodyPr/>
        <a:lstStyle/>
        <a:p>
          <a:endParaRPr lang="fr-FR" sz="1800" dirty="0"/>
        </a:p>
      </dgm:t>
    </dgm:pt>
    <dgm:pt modelId="{F64ADC85-C6E1-47FE-9B41-8F3922B888FA}" type="parTrans" cxnId="{EC6890A4-7F6B-4EF6-9A2A-FB020E74889F}">
      <dgm:prSet/>
      <dgm:spPr/>
      <dgm:t>
        <a:bodyPr/>
        <a:lstStyle/>
        <a:p>
          <a:endParaRPr lang="fr-FR"/>
        </a:p>
      </dgm:t>
    </dgm:pt>
    <dgm:pt modelId="{C2C73B8C-C14A-4EC6-98BD-771A111D3C61}" type="sibTrans" cxnId="{EC6890A4-7F6B-4EF6-9A2A-FB020E74889F}">
      <dgm:prSet/>
      <dgm:spPr/>
      <dgm:t>
        <a:bodyPr/>
        <a:lstStyle/>
        <a:p>
          <a:endParaRPr lang="fr-FR"/>
        </a:p>
      </dgm:t>
    </dgm:pt>
    <dgm:pt modelId="{B4A3A077-E641-4706-9AFC-B96BF863A27E}">
      <dgm:prSet phldrT="[Texte]" custT="1"/>
      <dgm:spPr/>
      <dgm:t>
        <a:bodyPr/>
        <a:lstStyle/>
        <a:p>
          <a:endParaRPr lang="fr-FR" sz="1800" dirty="0"/>
        </a:p>
      </dgm:t>
    </dgm:pt>
    <dgm:pt modelId="{07711D5E-8B24-4EDA-AA86-266D04902B66}" type="sibTrans" cxnId="{E0247C09-A0C1-4412-92C0-2B2B04B25641}">
      <dgm:prSet/>
      <dgm:spPr/>
      <dgm:t>
        <a:bodyPr/>
        <a:lstStyle/>
        <a:p>
          <a:endParaRPr lang="fr-FR"/>
        </a:p>
      </dgm:t>
    </dgm:pt>
    <dgm:pt modelId="{F3471A7E-C1DE-4347-B40F-0FB6D2B19DF1}" type="parTrans" cxnId="{E0247C09-A0C1-4412-92C0-2B2B04B25641}">
      <dgm:prSet/>
      <dgm:spPr/>
      <dgm:t>
        <a:bodyPr/>
        <a:lstStyle/>
        <a:p>
          <a:endParaRPr lang="fr-FR"/>
        </a:p>
      </dgm:t>
    </dgm:pt>
    <dgm:pt modelId="{F603C135-0E61-4959-9743-B61184B4C3D9}" type="pres">
      <dgm:prSet presAssocID="{40C24801-94B7-4A57-9B7D-5F71444535AD}" presName="Name0" presStyleCnt="0">
        <dgm:presLayoutVars>
          <dgm:dir/>
          <dgm:resizeHandles val="exact"/>
        </dgm:presLayoutVars>
      </dgm:prSet>
      <dgm:spPr/>
    </dgm:pt>
    <dgm:pt modelId="{CA8811B5-C915-4BB4-BC86-5AB937354FE8}" type="pres">
      <dgm:prSet presAssocID="{40C24801-94B7-4A57-9B7D-5F71444535AD}" presName="arrow" presStyleLbl="bgShp" presStyleIdx="0" presStyleCnt="1" custLinFactNeighborY="544"/>
      <dgm:spPr/>
    </dgm:pt>
    <dgm:pt modelId="{2B8CF933-C79F-4F90-99DF-AC4FB688D900}" type="pres">
      <dgm:prSet presAssocID="{40C24801-94B7-4A57-9B7D-5F71444535AD}" presName="points" presStyleCnt="0"/>
      <dgm:spPr/>
    </dgm:pt>
    <dgm:pt modelId="{9334E698-14FE-44F2-A916-4212307E781F}" type="pres">
      <dgm:prSet presAssocID="{B4A3A077-E641-4706-9AFC-B96BF863A27E}" presName="compositeA" presStyleCnt="0"/>
      <dgm:spPr/>
    </dgm:pt>
    <dgm:pt modelId="{9335B000-F84D-4256-BB4D-801D58C690CC}" type="pres">
      <dgm:prSet presAssocID="{B4A3A077-E641-4706-9AFC-B96BF863A27E}" presName="textA" presStyleLbl="revTx" presStyleIdx="0" presStyleCnt="5" custScaleX="127731" custLinFactNeighborY="544">
        <dgm:presLayoutVars>
          <dgm:bulletEnabled val="1"/>
        </dgm:presLayoutVars>
      </dgm:prSet>
      <dgm:spPr/>
    </dgm:pt>
    <dgm:pt modelId="{C27A0645-1A3D-4099-9A49-8AD8854865AF}" type="pres">
      <dgm:prSet presAssocID="{B4A3A077-E641-4706-9AFC-B96BF863A27E}" presName="circleA" presStyleLbl="node1" presStyleIdx="0" presStyleCnt="5" custLinFactNeighborX="-89575" custLinFactNeighborY="7631"/>
      <dgm:spPr/>
    </dgm:pt>
    <dgm:pt modelId="{B032F475-A99C-4A30-92C9-036D4F77BBD1}" type="pres">
      <dgm:prSet presAssocID="{B4A3A077-E641-4706-9AFC-B96BF863A27E}" presName="spaceA" presStyleCnt="0"/>
      <dgm:spPr/>
    </dgm:pt>
    <dgm:pt modelId="{68CBEB1D-484D-4EB3-98F2-19AF62EE8870}" type="pres">
      <dgm:prSet presAssocID="{07711D5E-8B24-4EDA-AA86-266D04902B66}" presName="space" presStyleCnt="0"/>
      <dgm:spPr/>
    </dgm:pt>
    <dgm:pt modelId="{8D6D9CDE-F48B-40C1-A29A-85EB3C5E81F5}" type="pres">
      <dgm:prSet presAssocID="{31B0F5EA-3831-4E72-B3CB-13F87BFBDE78}" presName="compositeB" presStyleCnt="0"/>
      <dgm:spPr/>
    </dgm:pt>
    <dgm:pt modelId="{A1F25A0E-8308-4D5E-8D52-54529F561428}" type="pres">
      <dgm:prSet presAssocID="{31B0F5EA-3831-4E72-B3CB-13F87BFBDE78}" presName="textB" presStyleLbl="revTx" presStyleIdx="1" presStyleCnt="5" custLinFactNeighborY="544">
        <dgm:presLayoutVars>
          <dgm:bulletEnabled val="1"/>
        </dgm:presLayoutVars>
      </dgm:prSet>
      <dgm:spPr/>
    </dgm:pt>
    <dgm:pt modelId="{48C59195-9FF7-41EB-86B1-B6189CFDB51E}" type="pres">
      <dgm:prSet presAssocID="{31B0F5EA-3831-4E72-B3CB-13F87BFBDE78}" presName="circleB" presStyleLbl="node1" presStyleIdx="1" presStyleCnt="5" custLinFactX="-122855" custLinFactNeighborX="-200000" custLinFactNeighborY="7631"/>
      <dgm:spPr/>
    </dgm:pt>
    <dgm:pt modelId="{78914D31-4BD6-43B9-A2DF-5A902649C5A6}" type="pres">
      <dgm:prSet presAssocID="{31B0F5EA-3831-4E72-B3CB-13F87BFBDE78}" presName="spaceB" presStyleCnt="0"/>
      <dgm:spPr/>
    </dgm:pt>
    <dgm:pt modelId="{D22B5EE2-058C-4792-9A00-D61C1494C68C}" type="pres">
      <dgm:prSet presAssocID="{488D3F11-A555-4833-8A7C-61FFBA1C3D34}" presName="space" presStyleCnt="0"/>
      <dgm:spPr/>
    </dgm:pt>
    <dgm:pt modelId="{120234BF-F4D9-4C25-84B0-C9FF057C1B97}" type="pres">
      <dgm:prSet presAssocID="{02D4E1F2-26B3-43B5-8EEB-75F6E9CC5DA1}" presName="compositeA" presStyleCnt="0"/>
      <dgm:spPr/>
    </dgm:pt>
    <dgm:pt modelId="{5CFD6FD1-2938-4BD5-8927-0F03D41C7074}" type="pres">
      <dgm:prSet presAssocID="{02D4E1F2-26B3-43B5-8EEB-75F6E9CC5DA1}" presName="textA" presStyleLbl="revTx" presStyleIdx="2" presStyleCnt="5" custLinFactNeighborY="544">
        <dgm:presLayoutVars>
          <dgm:bulletEnabled val="1"/>
        </dgm:presLayoutVars>
      </dgm:prSet>
      <dgm:spPr/>
    </dgm:pt>
    <dgm:pt modelId="{57767190-BA4E-437C-96F3-DAE6B8A03BB4}" type="pres">
      <dgm:prSet presAssocID="{02D4E1F2-26B3-43B5-8EEB-75F6E9CC5DA1}" presName="circleA" presStyleLbl="node1" presStyleIdx="2" presStyleCnt="5" custLinFactX="66366" custLinFactNeighborX="100000" custLinFactNeighborY="3312"/>
      <dgm:spPr/>
    </dgm:pt>
    <dgm:pt modelId="{B4815B91-53FA-47A5-9CC8-B83E603BAEB3}" type="pres">
      <dgm:prSet presAssocID="{02D4E1F2-26B3-43B5-8EEB-75F6E9CC5DA1}" presName="spaceA" presStyleCnt="0"/>
      <dgm:spPr/>
    </dgm:pt>
    <dgm:pt modelId="{CE7E67E1-D832-4DBB-9645-1CB9B4BD89FC}" type="pres">
      <dgm:prSet presAssocID="{A28046F4-27BB-4AC0-A22A-F733C8948880}" presName="space" presStyleCnt="0"/>
      <dgm:spPr/>
    </dgm:pt>
    <dgm:pt modelId="{4EB4FD42-3ABD-4995-BE39-E48DA585AA73}" type="pres">
      <dgm:prSet presAssocID="{E496F8C2-5C83-4F50-BD69-78D3B2CD67D0}" presName="compositeB" presStyleCnt="0"/>
      <dgm:spPr/>
    </dgm:pt>
    <dgm:pt modelId="{097BF319-691E-49CB-9E33-C3E789B89854}" type="pres">
      <dgm:prSet presAssocID="{E496F8C2-5C83-4F50-BD69-78D3B2CD67D0}" presName="textB" presStyleLbl="revTx" presStyleIdx="3" presStyleCnt="5" custLinFactNeighborY="544">
        <dgm:presLayoutVars>
          <dgm:bulletEnabled val="1"/>
        </dgm:presLayoutVars>
      </dgm:prSet>
      <dgm:spPr/>
    </dgm:pt>
    <dgm:pt modelId="{3A9B5B17-C135-40F4-96C8-D5590D7564B4}" type="pres">
      <dgm:prSet presAssocID="{E496F8C2-5C83-4F50-BD69-78D3B2CD67D0}" presName="circleB" presStyleLbl="node1" presStyleIdx="3" presStyleCnt="5" custLinFactNeighborX="-56146" custLinFactNeighborY="5490"/>
      <dgm:spPr/>
    </dgm:pt>
    <dgm:pt modelId="{BE04F061-12F0-42AD-AC9E-4117F6D8CB62}" type="pres">
      <dgm:prSet presAssocID="{E496F8C2-5C83-4F50-BD69-78D3B2CD67D0}" presName="spaceB" presStyleCnt="0"/>
      <dgm:spPr/>
    </dgm:pt>
    <dgm:pt modelId="{E5C99B16-586A-4ACA-8A94-22F0335BB11E}" type="pres">
      <dgm:prSet presAssocID="{B9F55BBD-DA01-4B5C-9A32-2DC2FDE1EF01}" presName="space" presStyleCnt="0"/>
      <dgm:spPr/>
    </dgm:pt>
    <dgm:pt modelId="{E2E5DCD3-0D90-47A9-BC50-F80A6B9BD230}" type="pres">
      <dgm:prSet presAssocID="{99D4859D-C334-43D5-8A83-F8CCCDE10804}" presName="compositeA" presStyleCnt="0"/>
      <dgm:spPr/>
    </dgm:pt>
    <dgm:pt modelId="{0D1FD0EC-9273-4A6F-823A-A4C2530E0657}" type="pres">
      <dgm:prSet presAssocID="{99D4859D-C334-43D5-8A83-F8CCCDE10804}" presName="textA" presStyleLbl="revTx" presStyleIdx="4" presStyleCnt="5" custLinFactNeighborY="544">
        <dgm:presLayoutVars>
          <dgm:bulletEnabled val="1"/>
        </dgm:presLayoutVars>
      </dgm:prSet>
      <dgm:spPr/>
    </dgm:pt>
    <dgm:pt modelId="{EDBD923D-D1E0-4B99-BA02-AC977B6ED557}" type="pres">
      <dgm:prSet presAssocID="{99D4859D-C334-43D5-8A83-F8CCCDE10804}" presName="circleA" presStyleLbl="node1" presStyleIdx="4" presStyleCnt="5" custLinFactNeighborX="79947" custLinFactNeighborY="7904"/>
      <dgm:spPr/>
    </dgm:pt>
    <dgm:pt modelId="{2E7C4A28-CC0E-4FFD-BE98-55D2A0DC0133}" type="pres">
      <dgm:prSet presAssocID="{99D4859D-C334-43D5-8A83-F8CCCDE10804}" presName="spaceA" presStyleCnt="0"/>
      <dgm:spPr/>
    </dgm:pt>
  </dgm:ptLst>
  <dgm:cxnLst>
    <dgm:cxn modelId="{E0247C09-A0C1-4412-92C0-2B2B04B25641}" srcId="{40C24801-94B7-4A57-9B7D-5F71444535AD}" destId="{B4A3A077-E641-4706-9AFC-B96BF863A27E}" srcOrd="0" destOrd="0" parTransId="{F3471A7E-C1DE-4347-B40F-0FB6D2B19DF1}" sibTransId="{07711D5E-8B24-4EDA-AA86-266D04902B66}"/>
    <dgm:cxn modelId="{6731801A-BCA2-42C9-A17A-DACA2293F2C5}" srcId="{40C24801-94B7-4A57-9B7D-5F71444535AD}" destId="{02D4E1F2-26B3-43B5-8EEB-75F6E9CC5DA1}" srcOrd="2" destOrd="0" parTransId="{1DF2D02F-44F0-4B9C-8003-268D122069CE}" sibTransId="{A28046F4-27BB-4AC0-A22A-F733C8948880}"/>
    <dgm:cxn modelId="{9E90AC1C-46D0-4614-A190-99A174FABAF8}" srcId="{40C24801-94B7-4A57-9B7D-5F71444535AD}" destId="{E496F8C2-5C83-4F50-BD69-78D3B2CD67D0}" srcOrd="3" destOrd="0" parTransId="{AA339A52-B54C-442B-9C71-21EB107BA0E3}" sibTransId="{B9F55BBD-DA01-4B5C-9A32-2DC2FDE1EF01}"/>
    <dgm:cxn modelId="{ABBE5071-64A5-4644-A639-7EEF3291E5B0}" type="presOf" srcId="{B4A3A077-E641-4706-9AFC-B96BF863A27E}" destId="{9335B000-F84D-4256-BB4D-801D58C690CC}" srcOrd="0" destOrd="0" presId="urn:microsoft.com/office/officeart/2005/8/layout/hProcess11"/>
    <dgm:cxn modelId="{DDA59073-E14B-439D-B989-768F455FD98D}" srcId="{40C24801-94B7-4A57-9B7D-5F71444535AD}" destId="{31B0F5EA-3831-4E72-B3CB-13F87BFBDE78}" srcOrd="1" destOrd="0" parTransId="{09F38C1F-E9E0-4D71-BEAC-C8CF95DFC2FA}" sibTransId="{488D3F11-A555-4833-8A7C-61FFBA1C3D34}"/>
    <dgm:cxn modelId="{B8423A88-5ABE-43B4-94B8-5DF84CCF2A48}" type="presOf" srcId="{99D4859D-C334-43D5-8A83-F8CCCDE10804}" destId="{0D1FD0EC-9273-4A6F-823A-A4C2530E0657}" srcOrd="0" destOrd="0" presId="urn:microsoft.com/office/officeart/2005/8/layout/hProcess11"/>
    <dgm:cxn modelId="{C61D7888-3378-4682-B502-93882DF9C5AA}" type="presOf" srcId="{31B0F5EA-3831-4E72-B3CB-13F87BFBDE78}" destId="{A1F25A0E-8308-4D5E-8D52-54529F561428}" srcOrd="0" destOrd="0" presId="urn:microsoft.com/office/officeart/2005/8/layout/hProcess11"/>
    <dgm:cxn modelId="{8559819A-9613-4846-854E-5AD5A5C665B8}" type="presOf" srcId="{40C24801-94B7-4A57-9B7D-5F71444535AD}" destId="{F603C135-0E61-4959-9743-B61184B4C3D9}" srcOrd="0" destOrd="0" presId="urn:microsoft.com/office/officeart/2005/8/layout/hProcess11"/>
    <dgm:cxn modelId="{EC6890A4-7F6B-4EF6-9A2A-FB020E74889F}" srcId="{40C24801-94B7-4A57-9B7D-5F71444535AD}" destId="{99D4859D-C334-43D5-8A83-F8CCCDE10804}" srcOrd="4" destOrd="0" parTransId="{F64ADC85-C6E1-47FE-9B41-8F3922B888FA}" sibTransId="{C2C73B8C-C14A-4EC6-98BD-771A111D3C61}"/>
    <dgm:cxn modelId="{AD0D75EC-2583-4484-A497-176E2FA002E4}" type="presOf" srcId="{02D4E1F2-26B3-43B5-8EEB-75F6E9CC5DA1}" destId="{5CFD6FD1-2938-4BD5-8927-0F03D41C7074}" srcOrd="0" destOrd="0" presId="urn:microsoft.com/office/officeart/2005/8/layout/hProcess11"/>
    <dgm:cxn modelId="{9841C5ED-1C58-4D35-B430-74126B5A90DC}" type="presOf" srcId="{E496F8C2-5C83-4F50-BD69-78D3B2CD67D0}" destId="{097BF319-691E-49CB-9E33-C3E789B89854}" srcOrd="0" destOrd="0" presId="urn:microsoft.com/office/officeart/2005/8/layout/hProcess11"/>
    <dgm:cxn modelId="{B65FEB8E-B534-4D8F-A1F1-E03B9BCC169E}" type="presParOf" srcId="{F603C135-0E61-4959-9743-B61184B4C3D9}" destId="{CA8811B5-C915-4BB4-BC86-5AB937354FE8}" srcOrd="0" destOrd="0" presId="urn:microsoft.com/office/officeart/2005/8/layout/hProcess11"/>
    <dgm:cxn modelId="{2C30BCFD-272B-4B52-8293-CF8CA531063A}" type="presParOf" srcId="{F603C135-0E61-4959-9743-B61184B4C3D9}" destId="{2B8CF933-C79F-4F90-99DF-AC4FB688D900}" srcOrd="1" destOrd="0" presId="urn:microsoft.com/office/officeart/2005/8/layout/hProcess11"/>
    <dgm:cxn modelId="{5C265C28-5E46-4DAE-9859-E7122FF4A616}" type="presParOf" srcId="{2B8CF933-C79F-4F90-99DF-AC4FB688D900}" destId="{9334E698-14FE-44F2-A916-4212307E781F}" srcOrd="0" destOrd="0" presId="urn:microsoft.com/office/officeart/2005/8/layout/hProcess11"/>
    <dgm:cxn modelId="{C386C283-0353-4C3F-BD42-864F5B243A84}" type="presParOf" srcId="{9334E698-14FE-44F2-A916-4212307E781F}" destId="{9335B000-F84D-4256-BB4D-801D58C690CC}" srcOrd="0" destOrd="0" presId="urn:microsoft.com/office/officeart/2005/8/layout/hProcess11"/>
    <dgm:cxn modelId="{DB5265C2-748C-4038-9CC6-9E88EA4583E5}" type="presParOf" srcId="{9334E698-14FE-44F2-A916-4212307E781F}" destId="{C27A0645-1A3D-4099-9A49-8AD8854865AF}" srcOrd="1" destOrd="0" presId="urn:microsoft.com/office/officeart/2005/8/layout/hProcess11"/>
    <dgm:cxn modelId="{F43EE9CC-AAFC-48D3-9D59-9F7211133E05}" type="presParOf" srcId="{9334E698-14FE-44F2-A916-4212307E781F}" destId="{B032F475-A99C-4A30-92C9-036D4F77BBD1}" srcOrd="2" destOrd="0" presId="urn:microsoft.com/office/officeart/2005/8/layout/hProcess11"/>
    <dgm:cxn modelId="{157D79D5-7149-4C82-A31C-19D14632FFA6}" type="presParOf" srcId="{2B8CF933-C79F-4F90-99DF-AC4FB688D900}" destId="{68CBEB1D-484D-4EB3-98F2-19AF62EE8870}" srcOrd="1" destOrd="0" presId="urn:microsoft.com/office/officeart/2005/8/layout/hProcess11"/>
    <dgm:cxn modelId="{8A458E97-5DB3-4DC7-8C42-299B3B4615E7}" type="presParOf" srcId="{2B8CF933-C79F-4F90-99DF-AC4FB688D900}" destId="{8D6D9CDE-F48B-40C1-A29A-85EB3C5E81F5}" srcOrd="2" destOrd="0" presId="urn:microsoft.com/office/officeart/2005/8/layout/hProcess11"/>
    <dgm:cxn modelId="{E7460953-1631-48FF-B3C5-304B23D0DDA5}" type="presParOf" srcId="{8D6D9CDE-F48B-40C1-A29A-85EB3C5E81F5}" destId="{A1F25A0E-8308-4D5E-8D52-54529F561428}" srcOrd="0" destOrd="0" presId="urn:microsoft.com/office/officeart/2005/8/layout/hProcess11"/>
    <dgm:cxn modelId="{8664BE92-5949-4E06-81B9-7BD6B983E968}" type="presParOf" srcId="{8D6D9CDE-F48B-40C1-A29A-85EB3C5E81F5}" destId="{48C59195-9FF7-41EB-86B1-B6189CFDB51E}" srcOrd="1" destOrd="0" presId="urn:microsoft.com/office/officeart/2005/8/layout/hProcess11"/>
    <dgm:cxn modelId="{77227D8E-1296-44E4-B03B-E304F40B2E41}" type="presParOf" srcId="{8D6D9CDE-F48B-40C1-A29A-85EB3C5E81F5}" destId="{78914D31-4BD6-43B9-A2DF-5A902649C5A6}" srcOrd="2" destOrd="0" presId="urn:microsoft.com/office/officeart/2005/8/layout/hProcess11"/>
    <dgm:cxn modelId="{D1B685BC-42D1-4EC8-84E4-45D5F4732550}" type="presParOf" srcId="{2B8CF933-C79F-4F90-99DF-AC4FB688D900}" destId="{D22B5EE2-058C-4792-9A00-D61C1494C68C}" srcOrd="3" destOrd="0" presId="urn:microsoft.com/office/officeart/2005/8/layout/hProcess11"/>
    <dgm:cxn modelId="{F76FF44B-6951-4AED-A011-2EB7F6513114}" type="presParOf" srcId="{2B8CF933-C79F-4F90-99DF-AC4FB688D900}" destId="{120234BF-F4D9-4C25-84B0-C9FF057C1B97}" srcOrd="4" destOrd="0" presId="urn:microsoft.com/office/officeart/2005/8/layout/hProcess11"/>
    <dgm:cxn modelId="{89392A74-216A-40EE-82BE-074C802BD14D}" type="presParOf" srcId="{120234BF-F4D9-4C25-84B0-C9FF057C1B97}" destId="{5CFD6FD1-2938-4BD5-8927-0F03D41C7074}" srcOrd="0" destOrd="0" presId="urn:microsoft.com/office/officeart/2005/8/layout/hProcess11"/>
    <dgm:cxn modelId="{5FB1057B-2D7D-4CCB-B11D-82544806E0FE}" type="presParOf" srcId="{120234BF-F4D9-4C25-84B0-C9FF057C1B97}" destId="{57767190-BA4E-437C-96F3-DAE6B8A03BB4}" srcOrd="1" destOrd="0" presId="urn:microsoft.com/office/officeart/2005/8/layout/hProcess11"/>
    <dgm:cxn modelId="{F3ECF457-2CD3-4AF0-9FB7-C1DFB3F3F5AE}" type="presParOf" srcId="{120234BF-F4D9-4C25-84B0-C9FF057C1B97}" destId="{B4815B91-53FA-47A5-9CC8-B83E603BAEB3}" srcOrd="2" destOrd="0" presId="urn:microsoft.com/office/officeart/2005/8/layout/hProcess11"/>
    <dgm:cxn modelId="{371AEC0C-3E0D-4D9B-B1D5-9360E0875687}" type="presParOf" srcId="{2B8CF933-C79F-4F90-99DF-AC4FB688D900}" destId="{CE7E67E1-D832-4DBB-9645-1CB9B4BD89FC}" srcOrd="5" destOrd="0" presId="urn:microsoft.com/office/officeart/2005/8/layout/hProcess11"/>
    <dgm:cxn modelId="{C27AD7F3-4867-41D2-80C9-1AEC41C33B3A}" type="presParOf" srcId="{2B8CF933-C79F-4F90-99DF-AC4FB688D900}" destId="{4EB4FD42-3ABD-4995-BE39-E48DA585AA73}" srcOrd="6" destOrd="0" presId="urn:microsoft.com/office/officeart/2005/8/layout/hProcess11"/>
    <dgm:cxn modelId="{5E87D8F7-1590-498C-97C3-8D1D9DB4A290}" type="presParOf" srcId="{4EB4FD42-3ABD-4995-BE39-E48DA585AA73}" destId="{097BF319-691E-49CB-9E33-C3E789B89854}" srcOrd="0" destOrd="0" presId="urn:microsoft.com/office/officeart/2005/8/layout/hProcess11"/>
    <dgm:cxn modelId="{221724D6-36EC-41F6-84EB-46ACCBD4E058}" type="presParOf" srcId="{4EB4FD42-3ABD-4995-BE39-E48DA585AA73}" destId="{3A9B5B17-C135-40F4-96C8-D5590D7564B4}" srcOrd="1" destOrd="0" presId="urn:microsoft.com/office/officeart/2005/8/layout/hProcess11"/>
    <dgm:cxn modelId="{60EE59ED-68D9-4A25-B0D2-B428103C019E}" type="presParOf" srcId="{4EB4FD42-3ABD-4995-BE39-E48DA585AA73}" destId="{BE04F061-12F0-42AD-AC9E-4117F6D8CB62}" srcOrd="2" destOrd="0" presId="urn:microsoft.com/office/officeart/2005/8/layout/hProcess11"/>
    <dgm:cxn modelId="{E70F04E9-CC88-4072-A397-0854033634F3}" type="presParOf" srcId="{2B8CF933-C79F-4F90-99DF-AC4FB688D900}" destId="{E5C99B16-586A-4ACA-8A94-22F0335BB11E}" srcOrd="7" destOrd="0" presId="urn:microsoft.com/office/officeart/2005/8/layout/hProcess11"/>
    <dgm:cxn modelId="{99353879-A0FE-4AC7-902B-FA47B293B03B}" type="presParOf" srcId="{2B8CF933-C79F-4F90-99DF-AC4FB688D900}" destId="{E2E5DCD3-0D90-47A9-BC50-F80A6B9BD230}" srcOrd="8" destOrd="0" presId="urn:microsoft.com/office/officeart/2005/8/layout/hProcess11"/>
    <dgm:cxn modelId="{0B812807-7FA0-487A-9C34-62AE62C83C8F}" type="presParOf" srcId="{E2E5DCD3-0D90-47A9-BC50-F80A6B9BD230}" destId="{0D1FD0EC-9273-4A6F-823A-A4C2530E0657}" srcOrd="0" destOrd="0" presId="urn:microsoft.com/office/officeart/2005/8/layout/hProcess11"/>
    <dgm:cxn modelId="{B3D7318D-1934-4932-A182-F742BC52780A}" type="presParOf" srcId="{E2E5DCD3-0D90-47A9-BC50-F80A6B9BD230}" destId="{EDBD923D-D1E0-4B99-BA02-AC977B6ED557}" srcOrd="1" destOrd="0" presId="urn:microsoft.com/office/officeart/2005/8/layout/hProcess11"/>
    <dgm:cxn modelId="{20C73093-032F-4387-BCFA-3F7C165CDBD3}" type="presParOf" srcId="{E2E5DCD3-0D90-47A9-BC50-F80A6B9BD230}" destId="{2E7C4A28-CC0E-4FFD-BE98-55D2A0DC0133}" srcOrd="2" destOrd="0" presId="urn:microsoft.com/office/officeart/2005/8/layout/hProcess1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70B54B0-D309-4B20-BA51-3A8EAFFF8841}">
      <dsp:nvSpPr>
        <dsp:cNvPr id="0" name=""/>
        <dsp:cNvSpPr/>
      </dsp:nvSpPr>
      <dsp:spPr>
        <a:xfrm>
          <a:off x="4690835" y="1751726"/>
          <a:ext cx="2116687" cy="73471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67359"/>
              </a:lnTo>
              <a:lnTo>
                <a:pt x="2116687" y="367359"/>
              </a:lnTo>
              <a:lnTo>
                <a:pt x="2116687" y="734718"/>
              </a:lnTo>
            </a:path>
          </a:pathLst>
        </a:custGeom>
        <a:noFill/>
        <a:ln w="19050" cap="rnd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8EF2953-B376-44D7-ACA5-E51EFAF99DEF}">
      <dsp:nvSpPr>
        <dsp:cNvPr id="0" name=""/>
        <dsp:cNvSpPr/>
      </dsp:nvSpPr>
      <dsp:spPr>
        <a:xfrm>
          <a:off x="2574147" y="1751726"/>
          <a:ext cx="2116687" cy="734718"/>
        </a:xfrm>
        <a:custGeom>
          <a:avLst/>
          <a:gdLst/>
          <a:ahLst/>
          <a:cxnLst/>
          <a:rect l="0" t="0" r="0" b="0"/>
          <a:pathLst>
            <a:path>
              <a:moveTo>
                <a:pt x="2116687" y="0"/>
              </a:moveTo>
              <a:lnTo>
                <a:pt x="2116687" y="367359"/>
              </a:lnTo>
              <a:lnTo>
                <a:pt x="0" y="367359"/>
              </a:lnTo>
              <a:lnTo>
                <a:pt x="0" y="734718"/>
              </a:lnTo>
            </a:path>
          </a:pathLst>
        </a:custGeom>
        <a:noFill/>
        <a:ln w="19050" cap="rnd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39725C4-E9F5-41EE-8380-ADEF207E1E7D}">
      <dsp:nvSpPr>
        <dsp:cNvPr id="0" name=""/>
        <dsp:cNvSpPr/>
      </dsp:nvSpPr>
      <dsp:spPr>
        <a:xfrm>
          <a:off x="2941506" y="2397"/>
          <a:ext cx="3498657" cy="1749328"/>
        </a:xfrm>
        <a:prstGeom prst="rect">
          <a:avLst/>
        </a:prstGeom>
        <a:solidFill>
          <a:srgbClr val="FF9900"/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marL="0" lvl="0" indent="0" algn="ctr" defTabSz="2578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5800" kern="1200" dirty="0" err="1"/>
            <a:t>Recovery</a:t>
          </a:r>
          <a:endParaRPr lang="fr-FR" sz="5800" kern="1200" dirty="0"/>
        </a:p>
      </dsp:txBody>
      <dsp:txXfrm>
        <a:off x="2941506" y="2397"/>
        <a:ext cx="3498657" cy="1749328"/>
      </dsp:txXfrm>
    </dsp:sp>
    <dsp:sp modelId="{A441B396-EA70-4381-9AA6-6C936547D053}">
      <dsp:nvSpPr>
        <dsp:cNvPr id="0" name=""/>
        <dsp:cNvSpPr/>
      </dsp:nvSpPr>
      <dsp:spPr>
        <a:xfrm>
          <a:off x="824818" y="2486444"/>
          <a:ext cx="3498657" cy="1749328"/>
        </a:xfrm>
        <a:prstGeom prst="rect">
          <a:avLst/>
        </a:prstGeom>
        <a:solidFill>
          <a:srgbClr val="FF0000"/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marL="0" lvl="0" indent="0" algn="ctr" defTabSz="2578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5800" kern="1200" dirty="0"/>
            <a:t>Transfer</a:t>
          </a:r>
        </a:p>
      </dsp:txBody>
      <dsp:txXfrm>
        <a:off x="824818" y="2486444"/>
        <a:ext cx="3498657" cy="1749328"/>
      </dsp:txXfrm>
    </dsp:sp>
    <dsp:sp modelId="{93051E59-9173-4954-82C7-83087060739B}">
      <dsp:nvSpPr>
        <dsp:cNvPr id="0" name=""/>
        <dsp:cNvSpPr/>
      </dsp:nvSpPr>
      <dsp:spPr>
        <a:xfrm>
          <a:off x="5058194" y="2486444"/>
          <a:ext cx="3498657" cy="1749328"/>
        </a:xfrm>
        <a:prstGeom prst="rect">
          <a:avLst/>
        </a:prstGeom>
        <a:solidFill>
          <a:srgbClr val="92D050"/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marL="0" lvl="0" indent="0" algn="ctr" defTabSz="2578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5800" kern="1200" dirty="0" err="1"/>
            <a:t>Recovery</a:t>
          </a:r>
          <a:r>
            <a:rPr lang="fr-FR" sz="5800" kern="1200" dirty="0"/>
            <a:t> box</a:t>
          </a:r>
        </a:p>
      </dsp:txBody>
      <dsp:txXfrm>
        <a:off x="5058194" y="2486444"/>
        <a:ext cx="3498657" cy="1749328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A8811B5-C915-4BB4-BC86-5AB937354FE8}">
      <dsp:nvSpPr>
        <dsp:cNvPr id="0" name=""/>
        <dsp:cNvSpPr/>
      </dsp:nvSpPr>
      <dsp:spPr>
        <a:xfrm>
          <a:off x="0" y="1349666"/>
          <a:ext cx="12093526" cy="1786596"/>
        </a:xfrm>
        <a:prstGeom prst="notchedRightArrow">
          <a:avLst/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335B000-F84D-4256-BB4D-801D58C690CC}">
      <dsp:nvSpPr>
        <dsp:cNvPr id="0" name=""/>
        <dsp:cNvSpPr/>
      </dsp:nvSpPr>
      <dsp:spPr>
        <a:xfrm>
          <a:off x="5911" y="9719"/>
          <a:ext cx="2535434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800" kern="1200" dirty="0"/>
        </a:p>
      </dsp:txBody>
      <dsp:txXfrm>
        <a:off x="5911" y="9719"/>
        <a:ext cx="2535434" cy="1786596"/>
      </dsp:txXfrm>
    </dsp:sp>
    <dsp:sp modelId="{C27A0645-1A3D-4099-9A49-8AD8854865AF}">
      <dsp:nvSpPr>
        <dsp:cNvPr id="0" name=""/>
        <dsp:cNvSpPr/>
      </dsp:nvSpPr>
      <dsp:spPr>
        <a:xfrm>
          <a:off x="650218" y="2044004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1F25A0E-8308-4D5E-8D52-54529F561428}">
      <dsp:nvSpPr>
        <dsp:cNvPr id="0" name=""/>
        <dsp:cNvSpPr/>
      </dsp:nvSpPr>
      <dsp:spPr>
        <a:xfrm>
          <a:off x="2640595" y="2679894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13792" tIns="113792" rIns="113792" bIns="113792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600" b="1" kern="1200" dirty="0"/>
        </a:p>
      </dsp:txBody>
      <dsp:txXfrm>
        <a:off x="2640595" y="2679894"/>
        <a:ext cx="1984979" cy="1786596"/>
      </dsp:txXfrm>
    </dsp:sp>
    <dsp:sp modelId="{48C59195-9FF7-41EB-86B1-B6189CFDB51E}">
      <dsp:nvSpPr>
        <dsp:cNvPr id="0" name=""/>
        <dsp:cNvSpPr/>
      </dsp:nvSpPr>
      <dsp:spPr>
        <a:xfrm>
          <a:off x="1967731" y="2044004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CFD6FD1-2938-4BD5-8927-0F03D41C7074}">
      <dsp:nvSpPr>
        <dsp:cNvPr id="0" name=""/>
        <dsp:cNvSpPr/>
      </dsp:nvSpPr>
      <dsp:spPr>
        <a:xfrm>
          <a:off x="4724824" y="9719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800" kern="1200" dirty="0"/>
        </a:p>
      </dsp:txBody>
      <dsp:txXfrm>
        <a:off x="4724824" y="9719"/>
        <a:ext cx="1984979" cy="1786596"/>
      </dsp:txXfrm>
    </dsp:sp>
    <dsp:sp modelId="{57767190-BA4E-437C-96F3-DAE6B8A03BB4}">
      <dsp:nvSpPr>
        <dsp:cNvPr id="0" name=""/>
        <dsp:cNvSpPr/>
      </dsp:nvSpPr>
      <dsp:spPr>
        <a:xfrm>
          <a:off x="6237061" y="2024713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97BF319-691E-49CB-9E33-C3E789B89854}">
      <dsp:nvSpPr>
        <dsp:cNvPr id="0" name=""/>
        <dsp:cNvSpPr/>
      </dsp:nvSpPr>
      <dsp:spPr>
        <a:xfrm>
          <a:off x="6809053" y="2679894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48056" tIns="448056" rIns="448056" bIns="448056" numCol="1" spcCol="1270" anchor="t" anchorCtr="0">
          <a:noAutofit/>
        </a:bodyPr>
        <a:lstStyle/>
        <a:p>
          <a:pPr marL="0" lvl="0" indent="0" algn="ctr" defTabSz="2800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6300" b="1" kern="1200" dirty="0"/>
        </a:p>
      </dsp:txBody>
      <dsp:txXfrm>
        <a:off x="6809053" y="2679894"/>
        <a:ext cx="1984979" cy="1786596"/>
      </dsp:txXfrm>
    </dsp:sp>
    <dsp:sp modelId="{3A9B5B17-C135-40F4-96C8-D5590D7564B4}">
      <dsp:nvSpPr>
        <dsp:cNvPr id="0" name=""/>
        <dsp:cNvSpPr/>
      </dsp:nvSpPr>
      <dsp:spPr>
        <a:xfrm>
          <a:off x="7327442" y="2034441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D1FD0EC-9273-4A6F-823A-A4C2530E0657}">
      <dsp:nvSpPr>
        <dsp:cNvPr id="0" name=""/>
        <dsp:cNvSpPr/>
      </dsp:nvSpPr>
      <dsp:spPr>
        <a:xfrm>
          <a:off x="8893281" y="9719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800" kern="1200" dirty="0"/>
        </a:p>
      </dsp:txBody>
      <dsp:txXfrm>
        <a:off x="8893281" y="9719"/>
        <a:ext cx="1984979" cy="1786596"/>
      </dsp:txXfrm>
    </dsp:sp>
    <dsp:sp modelId="{EDBD923D-D1E0-4B99-BA02-AC977B6ED557}">
      <dsp:nvSpPr>
        <dsp:cNvPr id="0" name=""/>
        <dsp:cNvSpPr/>
      </dsp:nvSpPr>
      <dsp:spPr>
        <a:xfrm>
          <a:off x="10019529" y="2045224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Process11">
  <dgm:title val=""/>
  <dgm:desc val=""/>
  <dgm:catLst>
    <dgm:cat type="process" pri="8000"/>
    <dgm:cat type="convert" pri="14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alg type="composite"/>
    <dgm:shape xmlns:r="http://schemas.openxmlformats.org/officeDocument/2006/relationships" r:blip="">
      <dgm:adjLst/>
    </dgm:shape>
    <dgm:presOf/>
    <dgm:choose name="Name1">
      <dgm:if name="Name2" func="var" arg="dir" op="equ" val="norm">
        <dgm:constrLst>
          <dgm:constr type="w" for="ch" forName="arrow" refType="w"/>
          <dgm:constr type="h" for="ch" forName="arrow" refType="h" fact="0.4"/>
          <dgm:constr type="ctrY" for="ch" forName="arrow" refType="h" fact="0.5"/>
          <dgm:constr type="l" for="ch" forName="arrow"/>
          <dgm:constr type="w" for="ch" forName="points" refType="w" fact="0.9"/>
          <dgm:constr type="h" for="ch" forName="points" refType="h"/>
          <dgm:constr type="t" for="ch" forName="points"/>
          <dgm:constr type="l" for="ch" forName="points"/>
        </dgm:constrLst>
      </dgm:if>
      <dgm:else name="Name3">
        <dgm:constrLst>
          <dgm:constr type="w" for="ch" forName="arrow" refType="w"/>
          <dgm:constr type="h" for="ch" forName="arrow" refType="h" fact="0.4"/>
          <dgm:constr type="ctrY" for="ch" forName="arrow" refType="h" fact="0.5"/>
          <dgm:constr type="r" for="ch" forName="arrow" refType="w"/>
          <dgm:constr type="w" for="ch" forName="points" refType="w" fact="0.9"/>
          <dgm:constr type="h" for="ch" forName="points" refType="h"/>
          <dgm:constr type="t" for="ch" forName="points"/>
          <dgm:constr type="r" for="ch" forName="points" refType="w"/>
        </dgm:constrLst>
      </dgm:else>
    </dgm:choose>
    <dgm:ruleLst/>
    <dgm:layoutNode name="arrow" styleLbl="bgShp">
      <dgm:alg type="sp"/>
      <dgm:choose name="Name4">
        <dgm:if name="Name5" func="var" arg="dir" op="equ" val="norm">
          <dgm:shape xmlns:r="http://schemas.openxmlformats.org/officeDocument/2006/relationships" type="notchedRightArrow" r:blip="">
            <dgm:adjLst/>
          </dgm:shape>
        </dgm:if>
        <dgm:else name="Name6">
          <dgm:shape xmlns:r="http://schemas.openxmlformats.org/officeDocument/2006/relationships" rot="180" type="notchedRightArrow" r:blip="">
            <dgm:adjLst/>
          </dgm:shape>
        </dgm:else>
      </dgm:choose>
      <dgm:presOf/>
      <dgm:constrLst/>
      <dgm:ruleLst/>
    </dgm:layoutNode>
    <dgm:layoutNode name="points">
      <dgm:choose name="Name7">
        <dgm:if name="Name8" func="var" arg="dir" op="equ" val="norm">
          <dgm:alg type="lin">
            <dgm:param type="linDir" val="fromL"/>
          </dgm:alg>
        </dgm:if>
        <dgm:else name="Name9">
          <dgm:alg type="lin">
            <dgm:param type="linDir" val="fromR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ompositeA" refType="w"/>
        <dgm:constr type="h" for="ch" forName="compositeA" refType="h"/>
        <dgm:constr type="w" for="ch" forName="compositeB" refType="w" refFor="ch" refForName="compositeA" op="equ"/>
        <dgm:constr type="h" for="ch" forName="compositeB" refType="h" refFor="ch" refForName="compositeA" op="equ"/>
        <dgm:constr type="primFontSz" for="des" ptType="node" op="equ" val="65"/>
        <dgm:constr type="w" for="ch" forName="space" refType="w" refFor="ch" refForName="compositeA" op="equ" fact="0.05"/>
      </dgm:constrLst>
      <dgm:ruleLst/>
      <dgm:forEach name="Name10" axis="ch" ptType="node">
        <dgm:choose name="Name11">
          <dgm:if name="Name12" axis="self" ptType="node" func="posOdd" op="equ" val="1">
            <dgm:layoutNode name="compositeA">
              <dgm:alg type="composite"/>
              <dgm:shape xmlns:r="http://schemas.openxmlformats.org/officeDocument/2006/relationships" r:blip="">
                <dgm:adjLst/>
              </dgm:shape>
              <dgm:presOf/>
              <dgm:constrLst>
                <dgm:constr type="w" for="ch" forName="textA" refType="w"/>
                <dgm:constr type="h" for="ch" forName="textA" refType="h" fact="0.4"/>
                <dgm:constr type="t" for="ch" forName="textA"/>
                <dgm:constr type="l" for="ch" forName="textA"/>
                <dgm:constr type="h" for="ch" forName="circleA" refType="h" fact="0.1"/>
                <dgm:constr type="h" for="ch" forName="circleA" refType="w" op="lte"/>
                <dgm:constr type="w" for="ch" forName="circleA" refType="h" refFor="ch" refForName="circleA" op="equ"/>
                <dgm:constr type="ctrY" for="ch" forName="circleA" refType="h" fact="0.5"/>
                <dgm:constr type="ctrX" for="ch" forName="circleA" refType="w" refFor="ch" refForName="textA" fact="0.5"/>
                <dgm:constr type="w" for="ch" forName="spaceA" refType="w"/>
                <dgm:constr type="h" for="ch" forName="spaceA" refType="h" fact="0.4"/>
                <dgm:constr type="b" for="ch" forName="spaceA" refType="h"/>
                <dgm:constr type="l" for="ch" forName="spaceA"/>
              </dgm:constrLst>
              <dgm:ruleLst/>
              <dgm:layoutNode name="textA" styleLbl="revTx">
                <dgm:varLst>
                  <dgm:bulletEnabled val="1"/>
                </dgm:varLst>
                <dgm:alg type="tx">
                  <dgm:param type="txAnchorVert" val="b"/>
                  <dgm:param type="txAnchorVertCh" val="b"/>
                  <dgm:param type="txAnchorHorzCh" val="ctr"/>
                </dgm:alg>
                <dgm:shape xmlns:r="http://schemas.openxmlformats.org/officeDocument/2006/relationships" type="rect" r:blip="">
                  <dgm:adjLst/>
                </dgm:shape>
                <dgm:presOf axis="desOrSelf" ptType="node"/>
                <dgm:constrLst/>
                <dgm:ruleLst>
                  <dgm:rule type="primFontSz" val="5" fact="NaN" max="NaN"/>
                </dgm:ruleLst>
              </dgm:layoutNode>
              <dgm:layoutNode name="circleA">
                <dgm:alg type="sp"/>
                <dgm:shape xmlns:r="http://schemas.openxmlformats.org/officeDocument/2006/relationships" type="ellipse" r:blip="">
                  <dgm:adjLst/>
                </dgm:shape>
                <dgm:presOf/>
                <dgm:constrLst/>
                <dgm:ruleLst/>
              </dgm:layoutNode>
              <dgm:layoutNode name="spaceA">
                <dgm:alg type="sp"/>
                <dgm:shape xmlns:r="http://schemas.openxmlformats.org/officeDocument/2006/relationships" r:blip="">
                  <dgm:adjLst/>
                </dgm:shape>
                <dgm:presOf/>
                <dgm:constrLst/>
                <dgm:ruleLst/>
              </dgm:layoutNode>
            </dgm:layoutNode>
          </dgm:if>
          <dgm:else name="Name13">
            <dgm:layoutNode name="compositeB">
              <dgm:alg type="composite"/>
              <dgm:shape xmlns:r="http://schemas.openxmlformats.org/officeDocument/2006/relationships" r:blip="">
                <dgm:adjLst/>
              </dgm:shape>
              <dgm:presOf/>
              <dgm:constrLst>
                <dgm:constr type="w" for="ch" forName="textB" refType="w"/>
                <dgm:constr type="h" for="ch" forName="textB" refType="h" fact="0.4"/>
                <dgm:constr type="b" for="ch" forName="textB" refType="h"/>
                <dgm:constr type="l" for="ch" forName="textB"/>
                <dgm:constr type="h" for="ch" forName="circleB" refType="h" fact="0.1"/>
                <dgm:constr type="w" for="ch" forName="circleB" refType="h" refFor="ch" refForName="circleB" op="equ"/>
                <dgm:constr type="h" for="ch" forName="circleB" refType="w" op="lte"/>
                <dgm:constr type="ctrY" for="ch" forName="circleB" refType="h" fact="0.5"/>
                <dgm:constr type="ctrX" for="ch" forName="circleB" refType="w" refFor="ch" refForName="textB" fact="0.5"/>
                <dgm:constr type="w" for="ch" forName="spaceB" refType="w"/>
                <dgm:constr type="h" for="ch" forName="spaceB" refType="h" fact="0.4"/>
                <dgm:constr type="t" for="ch" forName="spaceB"/>
                <dgm:constr type="l" for="ch" forName="spaceB"/>
              </dgm:constrLst>
              <dgm:ruleLst/>
              <dgm:layoutNode name="textB" styleLbl="revTx">
                <dgm:varLst>
                  <dgm:bulletEnabled val="1"/>
                </dgm:varLst>
                <dgm:alg type="tx">
                  <dgm:param type="txAnchorVert" val="t"/>
                  <dgm:param type="txAnchorVertCh" val="t"/>
                  <dgm:param type="txAnchorHorzCh" val="ctr"/>
                </dgm:alg>
                <dgm:shape xmlns:r="http://schemas.openxmlformats.org/officeDocument/2006/relationships" type="rect" r:blip="">
                  <dgm:adjLst/>
                </dgm:shape>
                <dgm:presOf axis="desOrSelf" ptType="node"/>
                <dgm:constrLst/>
                <dgm:ruleLst>
                  <dgm:rule type="primFontSz" val="5" fact="NaN" max="NaN"/>
                </dgm:ruleLst>
              </dgm:layoutNode>
              <dgm:layoutNode name="circleB">
                <dgm:alg type="sp"/>
                <dgm:shape xmlns:r="http://schemas.openxmlformats.org/officeDocument/2006/relationships" type="ellipse" r:blip="">
                  <dgm:adjLst/>
                </dgm:shape>
                <dgm:presOf/>
                <dgm:constrLst/>
                <dgm:ruleLst/>
              </dgm:layoutNode>
              <dgm:layoutNode name="spaceB">
                <dgm:alg type="sp"/>
                <dgm:shape xmlns:r="http://schemas.openxmlformats.org/officeDocument/2006/relationships" r:blip="">
                  <dgm:adjLst/>
                </dgm:shape>
                <dgm:presOf/>
                <dgm:constrLst/>
                <dgm:ruleLst/>
              </dgm:layoutNode>
            </dgm:layoutNode>
          </dgm:else>
        </dgm:choose>
        <dgm:forEach name="Name14" axis="followSib" ptType="sibTrans" cnt="1">
          <dgm:layoutNode name="space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C20D6C-847A-4A53-942B-DE6FA4EE556D}" type="datetimeFigureOut">
              <a:rPr lang="fr-CA" smtClean="0"/>
              <a:t>2018-02-20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10A45-1FF2-4998-91A6-DCE3F76FCE6B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8424628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CA" dirty="0"/>
              <a:t>SALG: Qui fait partie du Royal </a:t>
            </a:r>
            <a:r>
              <a:rPr lang="fr-CA" dirty="0" err="1"/>
              <a:t>College</a:t>
            </a:r>
            <a:r>
              <a:rPr lang="fr-CA" dirty="0"/>
              <a:t> of </a:t>
            </a:r>
            <a:r>
              <a:rPr lang="fr-CA" dirty="0" err="1"/>
              <a:t>Anaesthetists</a:t>
            </a:r>
            <a:endParaRPr lang="fr-CA" dirty="0"/>
          </a:p>
          <a:p>
            <a:endParaRPr lang="fr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A210A45-1FF2-4998-91A6-DCE3F76FCE6B}" type="slidenum">
              <a:rPr lang="fr-CA" smtClean="0"/>
              <a:t>3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9787580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8" name="Rectangle 7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Oval 10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2" name="Oval 11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Oval 12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2099733"/>
            <a:ext cx="8825658" cy="2677648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accent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 rot="5400000">
            <a:off x="10089390" y="1792223"/>
            <a:ext cx="990599" cy="304799"/>
          </a:xfrm>
        </p:spPr>
        <p:txBody>
          <a:bodyPr anchor="t"/>
          <a:lstStyle>
            <a:lvl1pPr algn="l">
              <a:defRPr b="0" i="0">
                <a:solidFill>
                  <a:schemeClr val="bg1"/>
                </a:solidFill>
              </a:defRPr>
            </a:lvl1pPr>
          </a:lstStyle>
          <a:p>
            <a:fld id="{1E700B27-DE4C-4B9E-BB11-B9027034A00F}" type="datetimeFigureOut">
              <a:rPr lang="en-US" dirty="0"/>
              <a:pPr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 rot="5400000">
            <a:off x="8959592" y="3226820"/>
            <a:ext cx="3859795" cy="304801"/>
          </a:xfrm>
        </p:spPr>
        <p:txBody>
          <a:bodyPr/>
          <a:lstStyle>
            <a:lvl1pPr>
              <a:defRPr b="0" i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
              </a:t>
            </a:r>
          </a:p>
        </p:txBody>
      </p:sp>
      <p:sp>
        <p:nvSpPr>
          <p:cNvPr id="10" name="Rectangle 9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351008" y="292608"/>
            <a:ext cx="838199" cy="767687"/>
          </a:xfrm>
        </p:spPr>
        <p:txBody>
          <a:bodyPr/>
          <a:lstStyle>
            <a:lvl1pPr>
              <a:defRPr sz="2800" b="0" i="0">
                <a:latin typeface="+mj-lt"/>
              </a:defRPr>
            </a:lvl1pPr>
          </a:lstStyle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panoramiqu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8" name="Freeform 5"/>
            <p:cNvSpPr/>
            <p:nvPr/>
          </p:nvSpPr>
          <p:spPr bwMode="gray">
            <a:xfrm rot="10371525">
              <a:off x="263767" y="443825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9" name="Freeform 5"/>
            <p:cNvSpPr/>
            <p:nvPr/>
          </p:nvSpPr>
          <p:spPr bwMode="gray">
            <a:xfrm rot="10800000">
              <a:off x="459506" y="321130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6" y="4966674"/>
            <a:ext cx="8825657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955" y="685800"/>
            <a:ext cx="8825658" cy="3429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6" y="5536665"/>
            <a:ext cx="8825656" cy="493712"/>
          </a:xfrm>
        </p:spPr>
        <p:txBody>
          <a:bodyPr>
            <a:normAutofit/>
          </a:bodyPr>
          <a:lstStyle>
            <a:lvl1pPr marL="0" indent="0">
              <a:buNone/>
              <a:defRPr sz="1200">
                <a:solidFill>
                  <a:schemeClr val="accent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0F4739-9812-4A9F-890D-2AD6BA5F6EE8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re et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0" name="Rectangle 9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21010068">
              <a:off x="8490951" y="271487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7" name="Freeform 5"/>
            <p:cNvSpPr/>
            <p:nvPr/>
          </p:nvSpPr>
          <p:spPr bwMode="gray">
            <a:xfrm>
              <a:off x="455612" y="2801319"/>
              <a:ext cx="11277600" cy="3602637"/>
            </a:xfrm>
            <a:custGeom>
              <a:avLst/>
              <a:gdLst/>
              <a:ahLst/>
              <a:cxnLst/>
              <a:rect l="l" t="t" r="r" b="b"/>
              <a:pathLst>
                <a:path w="10000" h="7946">
                  <a:moveTo>
                    <a:pt x="0" y="0"/>
                  </a:moveTo>
                  <a:lnTo>
                    <a:pt x="0" y="7945"/>
                  </a:lnTo>
                  <a:lnTo>
                    <a:pt x="10000" y="7946"/>
                  </a:lnTo>
                  <a:lnTo>
                    <a:pt x="10000" y="4"/>
                  </a:lnTo>
                  <a:lnTo>
                    <a:pt x="10000" y="4"/>
                  </a:lnTo>
                  <a:lnTo>
                    <a:pt x="9773" y="91"/>
                  </a:lnTo>
                  <a:lnTo>
                    <a:pt x="9547" y="175"/>
                  </a:lnTo>
                  <a:lnTo>
                    <a:pt x="9320" y="256"/>
                  </a:lnTo>
                  <a:lnTo>
                    <a:pt x="9092" y="326"/>
                  </a:lnTo>
                  <a:lnTo>
                    <a:pt x="8865" y="396"/>
                  </a:lnTo>
                  <a:lnTo>
                    <a:pt x="8637" y="462"/>
                  </a:lnTo>
                  <a:lnTo>
                    <a:pt x="8412" y="518"/>
                  </a:lnTo>
                  <a:lnTo>
                    <a:pt x="8184" y="571"/>
                  </a:lnTo>
                  <a:lnTo>
                    <a:pt x="7957" y="620"/>
                  </a:lnTo>
                  <a:lnTo>
                    <a:pt x="7734" y="662"/>
                  </a:lnTo>
                  <a:lnTo>
                    <a:pt x="7508" y="704"/>
                  </a:lnTo>
                  <a:lnTo>
                    <a:pt x="7285" y="739"/>
                  </a:lnTo>
                  <a:lnTo>
                    <a:pt x="7062" y="767"/>
                  </a:lnTo>
                  <a:lnTo>
                    <a:pt x="6840" y="795"/>
                  </a:lnTo>
                  <a:lnTo>
                    <a:pt x="6620" y="819"/>
                  </a:lnTo>
                  <a:lnTo>
                    <a:pt x="6402" y="837"/>
                  </a:lnTo>
                  <a:lnTo>
                    <a:pt x="6184" y="851"/>
                  </a:lnTo>
                  <a:lnTo>
                    <a:pt x="5968" y="865"/>
                  </a:lnTo>
                  <a:lnTo>
                    <a:pt x="5755" y="872"/>
                  </a:lnTo>
                  <a:lnTo>
                    <a:pt x="5542" y="879"/>
                  </a:lnTo>
                  <a:lnTo>
                    <a:pt x="5332" y="882"/>
                  </a:lnTo>
                  <a:lnTo>
                    <a:pt x="5124" y="879"/>
                  </a:lnTo>
                  <a:lnTo>
                    <a:pt x="4918" y="879"/>
                  </a:lnTo>
                  <a:lnTo>
                    <a:pt x="4714" y="872"/>
                  </a:lnTo>
                  <a:lnTo>
                    <a:pt x="4514" y="861"/>
                  </a:lnTo>
                  <a:lnTo>
                    <a:pt x="4316" y="851"/>
                  </a:lnTo>
                  <a:lnTo>
                    <a:pt x="4122" y="840"/>
                  </a:lnTo>
                  <a:lnTo>
                    <a:pt x="3929" y="823"/>
                  </a:lnTo>
                  <a:lnTo>
                    <a:pt x="3739" y="805"/>
                  </a:lnTo>
                  <a:lnTo>
                    <a:pt x="3553" y="788"/>
                  </a:lnTo>
                  <a:lnTo>
                    <a:pt x="3190" y="742"/>
                  </a:lnTo>
                  <a:lnTo>
                    <a:pt x="2842" y="693"/>
                  </a:lnTo>
                  <a:lnTo>
                    <a:pt x="2508" y="641"/>
                  </a:lnTo>
                  <a:lnTo>
                    <a:pt x="2192" y="585"/>
                  </a:lnTo>
                  <a:lnTo>
                    <a:pt x="1890" y="525"/>
                  </a:lnTo>
                  <a:lnTo>
                    <a:pt x="1610" y="462"/>
                  </a:lnTo>
                  <a:lnTo>
                    <a:pt x="1347" y="399"/>
                  </a:lnTo>
                  <a:lnTo>
                    <a:pt x="1105" y="336"/>
                  </a:lnTo>
                  <a:lnTo>
                    <a:pt x="883" y="277"/>
                  </a:lnTo>
                  <a:lnTo>
                    <a:pt x="686" y="221"/>
                  </a:lnTo>
                  <a:lnTo>
                    <a:pt x="508" y="168"/>
                  </a:lnTo>
                  <a:lnTo>
                    <a:pt x="358" y="123"/>
                  </a:lnTo>
                  <a:lnTo>
                    <a:pt x="232" y="81"/>
                  </a:lnTo>
                  <a:lnTo>
                    <a:pt x="59" y="2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1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1063416"/>
            <a:ext cx="8825659" cy="1379755"/>
          </a:xfrm>
        </p:spPr>
        <p:txBody>
          <a:bodyPr/>
          <a:lstStyle>
            <a:lvl1pPr>
              <a:defRPr sz="4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543300"/>
            <a:ext cx="8825659" cy="24765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5AC5-A3F8-44AA-BA8F-596CDCC976D3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itation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5" name="Rectangle 14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Freeform 5"/>
            <p:cNvSpPr/>
            <p:nvPr/>
          </p:nvSpPr>
          <p:spPr bwMode="gray">
            <a:xfrm rot="21010068">
              <a:off x="8490951" y="41851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24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6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13" name="TextBox 12"/>
          <p:cNvSpPr txBox="1"/>
          <p:nvPr/>
        </p:nvSpPr>
        <p:spPr>
          <a:xfrm>
            <a:off x="9719438" y="2631815"/>
            <a:ext cx="801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accent1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sz="9600" dirty="0"/>
              <a:t>”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98295" y="591093"/>
            <a:ext cx="801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accent1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sz="9600" dirty="0"/>
              <a:t>“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1878" y="980517"/>
            <a:ext cx="8453906" cy="2698249"/>
          </a:xfrm>
        </p:spPr>
        <p:txBody>
          <a:bodyPr/>
          <a:lstStyle>
            <a:lvl1pPr>
              <a:defRPr sz="4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4" name="Text Placeholder 3"/>
          <p:cNvSpPr>
            <a:spLocks noGrp="1"/>
          </p:cNvSpPr>
          <p:nvPr>
            <p:ph type="body" sz="half" idx="13"/>
          </p:nvPr>
        </p:nvSpPr>
        <p:spPr bwMode="gray">
          <a:xfrm>
            <a:off x="1945945" y="3678766"/>
            <a:ext cx="7725772" cy="342174"/>
          </a:xfrm>
        </p:spPr>
        <p:txBody>
          <a:bodyPr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accent1"/>
                </a:solidFill>
                <a:latin typeface="+mn-lt"/>
                <a:ea typeface="+mn-ea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4350657"/>
            <a:ext cx="8825659" cy="16764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3B183-A821-4095-A363-9EC968635539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32" name="Rectangle 3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arte n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0" name="Rectangle 9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Oval 12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Freeform 5"/>
            <p:cNvSpPr/>
            <p:nvPr/>
          </p:nvSpPr>
          <p:spPr bwMode="gray">
            <a:xfrm rot="21010068">
              <a:off x="8490951" y="4193583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1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370667"/>
            <a:ext cx="8825660" cy="1822514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5033068"/>
            <a:ext cx="8825659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D01B4-0AA5-45E6-B2E6-5FA4078AEBCF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 colonn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6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17299"/>
            <a:ext cx="312916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1154954" y="3193561"/>
            <a:ext cx="3129168" cy="2833496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12721" y="2603502"/>
            <a:ext cx="314538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4512721" y="3193561"/>
            <a:ext cx="3145380" cy="2833495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886700" y="2617299"/>
            <a:ext cx="3161029" cy="576261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886700" y="3193561"/>
            <a:ext cx="3164719" cy="28334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440397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1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77240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1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7335C-0450-40D7-8612-B3203BED4F28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 colonnes d’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6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2" y="4532845"/>
            <a:ext cx="305043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2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1334552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1154953" y="5109107"/>
            <a:ext cx="3050437" cy="91794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2537" y="4532846"/>
            <a:ext cx="3046766" cy="651156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30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748463" y="2603500"/>
            <a:ext cx="2691241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4568865" y="5184002"/>
            <a:ext cx="3050438" cy="843056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83434" y="4532847"/>
            <a:ext cx="3050438" cy="651154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31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8163031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83434" y="5184001"/>
            <a:ext cx="3050437" cy="843054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4388153" y="2603500"/>
            <a:ext cx="0" cy="3517594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801905" y="2603500"/>
            <a:ext cx="0" cy="3492500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6A105-2A1C-4284-B4EA-07CF89B1A393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3" y="973668"/>
            <a:ext cx="8825660" cy="706964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 anchorCtr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BE609-F3F2-45E6-BD6A-E03A8C86C1AE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Freeform 5"/>
            <p:cNvSpPr/>
            <p:nvPr/>
          </p:nvSpPr>
          <p:spPr bwMode="gray">
            <a:xfrm rot="5101749">
              <a:off x="6294738" y="457773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Rectangle 7"/>
            <p:cNvSpPr/>
            <p:nvPr/>
          </p:nvSpPr>
          <p:spPr>
            <a:xfrm>
              <a:off x="414867" y="402165"/>
              <a:ext cx="6510866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5400000">
              <a:off x="44492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76756" y="1278468"/>
            <a:ext cx="1413933" cy="4748589"/>
          </a:xfrm>
        </p:spPr>
        <p:txBody>
          <a:bodyPr vert="eaVert" anchor="b" anchorCtr="0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1278468"/>
            <a:ext cx="6247546" cy="4748590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4AD68-089C-4467-A8F3-EA2BBCA6B44E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bg>
      <p:bgPr>
        <a:solidFill>
          <a:srgbClr val="5F5F5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787450551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51FCE-E4BB-4680-8E50-3C0E348D2609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Rectangle 6"/>
            <p:cNvSpPr/>
            <p:nvPr/>
          </p:nvSpPr>
          <p:spPr>
            <a:xfrm>
              <a:off x="7289800" y="402165"/>
              <a:ext cx="44788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15922489">
              <a:off x="4698352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Freeform 5"/>
            <p:cNvSpPr/>
            <p:nvPr/>
          </p:nvSpPr>
          <p:spPr bwMode="gray">
            <a:xfrm rot="16200000">
              <a:off x="3787244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6" y="2677645"/>
            <a:ext cx="4351023" cy="2283824"/>
          </a:xfrm>
        </p:spPr>
        <p:txBody>
          <a:bodyPr anchor="ctr"/>
          <a:lstStyle>
            <a:lvl1pPr algn="l">
              <a:defRPr sz="40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95558" y="2677644"/>
            <a:ext cx="3755379" cy="2283823"/>
          </a:xfrm>
        </p:spPr>
        <p:txBody>
          <a:bodyPr anchor="ctr"/>
          <a:lstStyle>
            <a:lvl1pPr marL="0" indent="0" algn="l">
              <a:buNone/>
              <a:defRPr sz="2000" cap="all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A073D-A903-47F8-8D16-77642FB0DF1F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54954" y="2603500"/>
            <a:ext cx="4825158" cy="3416301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8712" y="2603500"/>
            <a:ext cx="4825159" cy="3416300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1FA40-626B-4CA1-85D0-7A9016E395BA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482515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4954" y="3179762"/>
            <a:ext cx="4825158" cy="2840039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08712" y="2603500"/>
            <a:ext cx="48251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08710" y="3179762"/>
            <a:ext cx="4825159" cy="2840039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425EA-B9DC-48A7-991E-9A82573B1B21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B97F8-6CEB-469B-AFCC-889F2A2B1D5A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9179F-009E-4FA5-B091-7EBB82A185BD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7" name="Rectangle 6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2" name="Rectangle 1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8" name="Rectangle 7"/>
            <p:cNvSpPr/>
            <p:nvPr/>
          </p:nvSpPr>
          <p:spPr>
            <a:xfrm>
              <a:off x="5713412" y="402165"/>
              <a:ext cx="6055253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Freeform 5"/>
            <p:cNvSpPr/>
            <p:nvPr/>
          </p:nvSpPr>
          <p:spPr bwMode="gray">
            <a:xfrm rot="15922489">
              <a:off x="3140485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9" name="Freeform 5"/>
            <p:cNvSpPr/>
            <p:nvPr/>
          </p:nvSpPr>
          <p:spPr bwMode="gray">
            <a:xfrm rot="16200000">
              <a:off x="2229377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3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1295400"/>
            <a:ext cx="2793159" cy="16002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81146" y="1447800"/>
            <a:ext cx="5190065" cy="4572000"/>
          </a:xfrm>
        </p:spPr>
        <p:txBody>
          <a:bodyPr anchor="ctr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5" y="2895600"/>
            <a:ext cx="2793158" cy="3129279"/>
          </a:xfrm>
        </p:spPr>
        <p:txBody>
          <a:bodyPr/>
          <a:lstStyle>
            <a:lvl1pPr marL="0" indent="0">
              <a:buNone/>
              <a:defRPr sz="1400">
                <a:solidFill>
                  <a:schemeClr val="accent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65CEB-0076-4E37-B880-BCEA9784DE0A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2" name="Rectangle 1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8" name="Rectangle 7"/>
            <p:cNvSpPr/>
            <p:nvPr/>
          </p:nvSpPr>
          <p:spPr>
            <a:xfrm>
              <a:off x="6172200" y="402165"/>
              <a:ext cx="55964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16200000">
              <a:off x="32954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0" name="Freeform 5"/>
            <p:cNvSpPr/>
            <p:nvPr/>
          </p:nvSpPr>
          <p:spPr bwMode="gray">
            <a:xfrm rot="15922489">
              <a:off x="4203594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3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3907" y="1693332"/>
            <a:ext cx="3860260" cy="1735668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47870" y="1143000"/>
            <a:ext cx="322719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5" y="3657600"/>
            <a:ext cx="3859212" cy="1371600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accent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49E5E-3896-4118-99A7-7B85668F1C5E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26" name="Rectangle 25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0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Freeform 5"/>
            <p:cNvSpPr/>
            <p:nvPr/>
          </p:nvSpPr>
          <p:spPr bwMode="gray">
            <a:xfrm rot="21010068">
              <a:off x="8490951" y="17975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20" name="Freeform 5"/>
            <p:cNvSpPr/>
            <p:nvPr/>
          </p:nvSpPr>
          <p:spPr bwMode="gray">
            <a:xfrm>
              <a:off x="459506" y="1866405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21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gray">
          <a:xfrm>
            <a:off x="1154953" y="973668"/>
            <a:ext cx="8761413" cy="7069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5" y="2603500"/>
            <a:ext cx="8761412" cy="34163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50938" y="6394061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r">
              <a:defRPr sz="1000" b="1" i="0">
                <a:solidFill>
                  <a:schemeClr val="accent1"/>
                </a:solidFill>
              </a:defRPr>
            </a:lvl1pPr>
          </a:lstStyle>
          <a:p>
            <a:fld id="{7E0D914D-B099-4142-A885-11F276715148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8358" y="6391838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000" b="1" i="0">
                <a:solidFill>
                  <a:schemeClr val="accent1"/>
                </a:solidFill>
                <a:latin typeface="+mn-lt"/>
              </a:defRPr>
            </a:lvl1pPr>
          </a:lstStyle>
          <a:p>
            <a:r>
              <a:rPr lang="en-US" dirty="0"/>
              <a:t>
              </a:t>
            </a:r>
          </a:p>
        </p:txBody>
      </p:sp>
      <p:sp>
        <p:nvSpPr>
          <p:cNvPr id="22" name="Rectangle 2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bg1"/>
                </a:solidFill>
                <a:latin typeface="+mn-lt"/>
              </a:defRPr>
            </a:lvl1pPr>
          </a:lstStyle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68" r:id="rId9"/>
    <p:sldLayoutId id="2147483667" r:id="rId10"/>
    <p:sldLayoutId id="2147483661" r:id="rId11"/>
    <p:sldLayoutId id="2147483664" r:id="rId12"/>
    <p:sldLayoutId id="2147483662" r:id="rId13"/>
    <p:sldLayoutId id="2147483669" r:id="rId14"/>
    <p:sldLayoutId id="2147483670" r:id="rId15"/>
    <p:sldLayoutId id="2147483658" r:id="rId16"/>
    <p:sldLayoutId id="2147483659" r:id="rId17"/>
    <p:sldLayoutId id="2147483671" r:id="rId18"/>
  </p:sldLayoutIdLst>
  <p:hf sldNum="0" hdr="0" ftr="0" dt="0"/>
  <p:txStyles>
    <p:titleStyle>
      <a:lvl1pPr algn="l" defTabSz="457200" rtl="0" eaLnBrk="1" latinLnBrk="0" hangingPunct="1">
        <a:spcBef>
          <a:spcPct val="0"/>
        </a:spcBef>
        <a:buNone/>
        <a:defRPr sz="3600" b="0" i="0" kern="1200">
          <a:solidFill>
            <a:schemeClr val="bg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E9824D3-828D-46F4-8DA7-77B261BB61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75624" y="585960"/>
            <a:ext cx="10818055" cy="2677648"/>
          </a:xfrm>
        </p:spPr>
        <p:txBody>
          <a:bodyPr/>
          <a:lstStyle/>
          <a:p>
            <a:r>
              <a:rPr lang="en-CA" sz="6000" dirty="0">
                <a:solidFill>
                  <a:schemeClr val="bg1"/>
                </a:solidFill>
              </a:rPr>
              <a:t>Morbidity &amp; mortality conference</a:t>
            </a:r>
          </a:p>
        </p:txBody>
      </p:sp>
      <p:sp>
        <p:nvSpPr>
          <p:cNvPr id="4" name="Rectangle 3"/>
          <p:cNvSpPr/>
          <p:nvPr/>
        </p:nvSpPr>
        <p:spPr>
          <a:xfrm>
            <a:off x="466928" y="5189130"/>
            <a:ext cx="11235446" cy="11965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265884" y="3767423"/>
            <a:ext cx="4129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>
                <a:solidFill>
                  <a:schemeClr val="bg1"/>
                </a:solidFill>
              </a:rPr>
              <a:t>Dr. Frédérik</a:t>
            </a:r>
            <a:r>
              <a:rPr lang="en-US" sz="2400" dirty="0">
                <a:solidFill>
                  <a:schemeClr val="bg1"/>
                </a:solidFill>
              </a:rPr>
              <a:t> Rousseau-Blass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3036" y="5258495"/>
            <a:ext cx="4245337" cy="1127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55793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0B5C832-DB2F-4F16-BEA1-9ABD05928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 err="1"/>
              <a:t>Predicted</a:t>
            </a:r>
            <a:r>
              <a:rPr lang="fr-CA" sz="5400" dirty="0"/>
              <a:t> PaO</a:t>
            </a:r>
            <a:r>
              <a:rPr lang="fr-CA" sz="5400" baseline="-25000" dirty="0"/>
              <a:t>2</a:t>
            </a:r>
            <a:r>
              <a:rPr lang="fr-CA" sz="5400" dirty="0"/>
              <a:t> </a:t>
            </a:r>
            <a:r>
              <a:rPr lang="fr-CA" sz="5400" dirty="0" err="1"/>
              <a:t>from</a:t>
            </a:r>
            <a:r>
              <a:rPr lang="fr-CA" sz="5400" dirty="0"/>
              <a:t> FIO</a:t>
            </a:r>
            <a:r>
              <a:rPr lang="fr-CA" sz="5400" baseline="-25000" dirty="0"/>
              <a:t>2</a:t>
            </a:r>
            <a:endParaRPr lang="fr-CA" sz="5400" dirty="0"/>
          </a:p>
        </p:txBody>
      </p:sp>
      <p:graphicFrame>
        <p:nvGraphicFramePr>
          <p:cNvPr id="9" name="Espace réservé du contenu 8">
            <a:extLst>
              <a:ext uri="{FF2B5EF4-FFF2-40B4-BE49-F238E27FC236}">
                <a16:creationId xmlns:a16="http://schemas.microsoft.com/office/drawing/2014/main" id="{B1E3AAB9-31B9-4DE6-BEC5-B75EF27E931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3993087"/>
              </p:ext>
            </p:extLst>
          </p:nvPr>
        </p:nvGraphicFramePr>
        <p:xfrm>
          <a:off x="2292011" y="2436533"/>
          <a:ext cx="7652090" cy="4372480"/>
        </p:xfrm>
        <a:graphic>
          <a:graphicData uri="http://schemas.openxmlformats.org/drawingml/2006/table">
            <a:tbl>
              <a:tblPr firstRow="1" bandRow="1">
                <a:tableStyleId>{D27102A9-8310-4765-A935-A1911B00CA55}</a:tableStyleId>
              </a:tblPr>
              <a:tblGrid>
                <a:gridCol w="3826045">
                  <a:extLst>
                    <a:ext uri="{9D8B030D-6E8A-4147-A177-3AD203B41FA5}">
                      <a16:colId xmlns:a16="http://schemas.microsoft.com/office/drawing/2014/main" val="2801958282"/>
                    </a:ext>
                  </a:extLst>
                </a:gridCol>
                <a:gridCol w="3826045">
                  <a:extLst>
                    <a:ext uri="{9D8B030D-6E8A-4147-A177-3AD203B41FA5}">
                      <a16:colId xmlns:a16="http://schemas.microsoft.com/office/drawing/2014/main" val="1450224159"/>
                    </a:ext>
                  </a:extLst>
                </a:gridCol>
              </a:tblGrid>
              <a:tr h="874496">
                <a:tc gridSpan="2"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PaO</a:t>
                      </a:r>
                      <a:r>
                        <a:rPr lang="fr-CA" sz="3600" baseline="-25000" dirty="0"/>
                        <a:t>2</a:t>
                      </a:r>
                      <a:r>
                        <a:rPr lang="fr-CA" sz="3600" baseline="0" dirty="0"/>
                        <a:t>/FiO</a:t>
                      </a:r>
                      <a:r>
                        <a:rPr lang="fr-CA" sz="3600" baseline="-25000" dirty="0"/>
                        <a:t>2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6455683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/>
                        <a:t>Norm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&gt;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5934593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 err="1"/>
                        <a:t>Mild</a:t>
                      </a:r>
                      <a:r>
                        <a:rPr lang="fr-CA" sz="3600" dirty="0"/>
                        <a:t> sh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300-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521015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 err="1"/>
                        <a:t>Moderate</a:t>
                      </a:r>
                      <a:r>
                        <a:rPr lang="fr-CA" sz="3600" dirty="0"/>
                        <a:t> sh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200-3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774645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 err="1"/>
                        <a:t>Severe</a:t>
                      </a:r>
                      <a:r>
                        <a:rPr lang="fr-CA" sz="3600" dirty="0"/>
                        <a:t> sh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&lt;2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5498957"/>
                  </a:ext>
                </a:extLst>
              </a:tr>
            </a:tbl>
          </a:graphicData>
        </a:graphic>
      </p:graphicFrame>
      <p:sp>
        <p:nvSpPr>
          <p:cNvPr id="5" name="Rectangle : coins arrondis 4">
            <a:extLst>
              <a:ext uri="{FF2B5EF4-FFF2-40B4-BE49-F238E27FC236}">
                <a16:creationId xmlns:a16="http://schemas.microsoft.com/office/drawing/2014/main" id="{A0B21C1B-4EF4-41B0-8B34-B9488DC473F3}"/>
              </a:ext>
            </a:extLst>
          </p:cNvPr>
          <p:cNvSpPr/>
          <p:nvPr/>
        </p:nvSpPr>
        <p:spPr>
          <a:xfrm>
            <a:off x="2292012" y="3391198"/>
            <a:ext cx="1776404" cy="485456"/>
          </a:xfrm>
          <a:prstGeom prst="roundRect">
            <a:avLst/>
          </a:prstGeom>
          <a:solidFill>
            <a:srgbClr val="00B05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" name="Rectangle : coins arrondis 5">
            <a:extLst>
              <a:ext uri="{FF2B5EF4-FFF2-40B4-BE49-F238E27FC236}">
                <a16:creationId xmlns:a16="http://schemas.microsoft.com/office/drawing/2014/main" id="{AA164FB4-25C8-4FD1-8240-A2EBB840B641}"/>
              </a:ext>
            </a:extLst>
          </p:cNvPr>
          <p:cNvSpPr/>
          <p:nvPr/>
        </p:nvSpPr>
        <p:spPr>
          <a:xfrm>
            <a:off x="7420195" y="3379303"/>
            <a:ext cx="1299737" cy="497351"/>
          </a:xfrm>
          <a:prstGeom prst="roundRect">
            <a:avLst/>
          </a:prstGeom>
          <a:solidFill>
            <a:srgbClr val="00B05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7" name="Rectangle : coins arrondis 6">
            <a:extLst>
              <a:ext uri="{FF2B5EF4-FFF2-40B4-BE49-F238E27FC236}">
                <a16:creationId xmlns:a16="http://schemas.microsoft.com/office/drawing/2014/main" id="{5CEAA658-BC3C-4347-861A-66114CB9EA99}"/>
              </a:ext>
            </a:extLst>
          </p:cNvPr>
          <p:cNvSpPr/>
          <p:nvPr/>
        </p:nvSpPr>
        <p:spPr>
          <a:xfrm>
            <a:off x="7420192" y="6012768"/>
            <a:ext cx="1299739" cy="485456"/>
          </a:xfrm>
          <a:prstGeom prst="roundRect">
            <a:avLst/>
          </a:prstGeom>
          <a:solidFill>
            <a:srgbClr val="FF000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8" name="Rectangle : coins arrondis 7">
            <a:extLst>
              <a:ext uri="{FF2B5EF4-FFF2-40B4-BE49-F238E27FC236}">
                <a16:creationId xmlns:a16="http://schemas.microsoft.com/office/drawing/2014/main" id="{2F0FABA3-A412-4F2B-9C1E-3AC638B80CD5}"/>
              </a:ext>
            </a:extLst>
          </p:cNvPr>
          <p:cNvSpPr/>
          <p:nvPr/>
        </p:nvSpPr>
        <p:spPr>
          <a:xfrm>
            <a:off x="2292010" y="5999516"/>
            <a:ext cx="2983380" cy="485456"/>
          </a:xfrm>
          <a:prstGeom prst="roundRect">
            <a:avLst/>
          </a:prstGeom>
          <a:solidFill>
            <a:srgbClr val="FF000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0831914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6" grpId="0" animBg="1"/>
      <p:bldP spid="7" grpId="0" animBg="1"/>
      <p:bldP spid="8" grpId="0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Anaesthesia</a:t>
            </a:r>
            <a:r>
              <a:rPr lang="en-US" dirty="0"/>
              <a:t> - maintena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Low SpO</a:t>
            </a:r>
            <a:r>
              <a:rPr lang="en-US" baseline="-25000" dirty="0"/>
              <a:t>2</a:t>
            </a:r>
            <a:r>
              <a:rPr lang="en-US" dirty="0"/>
              <a:t> values noted during first 30 mins of </a:t>
            </a:r>
            <a:r>
              <a:rPr lang="en-US" dirty="0" err="1"/>
              <a:t>anaesthesia</a:t>
            </a:r>
            <a:r>
              <a:rPr lang="en-US" dirty="0"/>
              <a:t> (FIO</a:t>
            </a:r>
            <a:r>
              <a:rPr lang="en-US" baseline="-25000" dirty="0"/>
              <a:t>2</a:t>
            </a:r>
            <a:r>
              <a:rPr lang="en-US" dirty="0"/>
              <a:t> ≈ 1.0) </a:t>
            </a:r>
            <a:r>
              <a:rPr lang="mr-IN" dirty="0"/>
              <a:t>–</a:t>
            </a:r>
            <a:r>
              <a:rPr lang="en-US" dirty="0"/>
              <a:t> 90-95%</a:t>
            </a:r>
          </a:p>
          <a:p>
            <a:pPr lvl="1"/>
            <a:r>
              <a:rPr lang="en-US" dirty="0"/>
              <a:t>Ventilation: 8 breaths/min, 8L tidal volume, peak </a:t>
            </a:r>
            <a:r>
              <a:rPr lang="en-US" dirty="0" err="1"/>
              <a:t>insp</a:t>
            </a:r>
            <a:r>
              <a:rPr lang="en-US" dirty="0"/>
              <a:t> pressure 28 cm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  <a:p>
            <a:pPr lvl="1"/>
            <a:r>
              <a:rPr lang="en-US" dirty="0"/>
              <a:t>First ABG </a:t>
            </a:r>
            <a:r>
              <a:rPr lang="mr-IN" dirty="0"/>
              <a:t>–</a:t>
            </a:r>
            <a:r>
              <a:rPr lang="en-US" dirty="0"/>
              <a:t> pH = 7.41, PaCO</a:t>
            </a:r>
            <a:r>
              <a:rPr lang="en-US" baseline="-25000" dirty="0"/>
              <a:t>2</a:t>
            </a:r>
            <a:r>
              <a:rPr lang="en-US" dirty="0"/>
              <a:t> = 42 mmHg, PaO</a:t>
            </a:r>
            <a:r>
              <a:rPr lang="en-US" baseline="-25000" dirty="0"/>
              <a:t>2</a:t>
            </a:r>
            <a:r>
              <a:rPr lang="en-US" dirty="0"/>
              <a:t> = 82 mmHg (FIO</a:t>
            </a:r>
            <a:r>
              <a:rPr lang="en-US" baseline="-25000" dirty="0"/>
              <a:t>2</a:t>
            </a:r>
            <a:r>
              <a:rPr lang="en-US" dirty="0"/>
              <a:t> ≈ 1.0)</a:t>
            </a:r>
          </a:p>
          <a:p>
            <a:r>
              <a:rPr lang="en-US" dirty="0"/>
              <a:t>Response to blood gas results</a:t>
            </a:r>
          </a:p>
          <a:p>
            <a:pPr lvl="1"/>
            <a:r>
              <a:rPr lang="en-US" dirty="0"/>
              <a:t>Ventilation: 8 breaths/min, 9L tidal volume, peak </a:t>
            </a:r>
            <a:r>
              <a:rPr lang="en-US" dirty="0" err="1"/>
              <a:t>insp</a:t>
            </a:r>
            <a:r>
              <a:rPr lang="en-US" dirty="0"/>
              <a:t> pressure 30 cm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  <a:p>
            <a:pPr lvl="1"/>
            <a:r>
              <a:rPr lang="en-US" dirty="0"/>
              <a:t>Salbutamol 2 mcg/kg via gas sampling port at y-piece</a:t>
            </a:r>
          </a:p>
          <a:p>
            <a:r>
              <a:rPr lang="en-US" dirty="0"/>
              <a:t>Second ABG (30 minutes after first, 15 minutes after salbutamol)</a:t>
            </a:r>
          </a:p>
          <a:p>
            <a:pPr lvl="1"/>
            <a:r>
              <a:rPr lang="en-US" dirty="0"/>
              <a:t>pH = 7.44, PaCO</a:t>
            </a:r>
            <a:r>
              <a:rPr lang="en-US" baseline="-25000" dirty="0"/>
              <a:t>2</a:t>
            </a:r>
            <a:r>
              <a:rPr lang="en-US" dirty="0"/>
              <a:t> = 38 mmHg, PaO</a:t>
            </a:r>
            <a:r>
              <a:rPr lang="en-US" baseline="-25000" dirty="0"/>
              <a:t>2</a:t>
            </a:r>
            <a:r>
              <a:rPr lang="en-US" dirty="0"/>
              <a:t> = 172 mmHg (FIO</a:t>
            </a:r>
            <a:r>
              <a:rPr lang="en-US" baseline="-25000" dirty="0"/>
              <a:t>2</a:t>
            </a:r>
            <a:r>
              <a:rPr lang="en-US" dirty="0"/>
              <a:t> ≈ 1.0)</a:t>
            </a:r>
          </a:p>
          <a:p>
            <a:pPr lvl="1"/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897069" y="5942138"/>
            <a:ext cx="101537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uring actual presentation, copies of </a:t>
            </a:r>
            <a:r>
              <a:rPr lang="en-US" dirty="0" err="1"/>
              <a:t>anaesthetic</a:t>
            </a:r>
            <a:r>
              <a:rPr lang="en-US" dirty="0"/>
              <a:t> chart and blood gas results displayed)</a:t>
            </a:r>
          </a:p>
        </p:txBody>
      </p:sp>
    </p:spTree>
    <p:extLst>
      <p:ext uri="{BB962C8B-B14F-4D97-AF65-F5344CB8AC3E}">
        <p14:creationId xmlns:p14="http://schemas.microsoft.com/office/powerpoint/2010/main" val="11491883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015319-7FAA-4906-BBF7-248C02F942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54953" y="973668"/>
            <a:ext cx="9382418" cy="706964"/>
          </a:xfrm>
        </p:spPr>
        <p:txBody>
          <a:bodyPr/>
          <a:lstStyle/>
          <a:p>
            <a:r>
              <a:rPr lang="fr-CA" sz="5400" dirty="0" err="1">
                <a:solidFill>
                  <a:schemeClr val="bg1"/>
                </a:solidFill>
              </a:rPr>
              <a:t>Assessment</a:t>
            </a:r>
            <a:r>
              <a:rPr lang="fr-CA" sz="5400" dirty="0">
                <a:solidFill>
                  <a:schemeClr val="bg1"/>
                </a:solidFill>
              </a:rPr>
              <a:t> &amp; </a:t>
            </a:r>
            <a:r>
              <a:rPr lang="fr-CA" sz="5400" dirty="0" err="1">
                <a:solidFill>
                  <a:schemeClr val="bg1"/>
                </a:solidFill>
              </a:rPr>
              <a:t>analysis</a:t>
            </a:r>
            <a:r>
              <a:rPr lang="fr-CA" sz="5400" dirty="0">
                <a:solidFill>
                  <a:schemeClr val="bg1"/>
                </a:solidFill>
              </a:rPr>
              <a:t> </a:t>
            </a:r>
            <a:r>
              <a:rPr lang="fr-CA" dirty="0"/>
              <a:t>(SB</a:t>
            </a:r>
            <a:r>
              <a:rPr lang="fr-CA" b="1" dirty="0"/>
              <a:t>A</a:t>
            </a:r>
            <a:r>
              <a:rPr lang="fr-CA" dirty="0"/>
              <a:t>R)</a:t>
            </a:r>
            <a:r>
              <a:rPr lang="fr-CA" sz="5400" dirty="0"/>
              <a:t> - </a:t>
            </a:r>
            <a:r>
              <a:rPr lang="fr-CA" sz="5400" dirty="0">
                <a:solidFill>
                  <a:srgbClr val="FF0000"/>
                </a:solidFill>
              </a:rPr>
              <a:t>Adverse </a:t>
            </a:r>
            <a:r>
              <a:rPr lang="fr-CA" sz="5400" dirty="0" err="1">
                <a:solidFill>
                  <a:srgbClr val="FF0000"/>
                </a:solidFill>
              </a:rPr>
              <a:t>event</a:t>
            </a:r>
            <a:r>
              <a:rPr lang="fr-CA" dirty="0"/>
              <a:t> </a:t>
            </a:r>
          </a:p>
        </p:txBody>
      </p:sp>
      <p:graphicFrame>
        <p:nvGraphicFramePr>
          <p:cNvPr id="4" name="Espace réservé du contenu 3">
            <a:extLst>
              <a:ext uri="{FF2B5EF4-FFF2-40B4-BE49-F238E27FC236}">
                <a16:creationId xmlns:a16="http://schemas.microsoft.com/office/drawing/2014/main" id="{93C25534-C4D7-451B-8728-43F08E35905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52687018"/>
              </p:ext>
            </p:extLst>
          </p:nvPr>
        </p:nvGraphicFramePr>
        <p:xfrm>
          <a:off x="1155700" y="2438399"/>
          <a:ext cx="9381671" cy="423817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4431994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2FC697E-9531-498F-B097-34A03C242D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8929" y="521384"/>
            <a:ext cx="10107561" cy="1405738"/>
          </a:xfrm>
        </p:spPr>
        <p:txBody>
          <a:bodyPr/>
          <a:lstStyle/>
          <a:p>
            <a:r>
              <a:rPr lang="fr-CA" sz="5400" dirty="0" err="1">
                <a:solidFill>
                  <a:schemeClr val="bg1"/>
                </a:solidFill>
              </a:rPr>
              <a:t>Assessment</a:t>
            </a:r>
            <a:r>
              <a:rPr lang="fr-CA" sz="5400" dirty="0">
                <a:solidFill>
                  <a:schemeClr val="bg1"/>
                </a:solidFill>
              </a:rPr>
              <a:t> &amp; </a:t>
            </a:r>
            <a:r>
              <a:rPr lang="fr-CA" sz="5400" dirty="0" err="1">
                <a:solidFill>
                  <a:schemeClr val="bg1"/>
                </a:solidFill>
              </a:rPr>
              <a:t>analysis</a:t>
            </a:r>
            <a:r>
              <a:rPr lang="fr-CA" sz="5400" dirty="0">
                <a:solidFill>
                  <a:schemeClr val="bg1"/>
                </a:solidFill>
              </a:rPr>
              <a:t> </a:t>
            </a:r>
            <a:r>
              <a:rPr lang="fr-CA" dirty="0"/>
              <a:t>(SB</a:t>
            </a:r>
            <a:r>
              <a:rPr lang="fr-CA" b="1" dirty="0"/>
              <a:t>A</a:t>
            </a:r>
            <a:r>
              <a:rPr lang="fr-CA" dirty="0"/>
              <a:t>R) </a:t>
            </a:r>
            <a:br>
              <a:rPr lang="fr-CA" dirty="0"/>
            </a:br>
            <a:r>
              <a:rPr lang="fr-CA" dirty="0"/>
              <a:t>- </a:t>
            </a:r>
            <a:r>
              <a:rPr lang="fr-CA" sz="5400" dirty="0"/>
              <a:t>Transfer</a:t>
            </a:r>
          </a:p>
        </p:txBody>
      </p:sp>
      <p:pic>
        <p:nvPicPr>
          <p:cNvPr id="17" name="Image 16">
            <a:extLst>
              <a:ext uri="{FF2B5EF4-FFF2-40B4-BE49-F238E27FC236}">
                <a16:creationId xmlns:a16="http://schemas.microsoft.com/office/drawing/2014/main" id="{2316218E-AE87-453E-B8B4-13588E2C67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768" t="24640" r="13207" b="4353"/>
          <a:stretch/>
        </p:blipFill>
        <p:spPr>
          <a:xfrm rot="16200000">
            <a:off x="9492210" y="3997101"/>
            <a:ext cx="1575582" cy="3692769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4019" y="2535406"/>
            <a:ext cx="8761412" cy="3416300"/>
          </a:xfrm>
        </p:spPr>
        <p:txBody>
          <a:bodyPr/>
          <a:lstStyle/>
          <a:p>
            <a:r>
              <a:rPr lang="en-US" dirty="0"/>
              <a:t>1. Positive pressure ventilation attempted with Hudson demand valve during transfer to cart, but ET tube cuff deflated when horse was lifted by hoist</a:t>
            </a:r>
          </a:p>
          <a:p>
            <a:r>
              <a:rPr lang="en-US" dirty="0"/>
              <a:t>2. Body position changed from left lateral recumbency (in MRI) to right lateral recumbency for transfer to recovery box</a:t>
            </a:r>
          </a:p>
          <a:p>
            <a:r>
              <a:rPr lang="en-US" dirty="0"/>
              <a:t>3. Transfer to recovery box via cart, taking approximately 3-5 minutes. Limited ability to provide positive pressure ventilation during transfer.</a:t>
            </a:r>
          </a:p>
          <a:p>
            <a:r>
              <a:rPr lang="en-US" dirty="0"/>
              <a:t>4. Horse maintained in right lateral recumbency for recovery (rope assisted). Tachypnea noted during transfer, mucous membranes grey.</a:t>
            </a:r>
          </a:p>
        </p:txBody>
      </p:sp>
    </p:spTree>
    <p:extLst>
      <p:ext uri="{BB962C8B-B14F-4D97-AF65-F5344CB8AC3E}">
        <p14:creationId xmlns:p14="http://schemas.microsoft.com/office/powerpoint/2010/main" val="24709742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8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Rot by="10800000">
                                      <p:cBhvr>
                                        <p:cTn id="10" dur="20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Espace réservé du contenu 3">
            <a:extLst>
              <a:ext uri="{FF2B5EF4-FFF2-40B4-BE49-F238E27FC236}">
                <a16:creationId xmlns:a16="http://schemas.microsoft.com/office/drawing/2014/main" id="{110EBB41-080F-4E5A-90A0-CA5637CA376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33171332"/>
              </p:ext>
            </p:extLst>
          </p:nvPr>
        </p:nvGraphicFramePr>
        <p:xfrm>
          <a:off x="98474" y="2391507"/>
          <a:ext cx="12093526" cy="446649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0" name="ZoneTexte 9">
            <a:extLst>
              <a:ext uri="{FF2B5EF4-FFF2-40B4-BE49-F238E27FC236}">
                <a16:creationId xmlns:a16="http://schemas.microsoft.com/office/drawing/2014/main" id="{DAB5BCC0-2D9F-4115-9DAA-9CB3CE04109C}"/>
              </a:ext>
            </a:extLst>
          </p:cNvPr>
          <p:cNvSpPr txBox="1"/>
          <p:nvPr/>
        </p:nvSpPr>
        <p:spPr>
          <a:xfrm>
            <a:off x="105723" y="3226501"/>
            <a:ext cx="20973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Tachypnea</a:t>
            </a:r>
            <a:r>
              <a:rPr lang="fr-FR" dirty="0"/>
              <a:t> </a:t>
            </a:r>
            <a:r>
              <a:rPr lang="fr-FR" dirty="0" err="1"/>
              <a:t>observed</a:t>
            </a:r>
            <a:r>
              <a:rPr lang="fr-FR" dirty="0"/>
              <a:t> </a:t>
            </a:r>
            <a:r>
              <a:rPr lang="fr-FR" dirty="0" err="1"/>
              <a:t>during</a:t>
            </a:r>
            <a:r>
              <a:rPr lang="fr-FR" dirty="0"/>
              <a:t> </a:t>
            </a:r>
            <a:r>
              <a:rPr lang="fr-FR" dirty="0" err="1"/>
              <a:t>transfer</a:t>
            </a:r>
            <a:endParaRPr lang="fr-FR" dirty="0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0ED6D6C3-450D-466E-9869-C8B05DC043C3}"/>
              </a:ext>
            </a:extLst>
          </p:cNvPr>
          <p:cNvSpPr txBox="1"/>
          <p:nvPr/>
        </p:nvSpPr>
        <p:spPr>
          <a:xfrm>
            <a:off x="1415956" y="5036333"/>
            <a:ext cx="16480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/>
              <a:t>12h10-12h15</a:t>
            </a:r>
          </a:p>
          <a:p>
            <a:pPr algn="ctr"/>
            <a:r>
              <a:rPr lang="fr-FR" dirty="0"/>
              <a:t>Transfe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17E5963-7FE1-44E9-8639-EEA4B9999570}"/>
              </a:ext>
            </a:extLst>
          </p:cNvPr>
          <p:cNvSpPr txBox="1"/>
          <p:nvPr/>
        </p:nvSpPr>
        <p:spPr>
          <a:xfrm>
            <a:off x="1657465" y="2703145"/>
            <a:ext cx="395122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fr-FR" dirty="0"/>
              <a:t>SpO2 87% (IPPV </a:t>
            </a:r>
            <a:r>
              <a:rPr lang="fr-FR" dirty="0" err="1"/>
              <a:t>demand</a:t>
            </a:r>
            <a:r>
              <a:rPr lang="fr-FR" dirty="0"/>
              <a:t> valve):</a:t>
            </a:r>
          </a:p>
          <a:p>
            <a:pPr lvl="0" algn="ctr"/>
            <a:r>
              <a:rPr lang="fr-FR" dirty="0"/>
              <a:t>Salbutamol (2 </a:t>
            </a:r>
            <a:r>
              <a:rPr lang="fr-FR" dirty="0" err="1"/>
              <a:t>mcg</a:t>
            </a:r>
            <a:r>
              <a:rPr lang="fr-FR" dirty="0"/>
              <a:t>/kg) </a:t>
            </a:r>
            <a:br>
              <a:rPr lang="fr-FR" dirty="0"/>
            </a:br>
            <a:r>
              <a:rPr lang="fr-FR" dirty="0"/>
              <a:t>+ ABG #4 (pH 7.40, PaCO</a:t>
            </a:r>
            <a:r>
              <a:rPr lang="fr-FR" baseline="-25000" dirty="0"/>
              <a:t>2</a:t>
            </a:r>
            <a:r>
              <a:rPr lang="fr-FR" dirty="0"/>
              <a:t> 50 </a:t>
            </a:r>
            <a:r>
              <a:rPr lang="fr-FR" dirty="0" err="1"/>
              <a:t>mmHg</a:t>
            </a:r>
            <a:r>
              <a:rPr lang="fr-FR" dirty="0"/>
              <a:t>, PaO</a:t>
            </a:r>
            <a:r>
              <a:rPr lang="fr-FR" baseline="-25000" dirty="0"/>
              <a:t>2</a:t>
            </a:r>
            <a:r>
              <a:rPr lang="fr-FR" dirty="0"/>
              <a:t> 47 </a:t>
            </a:r>
            <a:r>
              <a:rPr lang="fr-FR" dirty="0" err="1"/>
              <a:t>mmHg</a:t>
            </a:r>
            <a:r>
              <a:rPr lang="fr-FR" dirty="0"/>
              <a:t>)</a:t>
            </a:r>
          </a:p>
          <a:p>
            <a:pPr lvl="0" algn="ctr"/>
            <a:r>
              <a:rPr lang="fr-FR" b="1" dirty="0"/>
              <a:t>12h25 </a:t>
            </a:r>
            <a:r>
              <a:rPr lang="mr-IN" b="1" dirty="0"/>
              <a:t>–</a:t>
            </a:r>
            <a:r>
              <a:rPr lang="fr-FR" b="1" dirty="0"/>
              <a:t> </a:t>
            </a:r>
            <a:r>
              <a:rPr lang="fr-FR" b="1" dirty="0" err="1"/>
              <a:t>recovery</a:t>
            </a:r>
            <a:r>
              <a:rPr lang="fr-FR" b="1" dirty="0"/>
              <a:t> box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D7A99AF7-C665-42DA-8E75-7C9F0B02A362}"/>
              </a:ext>
            </a:extLst>
          </p:cNvPr>
          <p:cNvSpPr txBox="1"/>
          <p:nvPr/>
        </p:nvSpPr>
        <p:spPr>
          <a:xfrm>
            <a:off x="5194051" y="2426147"/>
            <a:ext cx="272961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fr-FR" dirty="0"/>
              <a:t>SpO2 87% (IPPV </a:t>
            </a:r>
            <a:r>
              <a:rPr lang="fr-FR" dirty="0" err="1"/>
              <a:t>demand</a:t>
            </a:r>
            <a:r>
              <a:rPr lang="fr-FR" dirty="0"/>
              <a:t> valve)</a:t>
            </a:r>
            <a:br>
              <a:rPr lang="fr-FR" dirty="0"/>
            </a:br>
            <a:r>
              <a:rPr lang="fr-FR" dirty="0"/>
              <a:t>ABG #5 (pH 7.43, PaCO</a:t>
            </a:r>
            <a:r>
              <a:rPr lang="fr-FR" baseline="-25000" dirty="0"/>
              <a:t>2</a:t>
            </a:r>
            <a:r>
              <a:rPr lang="fr-FR" dirty="0"/>
              <a:t> 45 </a:t>
            </a:r>
            <a:r>
              <a:rPr lang="fr-FR" dirty="0" err="1"/>
              <a:t>mmHg</a:t>
            </a:r>
            <a:r>
              <a:rPr lang="fr-FR" dirty="0"/>
              <a:t>, PaO</a:t>
            </a:r>
            <a:r>
              <a:rPr lang="fr-FR" baseline="-25000" dirty="0"/>
              <a:t>2</a:t>
            </a:r>
            <a:r>
              <a:rPr lang="fr-FR" dirty="0"/>
              <a:t> 52 </a:t>
            </a:r>
            <a:r>
              <a:rPr lang="fr-FR" dirty="0" err="1"/>
              <a:t>mmHg</a:t>
            </a:r>
            <a:r>
              <a:rPr lang="fr-FR" dirty="0"/>
              <a:t>)</a:t>
            </a:r>
            <a:br>
              <a:rPr lang="fr-FR" dirty="0"/>
            </a:br>
            <a:r>
              <a:rPr lang="fr-FR" b="1" dirty="0"/>
              <a:t>12h38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C95BC87-E7BC-467E-BC83-AF2550228751}"/>
              </a:ext>
            </a:extLst>
          </p:cNvPr>
          <p:cNvSpPr txBox="1"/>
          <p:nvPr/>
        </p:nvSpPr>
        <p:spPr>
          <a:xfrm>
            <a:off x="6558860" y="4984128"/>
            <a:ext cx="213828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12h42</a:t>
            </a:r>
            <a:endParaRPr lang="fr-CA" dirty="0"/>
          </a:p>
          <a:p>
            <a:pPr algn="ctr"/>
            <a:r>
              <a:rPr lang="fr-CA" dirty="0" err="1"/>
              <a:t>Dobutamine</a:t>
            </a:r>
            <a:r>
              <a:rPr lang="fr-CA" dirty="0"/>
              <a:t> 1 </a:t>
            </a:r>
            <a:r>
              <a:rPr lang="fr-CA" dirty="0" err="1"/>
              <a:t>mcg</a:t>
            </a:r>
            <a:r>
              <a:rPr lang="fr-CA" dirty="0"/>
              <a:t>/kg/min + </a:t>
            </a:r>
            <a:r>
              <a:rPr lang="fr-CA" dirty="0" err="1"/>
              <a:t>Lactated</a:t>
            </a:r>
            <a:r>
              <a:rPr lang="fr-CA" dirty="0"/>
              <a:t> </a:t>
            </a:r>
            <a:r>
              <a:rPr lang="fr-CA" dirty="0" err="1"/>
              <a:t>Ringers</a:t>
            </a:r>
            <a:r>
              <a:rPr lang="fr-CA" dirty="0"/>
              <a:t> </a:t>
            </a:r>
            <a:r>
              <a:rPr lang="fr-CA" dirty="0" err="1"/>
              <a:t>Soln</a:t>
            </a:r>
            <a:endParaRPr lang="fr-CA" dirty="0"/>
          </a:p>
        </p:txBody>
      </p:sp>
      <p:sp>
        <p:nvSpPr>
          <p:cNvPr id="18" name="Ellipse 17">
            <a:extLst>
              <a:ext uri="{FF2B5EF4-FFF2-40B4-BE49-F238E27FC236}">
                <a16:creationId xmlns:a16="http://schemas.microsoft.com/office/drawing/2014/main" id="{20576CA8-1D41-4EAD-870D-C03B44F437FD}"/>
              </a:ext>
            </a:extLst>
          </p:cNvPr>
          <p:cNvSpPr/>
          <p:nvPr/>
        </p:nvSpPr>
        <p:spPr>
          <a:xfrm>
            <a:off x="9148574" y="4416219"/>
            <a:ext cx="446649" cy="446649"/>
          </a:xfrm>
          <a:prstGeom prst="ellipse">
            <a:avLst/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D6F6118E-4106-42C9-AE42-2447DB4E16C4}"/>
              </a:ext>
            </a:extLst>
          </p:cNvPr>
          <p:cNvSpPr txBox="1"/>
          <p:nvPr/>
        </p:nvSpPr>
        <p:spPr>
          <a:xfrm>
            <a:off x="8428527" y="4989639"/>
            <a:ext cx="18867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12h49</a:t>
            </a:r>
            <a:endParaRPr lang="fr-CA" dirty="0"/>
          </a:p>
          <a:p>
            <a:pPr algn="ctr"/>
            <a:r>
              <a:rPr lang="fr-CA" dirty="0"/>
              <a:t>SpO2 88%</a:t>
            </a:r>
            <a:br>
              <a:rPr lang="fr-CA" dirty="0"/>
            </a:br>
            <a:r>
              <a:rPr lang="fr-CA" dirty="0"/>
              <a:t>Salbutamol </a:t>
            </a:r>
            <a:br>
              <a:rPr lang="fr-CA" dirty="0"/>
            </a:br>
            <a:r>
              <a:rPr lang="fr-CA" dirty="0"/>
              <a:t>(2 </a:t>
            </a:r>
            <a:r>
              <a:rPr lang="fr-CA" dirty="0" err="1"/>
              <a:t>mcg</a:t>
            </a:r>
            <a:r>
              <a:rPr lang="fr-CA" dirty="0"/>
              <a:t>/kg)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3ED1653-3E69-497C-95BA-9E091E1F8DE8}"/>
              </a:ext>
            </a:extLst>
          </p:cNvPr>
          <p:cNvSpPr txBox="1"/>
          <p:nvPr/>
        </p:nvSpPr>
        <p:spPr>
          <a:xfrm>
            <a:off x="7940483" y="2122720"/>
            <a:ext cx="423470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CA" dirty="0"/>
              <a:t>SpO2 91-92% (room air)</a:t>
            </a:r>
            <a:br>
              <a:rPr lang="fr-CA" dirty="0"/>
            </a:br>
            <a:r>
              <a:rPr lang="fr-CA" dirty="0"/>
              <a:t>Normal ventilation pattern</a:t>
            </a:r>
            <a:endParaRPr lang="fr-CA" b="1" dirty="0"/>
          </a:p>
          <a:p>
            <a:pPr algn="r"/>
            <a:r>
              <a:rPr lang="fr-CA" dirty="0" err="1"/>
              <a:t>Dobut</a:t>
            </a:r>
            <a:r>
              <a:rPr lang="fr-CA" dirty="0"/>
              <a:t> </a:t>
            </a:r>
            <a:r>
              <a:rPr lang="fr-CA" dirty="0" err="1"/>
              <a:t>stopped</a:t>
            </a:r>
            <a:r>
              <a:rPr lang="fr-CA" dirty="0"/>
              <a:t> + extubation</a:t>
            </a:r>
          </a:p>
          <a:p>
            <a:pPr algn="r"/>
            <a:r>
              <a:rPr lang="fr-CA" dirty="0" err="1"/>
              <a:t>Recovery</a:t>
            </a:r>
            <a:r>
              <a:rPr lang="fr-CA" dirty="0"/>
              <a:t> to standing </a:t>
            </a:r>
            <a:r>
              <a:rPr lang="fr-CA" dirty="0" err="1"/>
              <a:t>uneventful</a:t>
            </a:r>
            <a:endParaRPr lang="fr-CA" dirty="0"/>
          </a:p>
          <a:p>
            <a:pPr algn="r"/>
            <a:r>
              <a:rPr lang="fr-FR" dirty="0"/>
              <a:t>ABG #6 (pH 7.52, PaCO</a:t>
            </a:r>
            <a:r>
              <a:rPr lang="fr-FR" baseline="-25000" dirty="0"/>
              <a:t>2</a:t>
            </a:r>
            <a:r>
              <a:rPr lang="fr-FR" dirty="0"/>
              <a:t> 36 </a:t>
            </a:r>
            <a:r>
              <a:rPr lang="fr-FR" dirty="0" err="1"/>
              <a:t>mmHg</a:t>
            </a:r>
            <a:r>
              <a:rPr lang="fr-FR" dirty="0"/>
              <a:t>, PaO</a:t>
            </a:r>
            <a:r>
              <a:rPr lang="fr-FR" baseline="-25000" dirty="0"/>
              <a:t>2</a:t>
            </a:r>
            <a:r>
              <a:rPr lang="fr-FR" dirty="0"/>
              <a:t> 131 </a:t>
            </a:r>
            <a:r>
              <a:rPr lang="fr-FR" dirty="0" err="1"/>
              <a:t>mmHg</a:t>
            </a:r>
            <a:r>
              <a:rPr lang="fr-FR" dirty="0"/>
              <a:t>)</a:t>
            </a:r>
            <a:endParaRPr lang="fr-CA" dirty="0"/>
          </a:p>
          <a:p>
            <a:pPr algn="ctr"/>
            <a:r>
              <a:rPr lang="fr-CA" b="1" dirty="0"/>
              <a:t>13h07</a:t>
            </a:r>
            <a:endParaRPr lang="fr-CA" dirty="0"/>
          </a:p>
        </p:txBody>
      </p:sp>
      <p:sp>
        <p:nvSpPr>
          <p:cNvPr id="24" name="Ellipse 23">
            <a:extLst>
              <a:ext uri="{FF2B5EF4-FFF2-40B4-BE49-F238E27FC236}">
                <a16:creationId xmlns:a16="http://schemas.microsoft.com/office/drawing/2014/main" id="{D21D78C9-CEC9-4D51-A234-B7D7551B6C8F}"/>
              </a:ext>
            </a:extLst>
          </p:cNvPr>
          <p:cNvSpPr/>
          <p:nvPr/>
        </p:nvSpPr>
        <p:spPr>
          <a:xfrm>
            <a:off x="3409754" y="4416220"/>
            <a:ext cx="446649" cy="446649"/>
          </a:xfrm>
          <a:prstGeom prst="ellipse">
            <a:avLst/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17" name="Titre 1">
            <a:extLst>
              <a:ext uri="{FF2B5EF4-FFF2-40B4-BE49-F238E27FC236}">
                <a16:creationId xmlns:a16="http://schemas.microsoft.com/office/drawing/2014/main" id="{12FC697E-9531-498F-B097-34A03C242DAF}"/>
              </a:ext>
            </a:extLst>
          </p:cNvPr>
          <p:cNvSpPr txBox="1">
            <a:spLocks/>
          </p:cNvSpPr>
          <p:nvPr/>
        </p:nvSpPr>
        <p:spPr bwMode="gray">
          <a:xfrm>
            <a:off x="884902" y="485489"/>
            <a:ext cx="10107561" cy="140573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3600" b="0" i="0" kern="1200">
                <a:solidFill>
                  <a:schemeClr val="bg2"/>
                </a:solidFill>
                <a:latin typeface="+mj-lt"/>
                <a:ea typeface="+mj-ea"/>
                <a:cs typeface="+mj-c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fr-CA" sz="5400" dirty="0" err="1">
                <a:solidFill>
                  <a:schemeClr val="bg1"/>
                </a:solidFill>
              </a:rPr>
              <a:t>Assessment</a:t>
            </a:r>
            <a:r>
              <a:rPr lang="fr-CA" sz="5400" dirty="0">
                <a:solidFill>
                  <a:schemeClr val="bg1"/>
                </a:solidFill>
              </a:rPr>
              <a:t> &amp; </a:t>
            </a:r>
            <a:r>
              <a:rPr lang="fr-CA" sz="5400" dirty="0" err="1">
                <a:solidFill>
                  <a:schemeClr val="bg1"/>
                </a:solidFill>
              </a:rPr>
              <a:t>analysis</a:t>
            </a:r>
            <a:r>
              <a:rPr lang="fr-CA" sz="5400" dirty="0">
                <a:solidFill>
                  <a:schemeClr val="bg1"/>
                </a:solidFill>
              </a:rPr>
              <a:t> </a:t>
            </a:r>
            <a:r>
              <a:rPr lang="fr-CA" dirty="0"/>
              <a:t>(SB</a:t>
            </a:r>
            <a:r>
              <a:rPr lang="fr-CA" b="1" dirty="0"/>
              <a:t>A</a:t>
            </a:r>
            <a:r>
              <a:rPr lang="fr-CA" dirty="0"/>
              <a:t>R) </a:t>
            </a:r>
            <a:br>
              <a:rPr lang="fr-CA" dirty="0"/>
            </a:br>
            <a:r>
              <a:rPr lang="fr-CA" dirty="0"/>
              <a:t>- </a:t>
            </a:r>
            <a:r>
              <a:rPr lang="fr-CA" sz="5400" dirty="0" err="1"/>
              <a:t>Recovery</a:t>
            </a:r>
            <a:r>
              <a:rPr lang="fr-CA" sz="5400" dirty="0"/>
              <a:t> box</a:t>
            </a:r>
          </a:p>
        </p:txBody>
      </p:sp>
    </p:spTree>
    <p:extLst>
      <p:ext uri="{BB962C8B-B14F-4D97-AF65-F5344CB8AC3E}">
        <p14:creationId xmlns:p14="http://schemas.microsoft.com/office/powerpoint/2010/main" val="5512657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  <p:bldP spid="11" grpId="0"/>
      <p:bldP spid="13" grpId="0"/>
      <p:bldP spid="15" grpId="0"/>
      <p:bldP spid="16" grpId="0"/>
      <p:bldP spid="19" grpId="0"/>
      <p:bldP spid="20" grpId="0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EF892F-E35E-4826-B661-0269DE2713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37244" y="2676070"/>
            <a:ext cx="8761412" cy="3416300"/>
          </a:xfrm>
        </p:spPr>
        <p:txBody>
          <a:bodyPr/>
          <a:lstStyle/>
          <a:p>
            <a:endParaRPr lang="fr-CA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27943C1D-4AFC-4E84-934C-D50E4B654AEF}"/>
              </a:ext>
            </a:extLst>
          </p:cNvPr>
          <p:cNvSpPr txBox="1"/>
          <p:nvPr/>
        </p:nvSpPr>
        <p:spPr>
          <a:xfrm>
            <a:off x="217717" y="2322127"/>
            <a:ext cx="2873829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Personnel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AAEF843-B317-445A-9465-E2FE3D0F2C58}"/>
              </a:ext>
            </a:extLst>
          </p:cNvPr>
          <p:cNvSpPr txBox="1"/>
          <p:nvPr/>
        </p:nvSpPr>
        <p:spPr>
          <a:xfrm>
            <a:off x="3389089" y="2329385"/>
            <a:ext cx="2873829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 err="1"/>
              <a:t>Procedure</a:t>
            </a:r>
            <a:endParaRPr lang="fr-CA" sz="4000" b="1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889B2C2-1AEA-4B5A-BCCD-0C0F136CBC7D}"/>
              </a:ext>
            </a:extLst>
          </p:cNvPr>
          <p:cNvSpPr txBox="1"/>
          <p:nvPr/>
        </p:nvSpPr>
        <p:spPr>
          <a:xfrm>
            <a:off x="6647546" y="2322129"/>
            <a:ext cx="3197332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Equipmen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8672BEF-582C-4728-8C10-40DA18811894}"/>
              </a:ext>
            </a:extLst>
          </p:cNvPr>
          <p:cNvSpPr txBox="1"/>
          <p:nvPr/>
        </p:nvSpPr>
        <p:spPr>
          <a:xfrm>
            <a:off x="79824" y="5870872"/>
            <a:ext cx="3955152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 err="1"/>
              <a:t>Environment</a:t>
            </a:r>
            <a:endParaRPr lang="fr-CA" sz="4000" b="1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92FBD79-E830-476C-813F-6D430C80303B}"/>
              </a:ext>
            </a:extLst>
          </p:cNvPr>
          <p:cNvSpPr txBox="1"/>
          <p:nvPr/>
        </p:nvSpPr>
        <p:spPr>
          <a:xfrm>
            <a:off x="4187605" y="5856356"/>
            <a:ext cx="3404499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/>
              <a:t>Organisation</a:t>
            </a:r>
            <a:endParaRPr lang="fr-CA" sz="4000" b="1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A515F384-D48F-4F90-9C26-F9DD97CA543F}"/>
              </a:ext>
            </a:extLst>
          </p:cNvPr>
          <p:cNvSpPr txBox="1"/>
          <p:nvPr/>
        </p:nvSpPr>
        <p:spPr>
          <a:xfrm>
            <a:off x="7759953" y="5855228"/>
            <a:ext cx="1884308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Patient</a:t>
            </a:r>
          </a:p>
        </p:txBody>
      </p: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D6777651-C6CE-4B82-8AB1-523A4A2A9F9C}"/>
              </a:ext>
            </a:extLst>
          </p:cNvPr>
          <p:cNvCxnSpPr>
            <a:cxnSpLocks/>
          </p:cNvCxnSpPr>
          <p:nvPr/>
        </p:nvCxnSpPr>
        <p:spPr>
          <a:xfrm>
            <a:off x="1132114" y="304452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590C5340-EAB8-4EB9-82BD-35EF787EC191}"/>
              </a:ext>
            </a:extLst>
          </p:cNvPr>
          <p:cNvCxnSpPr>
            <a:cxnSpLocks/>
          </p:cNvCxnSpPr>
          <p:nvPr/>
        </p:nvCxnSpPr>
        <p:spPr>
          <a:xfrm>
            <a:off x="4579256" y="3051784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C462A1E2-6BF1-402C-AE1C-A56A3927E354}"/>
              </a:ext>
            </a:extLst>
          </p:cNvPr>
          <p:cNvCxnSpPr>
            <a:cxnSpLocks/>
          </p:cNvCxnSpPr>
          <p:nvPr/>
        </p:nvCxnSpPr>
        <p:spPr>
          <a:xfrm>
            <a:off x="8098968" y="304452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4D0B916F-54CF-4CC0-A9A1-B0254D0E772F}"/>
              </a:ext>
            </a:extLst>
          </p:cNvPr>
          <p:cNvCxnSpPr>
            <a:cxnSpLocks/>
          </p:cNvCxnSpPr>
          <p:nvPr/>
        </p:nvCxnSpPr>
        <p:spPr>
          <a:xfrm rot="5400000">
            <a:off x="1182907" y="445966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A5649F82-EEB3-4029-B6FE-D2BDA600961A}"/>
              </a:ext>
            </a:extLst>
          </p:cNvPr>
          <p:cNvCxnSpPr>
            <a:cxnSpLocks/>
          </p:cNvCxnSpPr>
          <p:nvPr/>
        </p:nvCxnSpPr>
        <p:spPr>
          <a:xfrm rot="5400000">
            <a:off x="4615535" y="4437896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BD1F059D-D85B-4C4D-8A55-01A5E436E981}"/>
              </a:ext>
            </a:extLst>
          </p:cNvPr>
          <p:cNvCxnSpPr>
            <a:cxnSpLocks/>
          </p:cNvCxnSpPr>
          <p:nvPr/>
        </p:nvCxnSpPr>
        <p:spPr>
          <a:xfrm rot="5400000">
            <a:off x="8135247" y="445966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9B54346C-D0D5-4528-B178-740070D49B11}"/>
              </a:ext>
            </a:extLst>
          </p:cNvPr>
          <p:cNvCxnSpPr/>
          <p:nvPr/>
        </p:nvCxnSpPr>
        <p:spPr>
          <a:xfrm>
            <a:off x="2554514" y="4398734"/>
            <a:ext cx="7112000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909F9232-588F-4F6E-BB77-5D4478FF175F}"/>
              </a:ext>
            </a:extLst>
          </p:cNvPr>
          <p:cNvSpPr txBox="1"/>
          <p:nvPr/>
        </p:nvSpPr>
        <p:spPr>
          <a:xfrm>
            <a:off x="8890555" y="4025453"/>
            <a:ext cx="3055256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 err="1"/>
              <a:t>Hypoxemia</a:t>
            </a:r>
            <a:endParaRPr lang="fr-CA" sz="4000" b="1" dirty="0"/>
          </a:p>
        </p:txBody>
      </p:sp>
      <p:sp>
        <p:nvSpPr>
          <p:cNvPr id="26" name="Phylactère : pensées 25">
            <a:extLst>
              <a:ext uri="{FF2B5EF4-FFF2-40B4-BE49-F238E27FC236}">
                <a16:creationId xmlns:a16="http://schemas.microsoft.com/office/drawing/2014/main" id="{AF7E5F2C-8520-4696-B843-622D27BABD2A}"/>
              </a:ext>
            </a:extLst>
          </p:cNvPr>
          <p:cNvSpPr/>
          <p:nvPr/>
        </p:nvSpPr>
        <p:spPr>
          <a:xfrm>
            <a:off x="580571" y="3248281"/>
            <a:ext cx="4256843" cy="2344488"/>
          </a:xfrm>
          <a:prstGeom prst="cloudCallout">
            <a:avLst>
              <a:gd name="adj1" fmla="val -21387"/>
              <a:gd name="adj2" fmla="val 6896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EF2430F3-BD58-465C-AA66-3D92D0E4A0B8}"/>
              </a:ext>
            </a:extLst>
          </p:cNvPr>
          <p:cNvSpPr txBox="1"/>
          <p:nvPr/>
        </p:nvSpPr>
        <p:spPr>
          <a:xfrm>
            <a:off x="1071631" y="4025453"/>
            <a:ext cx="367748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 err="1"/>
              <a:t>Difficult</a:t>
            </a:r>
            <a:r>
              <a:rPr lang="fr-CA" sz="2000" dirty="0"/>
              <a:t> to </a:t>
            </a:r>
            <a:r>
              <a:rPr lang="fr-CA" sz="2000" dirty="0" err="1"/>
              <a:t>assist</a:t>
            </a:r>
            <a:r>
              <a:rPr lang="fr-CA" sz="2000" dirty="0"/>
              <a:t> ventilation </a:t>
            </a:r>
            <a:r>
              <a:rPr lang="fr-CA" sz="2000" dirty="0" err="1"/>
              <a:t>during</a:t>
            </a:r>
            <a:r>
              <a:rPr lang="fr-CA" sz="2000" dirty="0"/>
              <a:t> </a:t>
            </a:r>
            <a:r>
              <a:rPr lang="fr-CA" sz="2000" dirty="0" err="1"/>
              <a:t>transfer</a:t>
            </a:r>
            <a:endParaRPr lang="fr-CA" sz="2000" dirty="0"/>
          </a:p>
        </p:txBody>
      </p:sp>
      <p:sp>
        <p:nvSpPr>
          <p:cNvPr id="28" name="Phylactère : pensées 27">
            <a:extLst>
              <a:ext uri="{FF2B5EF4-FFF2-40B4-BE49-F238E27FC236}">
                <a16:creationId xmlns:a16="http://schemas.microsoft.com/office/drawing/2014/main" id="{7E674B15-6E83-41C4-A9AB-A27104CF2D2E}"/>
              </a:ext>
            </a:extLst>
          </p:cNvPr>
          <p:cNvSpPr/>
          <p:nvPr/>
        </p:nvSpPr>
        <p:spPr>
          <a:xfrm>
            <a:off x="4579256" y="3150657"/>
            <a:ext cx="3947884" cy="2061028"/>
          </a:xfrm>
          <a:prstGeom prst="cloudCallout">
            <a:avLst>
              <a:gd name="adj1" fmla="val -24238"/>
              <a:gd name="adj2" fmla="val 88079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8E617F71-DF0F-4DB7-B4BD-2F21F376AD81}"/>
              </a:ext>
            </a:extLst>
          </p:cNvPr>
          <p:cNvSpPr txBox="1"/>
          <p:nvPr/>
        </p:nvSpPr>
        <p:spPr>
          <a:xfrm>
            <a:off x="4979337" y="3697013"/>
            <a:ext cx="323556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 err="1"/>
              <a:t>Anaesthetist</a:t>
            </a:r>
            <a:r>
              <a:rPr lang="fr-CA" sz="2000" dirty="0"/>
              <a:t> </a:t>
            </a:r>
            <a:r>
              <a:rPr lang="fr-CA" sz="2000" dirty="0" err="1"/>
              <a:t>shortage</a:t>
            </a:r>
            <a:r>
              <a:rPr lang="fr-CA" sz="2000" dirty="0"/>
              <a:t> - email </a:t>
            </a:r>
            <a:r>
              <a:rPr lang="fr-CA" sz="2000" dirty="0" err="1"/>
              <a:t>announcing</a:t>
            </a:r>
            <a:r>
              <a:rPr lang="fr-CA" sz="2000" dirty="0"/>
              <a:t> </a:t>
            </a:r>
            <a:r>
              <a:rPr lang="fr-CA" sz="2000" dirty="0" err="1"/>
              <a:t>planned</a:t>
            </a:r>
            <a:r>
              <a:rPr lang="fr-CA" sz="2000" dirty="0"/>
              <a:t> absence</a:t>
            </a:r>
          </a:p>
          <a:p>
            <a:r>
              <a:rPr lang="fr-CA" sz="2000" dirty="0" err="1"/>
              <a:t>Possibility</a:t>
            </a:r>
            <a:r>
              <a:rPr lang="fr-CA" sz="2000" dirty="0"/>
              <a:t> of </a:t>
            </a:r>
            <a:r>
              <a:rPr lang="fr-CA" sz="2000" dirty="0" err="1"/>
              <a:t>abandoning</a:t>
            </a:r>
            <a:r>
              <a:rPr lang="fr-CA" sz="2000" dirty="0"/>
              <a:t> </a:t>
            </a:r>
            <a:r>
              <a:rPr lang="fr-CA" sz="2000" dirty="0" err="1"/>
              <a:t>procedure</a:t>
            </a:r>
            <a:r>
              <a:rPr lang="fr-CA" sz="2000" dirty="0"/>
              <a:t>? </a:t>
            </a:r>
          </a:p>
        </p:txBody>
      </p:sp>
      <p:sp>
        <p:nvSpPr>
          <p:cNvPr id="32" name="Phylactère : pensées 31">
            <a:extLst>
              <a:ext uri="{FF2B5EF4-FFF2-40B4-BE49-F238E27FC236}">
                <a16:creationId xmlns:a16="http://schemas.microsoft.com/office/drawing/2014/main" id="{97CE010E-6C1A-4857-AB5F-A8F1F9EAB0AE}"/>
              </a:ext>
            </a:extLst>
          </p:cNvPr>
          <p:cNvSpPr/>
          <p:nvPr/>
        </p:nvSpPr>
        <p:spPr>
          <a:xfrm>
            <a:off x="7802346" y="3170235"/>
            <a:ext cx="3947884" cy="2061028"/>
          </a:xfrm>
          <a:prstGeom prst="cloudCallout">
            <a:avLst>
              <a:gd name="adj1" fmla="val -24238"/>
              <a:gd name="adj2" fmla="val 88079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6B6473CF-99DD-4875-87E8-E53F705B1940}"/>
              </a:ext>
            </a:extLst>
          </p:cNvPr>
          <p:cNvSpPr txBox="1"/>
          <p:nvPr/>
        </p:nvSpPr>
        <p:spPr>
          <a:xfrm>
            <a:off x="8345039" y="3945559"/>
            <a:ext cx="323556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 err="1"/>
              <a:t>Species</a:t>
            </a:r>
            <a:r>
              <a:rPr lang="fr-CA" sz="2000" dirty="0"/>
              <a:t> </a:t>
            </a:r>
            <a:r>
              <a:rPr lang="fr-CA" sz="2000" dirty="0" err="1"/>
              <a:t>predisposition</a:t>
            </a:r>
            <a:r>
              <a:rPr lang="fr-CA" sz="2000" dirty="0"/>
              <a:t> to </a:t>
            </a:r>
            <a:r>
              <a:rPr lang="fr-CA" sz="2000" dirty="0" err="1"/>
              <a:t>hypoxemia</a:t>
            </a:r>
            <a:endParaRPr lang="fr-CA" sz="2000" dirty="0"/>
          </a:p>
        </p:txBody>
      </p:sp>
      <p:sp>
        <p:nvSpPr>
          <p:cNvPr id="35" name="Titre 1">
            <a:extLst>
              <a:ext uri="{FF2B5EF4-FFF2-40B4-BE49-F238E27FC236}">
                <a16:creationId xmlns:a16="http://schemas.microsoft.com/office/drawing/2014/main" id="{12FC697E-9531-498F-B097-34A03C242D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8929" y="521384"/>
            <a:ext cx="10107561" cy="1405738"/>
          </a:xfrm>
        </p:spPr>
        <p:txBody>
          <a:bodyPr/>
          <a:lstStyle/>
          <a:p>
            <a:r>
              <a:rPr lang="fr-CA" sz="5400" dirty="0" err="1">
                <a:solidFill>
                  <a:schemeClr val="bg1"/>
                </a:solidFill>
              </a:rPr>
              <a:t>Assessment</a:t>
            </a:r>
            <a:r>
              <a:rPr lang="fr-CA" sz="5400" dirty="0">
                <a:solidFill>
                  <a:schemeClr val="bg1"/>
                </a:solidFill>
              </a:rPr>
              <a:t> &amp; </a:t>
            </a:r>
            <a:r>
              <a:rPr lang="fr-CA" sz="5400" dirty="0" err="1">
                <a:solidFill>
                  <a:schemeClr val="bg1"/>
                </a:solidFill>
              </a:rPr>
              <a:t>analysis</a:t>
            </a:r>
            <a:r>
              <a:rPr lang="fr-CA" sz="5400" dirty="0">
                <a:solidFill>
                  <a:schemeClr val="bg1"/>
                </a:solidFill>
              </a:rPr>
              <a:t> </a:t>
            </a:r>
            <a:r>
              <a:rPr lang="fr-CA" dirty="0"/>
              <a:t>(SB</a:t>
            </a:r>
            <a:r>
              <a:rPr lang="fr-CA" b="1" dirty="0"/>
              <a:t>A</a:t>
            </a:r>
            <a:r>
              <a:rPr lang="fr-CA" dirty="0"/>
              <a:t>R) </a:t>
            </a:r>
            <a:br>
              <a:rPr lang="fr-CA" dirty="0"/>
            </a:br>
            <a:r>
              <a:rPr lang="fr-CA" dirty="0"/>
              <a:t>- </a:t>
            </a:r>
            <a:r>
              <a:rPr lang="fr-CA" sz="5400" dirty="0" err="1"/>
              <a:t>Recovery</a:t>
            </a:r>
            <a:r>
              <a:rPr lang="fr-CA" sz="5400" dirty="0"/>
              <a:t> box</a:t>
            </a:r>
          </a:p>
        </p:txBody>
      </p:sp>
      <p:sp>
        <p:nvSpPr>
          <p:cNvPr id="20" name="Phylactère : pensées 19">
            <a:extLst>
              <a:ext uri="{FF2B5EF4-FFF2-40B4-BE49-F238E27FC236}">
                <a16:creationId xmlns:a16="http://schemas.microsoft.com/office/drawing/2014/main" id="{790C552E-7DC8-4274-9821-DF8D6ADC277E}"/>
              </a:ext>
            </a:extLst>
          </p:cNvPr>
          <p:cNvSpPr/>
          <p:nvPr/>
        </p:nvSpPr>
        <p:spPr>
          <a:xfrm>
            <a:off x="-1" y="100688"/>
            <a:ext cx="5639459" cy="2145401"/>
          </a:xfrm>
          <a:prstGeom prst="cloudCallout">
            <a:avLst>
              <a:gd name="adj1" fmla="val -21092"/>
              <a:gd name="adj2" fmla="val 68133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D59C6C34-3630-4BF4-9057-A11075A64FB4}"/>
              </a:ext>
            </a:extLst>
          </p:cNvPr>
          <p:cNvSpPr txBox="1"/>
          <p:nvPr/>
        </p:nvSpPr>
        <p:spPr>
          <a:xfrm>
            <a:off x="516280" y="589035"/>
            <a:ext cx="495560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 err="1"/>
              <a:t>Anaesth</a:t>
            </a:r>
            <a:r>
              <a:rPr lang="fr-CA" sz="2000" dirty="0"/>
              <a:t> team communication </a:t>
            </a:r>
            <a:r>
              <a:rPr lang="mr-IN" sz="2000" dirty="0"/>
              <a:t>–</a:t>
            </a:r>
            <a:r>
              <a:rPr lang="fr-CA" sz="2000" dirty="0"/>
              <a:t> </a:t>
            </a:r>
            <a:r>
              <a:rPr lang="fr-CA" sz="2000" dirty="0" err="1"/>
              <a:t>individual</a:t>
            </a:r>
            <a:r>
              <a:rPr lang="fr-CA" sz="2000" dirty="0"/>
              <a:t> actions &amp; </a:t>
            </a:r>
            <a:r>
              <a:rPr lang="fr-CA" sz="2000" dirty="0" err="1"/>
              <a:t>responsibilities</a:t>
            </a:r>
            <a:endParaRPr lang="fr-CA" sz="2000" dirty="0"/>
          </a:p>
          <a:p>
            <a:r>
              <a:rPr lang="fr-CA" sz="2000" dirty="0"/>
              <a:t>Communication </a:t>
            </a:r>
            <a:r>
              <a:rPr lang="fr-CA" sz="2000" dirty="0" err="1"/>
              <a:t>between</a:t>
            </a:r>
            <a:r>
              <a:rPr lang="fr-CA" sz="2000" dirty="0"/>
              <a:t> services</a:t>
            </a:r>
          </a:p>
          <a:p>
            <a:r>
              <a:rPr lang="mr-IN" sz="2000" dirty="0"/>
              <a:t>–</a:t>
            </a:r>
            <a:r>
              <a:rPr lang="en-CA" sz="2000" dirty="0"/>
              <a:t> leader for transfer</a:t>
            </a:r>
            <a:endParaRPr lang="fr-CA" sz="2000" dirty="0"/>
          </a:p>
        </p:txBody>
      </p:sp>
      <p:sp>
        <p:nvSpPr>
          <p:cNvPr id="30" name="Phylactère : pensées 29">
            <a:extLst>
              <a:ext uri="{FF2B5EF4-FFF2-40B4-BE49-F238E27FC236}">
                <a16:creationId xmlns:a16="http://schemas.microsoft.com/office/drawing/2014/main" id="{2C626C24-B881-4F12-832E-A782848F8BB0}"/>
              </a:ext>
            </a:extLst>
          </p:cNvPr>
          <p:cNvSpPr/>
          <p:nvPr/>
        </p:nvSpPr>
        <p:spPr>
          <a:xfrm>
            <a:off x="3788678" y="117843"/>
            <a:ext cx="3947884" cy="2061028"/>
          </a:xfrm>
          <a:prstGeom prst="cloudCallout">
            <a:avLst>
              <a:gd name="adj1" fmla="val -22895"/>
              <a:gd name="adj2" fmla="val 68146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8036C28A-EF14-460A-B343-7D3A539F0875}"/>
              </a:ext>
            </a:extLst>
          </p:cNvPr>
          <p:cNvSpPr txBox="1"/>
          <p:nvPr/>
        </p:nvSpPr>
        <p:spPr>
          <a:xfrm>
            <a:off x="4358117" y="568597"/>
            <a:ext cx="323556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 err="1"/>
              <a:t>Low</a:t>
            </a:r>
            <a:r>
              <a:rPr lang="fr-CA" sz="2000" dirty="0"/>
              <a:t> PaO</a:t>
            </a:r>
            <a:r>
              <a:rPr lang="fr-CA" sz="2000" baseline="-25000" dirty="0"/>
              <a:t>2</a:t>
            </a:r>
            <a:r>
              <a:rPr lang="fr-CA" sz="2000" dirty="0"/>
              <a:t> </a:t>
            </a:r>
            <a:r>
              <a:rPr lang="fr-CA" sz="2000" dirty="0" err="1"/>
              <a:t>during</a:t>
            </a:r>
            <a:r>
              <a:rPr lang="fr-CA" sz="2000" dirty="0"/>
              <a:t> MRI</a:t>
            </a:r>
          </a:p>
          <a:p>
            <a:r>
              <a:rPr lang="fr-CA" sz="2000" dirty="0"/>
              <a:t>Change of body position</a:t>
            </a:r>
          </a:p>
        </p:txBody>
      </p:sp>
      <p:sp>
        <p:nvSpPr>
          <p:cNvPr id="24" name="Phylactère : pensées 23">
            <a:extLst>
              <a:ext uri="{FF2B5EF4-FFF2-40B4-BE49-F238E27FC236}">
                <a16:creationId xmlns:a16="http://schemas.microsoft.com/office/drawing/2014/main" id="{C254256E-2E69-4E94-8499-8B7E24F31246}"/>
              </a:ext>
            </a:extLst>
          </p:cNvPr>
          <p:cNvSpPr/>
          <p:nvPr/>
        </p:nvSpPr>
        <p:spPr>
          <a:xfrm>
            <a:off x="7186401" y="74461"/>
            <a:ext cx="4276907" cy="2061028"/>
          </a:xfrm>
          <a:prstGeom prst="cloudCallout">
            <a:avLst>
              <a:gd name="adj1" fmla="val -21387"/>
              <a:gd name="adj2" fmla="val 6896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4" name="ZoneTexte 30">
            <a:extLst>
              <a:ext uri="{FF2B5EF4-FFF2-40B4-BE49-F238E27FC236}">
                <a16:creationId xmlns:a16="http://schemas.microsoft.com/office/drawing/2014/main" id="{8036C28A-EF14-460A-B343-7D3A539F0875}"/>
              </a:ext>
            </a:extLst>
          </p:cNvPr>
          <p:cNvSpPr txBox="1"/>
          <p:nvPr/>
        </p:nvSpPr>
        <p:spPr>
          <a:xfrm>
            <a:off x="7913023" y="538326"/>
            <a:ext cx="323556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/>
              <a:t>ET tube </a:t>
            </a:r>
            <a:r>
              <a:rPr lang="fr-CA" sz="2000" dirty="0" err="1"/>
              <a:t>cuff</a:t>
            </a:r>
            <a:r>
              <a:rPr lang="fr-CA" sz="2000" dirty="0"/>
              <a:t> </a:t>
            </a:r>
            <a:r>
              <a:rPr lang="fr-CA" sz="2000" dirty="0" err="1"/>
              <a:t>deflated</a:t>
            </a:r>
            <a:r>
              <a:rPr lang="fr-CA" sz="2000" dirty="0"/>
              <a:t> </a:t>
            </a:r>
            <a:r>
              <a:rPr lang="fr-CA" sz="2000" dirty="0" err="1"/>
              <a:t>during</a:t>
            </a:r>
            <a:r>
              <a:rPr lang="fr-CA" sz="2000" dirty="0"/>
              <a:t> </a:t>
            </a:r>
            <a:r>
              <a:rPr lang="fr-CA" sz="2000" dirty="0" err="1"/>
              <a:t>transfer</a:t>
            </a:r>
            <a:r>
              <a:rPr lang="fr-CA" sz="2000" dirty="0"/>
              <a:t>, </a:t>
            </a:r>
            <a:r>
              <a:rPr lang="fr-CA" sz="2000" dirty="0" err="1"/>
              <a:t>limiting</a:t>
            </a:r>
            <a:r>
              <a:rPr lang="fr-CA" sz="2000" dirty="0"/>
              <a:t> ventilation</a:t>
            </a:r>
          </a:p>
        </p:txBody>
      </p:sp>
    </p:spTree>
    <p:extLst>
      <p:ext uri="{BB962C8B-B14F-4D97-AF65-F5344CB8AC3E}">
        <p14:creationId xmlns:p14="http://schemas.microsoft.com/office/powerpoint/2010/main" val="20346709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" dur="10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10" dur="10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4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7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23" dur="10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4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26" dur="10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0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2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3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39" dur="10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0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42" dur="10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6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8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9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55" dur="10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6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58" dur="10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9" fill="hold">
                      <p:stCondLst>
                        <p:cond delay="indefinite"/>
                      </p:stCondLst>
                      <p:childTnLst>
                        <p:par>
                          <p:cTn id="60" fill="hold">
                            <p:stCondLst>
                              <p:cond delay="0"/>
                            </p:stCondLst>
                            <p:childTnLst>
                              <p:par>
                                <p:cTn id="61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2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4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5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7" fill="hold">
                      <p:stCondLst>
                        <p:cond delay="indefinite"/>
                      </p:stCondLst>
                      <p:childTnLst>
                        <p:par>
                          <p:cTn id="68" fill="hold">
                            <p:stCondLst>
                              <p:cond delay="0"/>
                            </p:stCondLst>
                            <p:childTnLst>
                              <p:par>
                                <p:cTn id="69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1" dur="10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2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4" dur="10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5" fill="hold">
                      <p:stCondLst>
                        <p:cond delay="indefinite"/>
                      </p:stCondLst>
                      <p:childTnLst>
                        <p:par>
                          <p:cTn id="76" fill="hold">
                            <p:stCondLst>
                              <p:cond delay="0"/>
                            </p:stCondLst>
                            <p:childTnLst>
                              <p:par>
                                <p:cTn id="77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78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0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81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3" fill="hold">
                      <p:stCondLst>
                        <p:cond delay="indefinite"/>
                      </p:stCondLst>
                      <p:childTnLst>
                        <p:par>
                          <p:cTn id="84" fill="hold">
                            <p:stCondLst>
                              <p:cond delay="0"/>
                            </p:stCondLst>
                            <p:childTnLst>
                              <p:par>
                                <p:cTn id="85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87" dur="10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8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90" dur="10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1" fill="hold">
                      <p:stCondLst>
                        <p:cond delay="indefinite"/>
                      </p:stCondLst>
                      <p:childTnLst>
                        <p:par>
                          <p:cTn id="92" fill="hold">
                            <p:stCondLst>
                              <p:cond delay="0"/>
                            </p:stCondLst>
                            <p:childTnLst>
                              <p:par>
                                <p:cTn id="93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4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6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7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6" grpId="1" animBg="1"/>
      <p:bldP spid="27" grpId="0"/>
      <p:bldP spid="27" grpId="1"/>
      <p:bldP spid="28" grpId="0" animBg="1"/>
      <p:bldP spid="28" grpId="1" animBg="1"/>
      <p:bldP spid="29" grpId="0"/>
      <p:bldP spid="29" grpId="1"/>
      <p:bldP spid="32" grpId="0" animBg="1"/>
      <p:bldP spid="32" grpId="1" animBg="1"/>
      <p:bldP spid="33" grpId="0"/>
      <p:bldP spid="33" grpId="1"/>
      <p:bldP spid="20" grpId="0" animBg="1"/>
      <p:bldP spid="20" grpId="1" animBg="1"/>
      <p:bldP spid="21" grpId="0"/>
      <p:bldP spid="21" grpId="1"/>
      <p:bldP spid="30" grpId="0" animBg="1"/>
      <p:bldP spid="30" grpId="1" animBg="1"/>
      <p:bldP spid="31" grpId="0"/>
      <p:bldP spid="31" grpId="1"/>
      <p:bldP spid="24" grpId="0" animBg="1"/>
      <p:bldP spid="24" grpId="1" animBg="1"/>
      <p:bldP spid="34" grpId="0"/>
      <p:bldP spid="34" grpId="1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reatment with </a:t>
            </a:r>
            <a:r>
              <a:rPr lang="en-US" dirty="0" err="1"/>
              <a:t>aerosolised</a:t>
            </a:r>
            <a:r>
              <a:rPr lang="en-US" dirty="0"/>
              <a:t> salbutamol increased PaO</a:t>
            </a:r>
            <a:r>
              <a:rPr lang="en-US" baseline="-25000" dirty="0"/>
              <a:t>2</a:t>
            </a:r>
            <a:r>
              <a:rPr lang="en-US" dirty="0"/>
              <a:t> from 62.4 ± 13.1 mmHg (mean ± SD) to 119.4 ± 57.7 mmHg</a:t>
            </a:r>
          </a:p>
          <a:p>
            <a:pPr lvl="1"/>
            <a:r>
              <a:rPr lang="en-US" dirty="0"/>
              <a:t>Horses received a variety of anesthetic drugs and ventilation strategies</a:t>
            </a:r>
          </a:p>
          <a:p>
            <a:pPr lvl="1"/>
            <a:r>
              <a:rPr lang="en-US" dirty="0"/>
              <a:t>Majority of horses in dorsal recumbency (74/ 81), majority for emergency ex lap (57/81)</a:t>
            </a:r>
          </a:p>
          <a:p>
            <a:pPr lvl="1"/>
            <a:r>
              <a:rPr lang="en-US" dirty="0"/>
              <a:t>Salbutamol @ 2 mcg/kg via chamber inserted between ET tube connector and circle system y-piece </a:t>
            </a:r>
            <a:r>
              <a:rPr lang="mr-IN" dirty="0"/>
              <a:t>–</a:t>
            </a:r>
            <a:r>
              <a:rPr lang="en-US" dirty="0"/>
              <a:t> administered if PaO</a:t>
            </a:r>
            <a:r>
              <a:rPr lang="en-US" baseline="-25000" dirty="0"/>
              <a:t>2</a:t>
            </a:r>
            <a:r>
              <a:rPr lang="en-US" dirty="0"/>
              <a:t> remained &lt; 70 mmHg despite mechanical ventilation and positive inotropes</a:t>
            </a:r>
          </a:p>
          <a:p>
            <a:pPr lvl="1"/>
            <a:r>
              <a:rPr lang="en-US" dirty="0"/>
              <a:t>ABG measured 20 minutes after salbutamol</a:t>
            </a:r>
          </a:p>
        </p:txBody>
      </p:sp>
      <p:sp>
        <p:nvSpPr>
          <p:cNvPr id="4" name="Titre 1">
            <a:extLst>
              <a:ext uri="{FF2B5EF4-FFF2-40B4-BE49-F238E27FC236}">
                <a16:creationId xmlns:a16="http://schemas.microsoft.com/office/drawing/2014/main" id="{D1837D34-1DE9-4B46-A9AF-1D2965A55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0930" y="791579"/>
            <a:ext cx="8761413" cy="706964"/>
          </a:xfrm>
        </p:spPr>
        <p:txBody>
          <a:bodyPr/>
          <a:lstStyle/>
          <a:p>
            <a:r>
              <a:rPr lang="fr-CA" sz="5400" dirty="0" err="1"/>
              <a:t>Review</a:t>
            </a:r>
            <a:r>
              <a:rPr lang="fr-CA" sz="5400" dirty="0"/>
              <a:t> of the </a:t>
            </a:r>
            <a:r>
              <a:rPr lang="fr-CA" sz="5400" dirty="0" err="1"/>
              <a:t>Literature</a:t>
            </a:r>
            <a:r>
              <a:rPr lang="fr-CA" sz="5400" dirty="0"/>
              <a:t> </a:t>
            </a:r>
            <a:r>
              <a:rPr lang="fr-CA" dirty="0"/>
              <a:t>(SBA</a:t>
            </a:r>
            <a:r>
              <a:rPr lang="fr-CA" b="1" dirty="0"/>
              <a:t>R</a:t>
            </a:r>
            <a:r>
              <a:rPr lang="fr-CA" dirty="0"/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757225" y="6322142"/>
            <a:ext cx="6434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bertson &amp; Bailey Vet </a:t>
            </a:r>
            <a:r>
              <a:rPr lang="en-US" dirty="0" err="1"/>
              <a:t>Anaesth</a:t>
            </a:r>
            <a:r>
              <a:rPr lang="en-US" dirty="0"/>
              <a:t> </a:t>
            </a:r>
            <a:r>
              <a:rPr lang="en-US" dirty="0" err="1"/>
              <a:t>Analg</a:t>
            </a:r>
            <a:r>
              <a:rPr lang="en-US" dirty="0"/>
              <a:t> (2002) 29:212-218</a:t>
            </a:r>
          </a:p>
        </p:txBody>
      </p:sp>
    </p:spTree>
    <p:extLst>
      <p:ext uri="{BB962C8B-B14F-4D97-AF65-F5344CB8AC3E}">
        <p14:creationId xmlns:p14="http://schemas.microsoft.com/office/powerpoint/2010/main" val="205447851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E8865D-89B7-47D9-ABA5-E39776A68A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1735" y="861127"/>
            <a:ext cx="8761413" cy="706964"/>
          </a:xfrm>
        </p:spPr>
        <p:txBody>
          <a:bodyPr/>
          <a:lstStyle/>
          <a:p>
            <a:r>
              <a:rPr lang="fr-CA" sz="4400" dirty="0" err="1"/>
              <a:t>Considerations</a:t>
            </a:r>
            <a:r>
              <a:rPr lang="fr-CA" sz="4400" dirty="0"/>
              <a:t> for </a:t>
            </a:r>
            <a:r>
              <a:rPr lang="fr-CA" sz="4400" dirty="0" err="1"/>
              <a:t>managing</a:t>
            </a:r>
            <a:r>
              <a:rPr lang="fr-CA" sz="4400" dirty="0"/>
              <a:t> </a:t>
            </a:r>
            <a:r>
              <a:rPr lang="fr-CA" sz="4400" dirty="0" err="1"/>
              <a:t>hypoxemia</a:t>
            </a:r>
            <a:endParaRPr lang="fr-CA" sz="4400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1D8E9DA-AB2B-45B0-89CE-E1C909B44E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90842" y="2194560"/>
            <a:ext cx="10480431" cy="4501661"/>
          </a:xfrm>
        </p:spPr>
        <p:txBody>
          <a:bodyPr>
            <a:normAutofit lnSpcReduction="10000"/>
          </a:bodyPr>
          <a:lstStyle/>
          <a:p>
            <a:r>
              <a:rPr lang="fr-CA" sz="2400" b="1" dirty="0"/>
              <a:t>FiO2 </a:t>
            </a:r>
          </a:p>
          <a:p>
            <a:r>
              <a:rPr lang="fr-CA" sz="2400" b="1" dirty="0"/>
              <a:t>Positive pressure ventilation</a:t>
            </a:r>
          </a:p>
          <a:p>
            <a:pPr lvl="1"/>
            <a:r>
              <a:rPr lang="fr-CA" sz="2200" dirty="0"/>
              <a:t>Vt: 10-20 </a:t>
            </a:r>
            <a:r>
              <a:rPr lang="fr-CA" sz="2200" dirty="0" err="1"/>
              <a:t>mL</a:t>
            </a:r>
            <a:r>
              <a:rPr lang="fr-CA" sz="2200" dirty="0"/>
              <a:t>/kg, pression: 20-30 cmH</a:t>
            </a:r>
            <a:r>
              <a:rPr lang="fr-CA" sz="2200" baseline="-25000" dirty="0"/>
              <a:t>2</a:t>
            </a:r>
            <a:r>
              <a:rPr lang="fr-CA" sz="2200" dirty="0"/>
              <a:t>0</a:t>
            </a:r>
          </a:p>
          <a:p>
            <a:r>
              <a:rPr lang="fr-CA" sz="2400" b="1" dirty="0"/>
              <a:t>Salbutamol</a:t>
            </a:r>
            <a:endParaRPr lang="fr-CA" sz="2400" dirty="0"/>
          </a:p>
          <a:p>
            <a:pPr lvl="1"/>
            <a:r>
              <a:rPr lang="fr-CA" sz="2200" dirty="0"/>
              <a:t>2 </a:t>
            </a:r>
            <a:r>
              <a:rPr lang="fr-CA" sz="2200" dirty="0" err="1"/>
              <a:t>mcg</a:t>
            </a:r>
            <a:r>
              <a:rPr lang="fr-CA" sz="2200" dirty="0"/>
              <a:t>/kg (10 actuations for a 500kg horse)</a:t>
            </a:r>
          </a:p>
          <a:p>
            <a:r>
              <a:rPr lang="fr-CA" sz="2400" b="1" dirty="0" err="1"/>
              <a:t>Recruitment</a:t>
            </a:r>
            <a:r>
              <a:rPr lang="fr-CA" sz="2400" b="1" dirty="0"/>
              <a:t> </a:t>
            </a:r>
            <a:r>
              <a:rPr lang="fr-CA" sz="2400" b="1" dirty="0" err="1"/>
              <a:t>maneuver</a:t>
            </a:r>
            <a:endParaRPr lang="fr-CA" sz="2400" b="1" dirty="0"/>
          </a:p>
          <a:p>
            <a:pPr lvl="1"/>
            <a:r>
              <a:rPr lang="fr-CA" sz="2200" dirty="0"/>
              <a:t>Wettstein et al. AJVR (2006) 67:152-159</a:t>
            </a:r>
          </a:p>
          <a:p>
            <a:r>
              <a:rPr lang="fr-CA" sz="2400" dirty="0"/>
              <a:t> </a:t>
            </a:r>
            <a:r>
              <a:rPr lang="fr-CA" sz="2400" b="1" dirty="0"/>
              <a:t>PEEP</a:t>
            </a:r>
          </a:p>
          <a:p>
            <a:pPr lvl="1"/>
            <a:r>
              <a:rPr lang="fr-CA" sz="2200" dirty="0"/>
              <a:t>10-15 cmH</a:t>
            </a:r>
            <a:r>
              <a:rPr lang="fr-CA" sz="2200" baseline="-25000" dirty="0"/>
              <a:t>2</a:t>
            </a:r>
            <a:r>
              <a:rPr lang="fr-CA" sz="2200" dirty="0"/>
              <a:t>0</a:t>
            </a:r>
          </a:p>
          <a:p>
            <a:r>
              <a:rPr lang="fr-CA" sz="2400" b="1" dirty="0"/>
              <a:t>Reverse Trendelenburg, CPAP, NO</a:t>
            </a:r>
          </a:p>
        </p:txBody>
      </p:sp>
    </p:spTree>
    <p:extLst>
      <p:ext uri="{BB962C8B-B14F-4D97-AF65-F5344CB8AC3E}">
        <p14:creationId xmlns:p14="http://schemas.microsoft.com/office/powerpoint/2010/main" val="43931288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76519" y="2564590"/>
            <a:ext cx="8761412" cy="3416300"/>
          </a:xfrm>
        </p:spPr>
        <p:txBody>
          <a:bodyPr>
            <a:normAutofit fontScale="85000" lnSpcReduction="10000"/>
          </a:bodyPr>
          <a:lstStyle/>
          <a:p>
            <a:r>
              <a:rPr lang="en-CA" sz="2400" dirty="0"/>
              <a:t>Clear communication within and between services is important</a:t>
            </a:r>
          </a:p>
          <a:p>
            <a:pPr lvl="1"/>
            <a:r>
              <a:rPr lang="en-CA" sz="2000" dirty="0"/>
              <a:t>1. A single person (usually senior anaesthetist) manages transfer</a:t>
            </a:r>
          </a:p>
          <a:p>
            <a:pPr lvl="1"/>
            <a:r>
              <a:rPr lang="en-CA" sz="2000" dirty="0"/>
              <a:t>2. Responsibility for transfer can be delegated but this should be arranged and confirmed in advance</a:t>
            </a:r>
          </a:p>
          <a:p>
            <a:pPr lvl="1"/>
            <a:r>
              <a:rPr lang="en-CA" sz="2000" dirty="0"/>
              <a:t>3. Transfer should not begin until the senior anaesthetist is present unless permission has been given</a:t>
            </a:r>
          </a:p>
          <a:p>
            <a:pPr lvl="1"/>
            <a:r>
              <a:rPr lang="en-CA" sz="2000" dirty="0"/>
              <a:t>Items 1-3 could be included in an standardised patient transfer protocol</a:t>
            </a:r>
          </a:p>
          <a:p>
            <a:pPr lvl="1"/>
            <a:r>
              <a:rPr lang="en-CA" sz="2000" dirty="0"/>
              <a:t>4. Senior anaesthetist has the right to delay or refuse elective cases in the interests of patient safety. An elective procedure may be stopped prematurely when patient safety is compromised.</a:t>
            </a:r>
            <a:endParaRPr lang="en-US" sz="2000" dirty="0"/>
          </a:p>
        </p:txBody>
      </p:sp>
      <p:sp>
        <p:nvSpPr>
          <p:cNvPr id="4" name="Titre 1">
            <a:extLst>
              <a:ext uri="{FF2B5EF4-FFF2-40B4-BE49-F238E27FC236}">
                <a16:creationId xmlns:a16="http://schemas.microsoft.com/office/drawing/2014/main" id="{D1837D34-1DE9-4B46-A9AF-1D2965A55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0930" y="791579"/>
            <a:ext cx="8761413" cy="706964"/>
          </a:xfrm>
        </p:spPr>
        <p:txBody>
          <a:bodyPr/>
          <a:lstStyle/>
          <a:p>
            <a:r>
              <a:rPr lang="fr-CA" sz="5400" dirty="0" err="1"/>
              <a:t>Recommendations</a:t>
            </a:r>
            <a:r>
              <a:rPr lang="fr-CA" sz="5400" dirty="0"/>
              <a:t> </a:t>
            </a:r>
            <a:r>
              <a:rPr lang="fr-CA" dirty="0"/>
              <a:t>(SBA</a:t>
            </a:r>
            <a:r>
              <a:rPr lang="fr-CA" b="1" dirty="0"/>
              <a:t>R</a:t>
            </a:r>
            <a:r>
              <a:rPr lang="fr-CA" dirty="0"/>
              <a:t>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757225" y="6322142"/>
            <a:ext cx="6434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bertson &amp; Bailey Vet </a:t>
            </a:r>
            <a:r>
              <a:rPr lang="en-US" dirty="0" err="1"/>
              <a:t>Anaesth</a:t>
            </a:r>
            <a:r>
              <a:rPr lang="en-US" dirty="0"/>
              <a:t> </a:t>
            </a:r>
            <a:r>
              <a:rPr lang="en-US" dirty="0" err="1"/>
              <a:t>Analg</a:t>
            </a:r>
            <a:r>
              <a:rPr lang="en-US" dirty="0"/>
              <a:t> (2002) 29:212-218</a:t>
            </a:r>
          </a:p>
        </p:txBody>
      </p:sp>
    </p:spTree>
    <p:extLst>
      <p:ext uri="{BB962C8B-B14F-4D97-AF65-F5344CB8AC3E}">
        <p14:creationId xmlns:p14="http://schemas.microsoft.com/office/powerpoint/2010/main" val="195712356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A06972-DE43-439B-824D-CD42B3B3C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 err="1"/>
              <a:t>Aim</a:t>
            </a:r>
            <a:r>
              <a:rPr lang="fr-CA" sz="5400" dirty="0"/>
              <a:t> of M&amp;M </a:t>
            </a:r>
            <a:r>
              <a:rPr lang="fr-CA" sz="5400" dirty="0" err="1"/>
              <a:t>conference</a:t>
            </a:r>
            <a:endParaRPr lang="fr-CA" sz="5400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0BF2015-857D-4130-8D82-3888D30F38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10450891" cy="4078654"/>
          </a:xfrm>
        </p:spPr>
        <p:txBody>
          <a:bodyPr>
            <a:normAutofit/>
          </a:bodyPr>
          <a:lstStyle/>
          <a:p>
            <a:pPr>
              <a:buFont typeface="+mj-lt"/>
              <a:buAutoNum type="arabicPeriod"/>
            </a:pPr>
            <a:r>
              <a:rPr lang="fr-CA" sz="3200" b="1" dirty="0" err="1"/>
              <a:t>Describe</a:t>
            </a:r>
            <a:r>
              <a:rPr lang="fr-CA" sz="3200" b="1" dirty="0"/>
              <a:t> </a:t>
            </a:r>
            <a:r>
              <a:rPr lang="fr-CA" sz="3200" dirty="0"/>
              <a:t>an adverse </a:t>
            </a:r>
            <a:r>
              <a:rPr lang="fr-CA" sz="3200" dirty="0" err="1"/>
              <a:t>event</a:t>
            </a:r>
            <a:endParaRPr lang="fr-CA" sz="3200" dirty="0"/>
          </a:p>
          <a:p>
            <a:pPr>
              <a:buFont typeface="+mj-lt"/>
              <a:buAutoNum type="arabicPeriod"/>
            </a:pPr>
            <a:r>
              <a:rPr lang="fr-CA" sz="3200" b="1" dirty="0" err="1"/>
              <a:t>Identify</a:t>
            </a:r>
            <a:r>
              <a:rPr lang="fr-CA" sz="3200" b="1" dirty="0"/>
              <a:t> </a:t>
            </a:r>
            <a:r>
              <a:rPr lang="fr-CA" sz="3200" dirty="0" err="1"/>
              <a:t>contributing</a:t>
            </a:r>
            <a:r>
              <a:rPr lang="fr-CA" sz="3200" dirty="0"/>
              <a:t> </a:t>
            </a:r>
            <a:r>
              <a:rPr lang="fr-CA" sz="3200" dirty="0" err="1"/>
              <a:t>factors</a:t>
            </a:r>
            <a:endParaRPr lang="fr-CA" sz="3200" dirty="0"/>
          </a:p>
          <a:p>
            <a:pPr>
              <a:buFont typeface="+mj-lt"/>
              <a:buAutoNum type="arabicPeriod"/>
            </a:pPr>
            <a:r>
              <a:rPr lang="fr-CA" sz="3200" b="1" dirty="0" err="1"/>
              <a:t>Learn</a:t>
            </a:r>
            <a:r>
              <a:rPr lang="fr-CA" sz="3200" b="1" dirty="0"/>
              <a:t> </a:t>
            </a:r>
            <a:r>
              <a:rPr lang="fr-CA" sz="3200" dirty="0" err="1"/>
              <a:t>from</a:t>
            </a:r>
            <a:r>
              <a:rPr lang="fr-CA" sz="3200" dirty="0"/>
              <a:t> incident &amp; </a:t>
            </a:r>
            <a:r>
              <a:rPr lang="fr-CA" sz="3200" b="1" dirty="0"/>
              <a:t>Propose </a:t>
            </a:r>
            <a:r>
              <a:rPr lang="fr-CA" sz="3200" dirty="0"/>
              <a:t>solutions</a:t>
            </a:r>
          </a:p>
          <a:p>
            <a:pPr marL="0" indent="0">
              <a:buNone/>
            </a:pPr>
            <a:endParaRPr lang="fr-CA" sz="3200" b="1" dirty="0">
              <a:solidFill>
                <a:srgbClr val="FF0000"/>
              </a:solidFill>
            </a:endParaRPr>
          </a:p>
          <a:p>
            <a:pPr marL="0" indent="0">
              <a:buNone/>
            </a:pPr>
            <a:r>
              <a:rPr lang="fr-CA" sz="3200" b="1" dirty="0">
                <a:solidFill>
                  <a:srgbClr val="FF0000"/>
                </a:solidFill>
              </a:rPr>
              <a:t>The </a:t>
            </a:r>
            <a:r>
              <a:rPr lang="fr-CA" sz="3200" b="1" dirty="0" err="1">
                <a:solidFill>
                  <a:srgbClr val="FF0000"/>
                </a:solidFill>
              </a:rPr>
              <a:t>aim</a:t>
            </a:r>
            <a:r>
              <a:rPr lang="fr-CA" sz="3200" b="1" dirty="0">
                <a:solidFill>
                  <a:srgbClr val="FF0000"/>
                </a:solidFill>
              </a:rPr>
              <a:t> </a:t>
            </a:r>
            <a:r>
              <a:rPr lang="fr-CA" sz="3200" b="1" dirty="0" err="1">
                <a:solidFill>
                  <a:srgbClr val="FF0000"/>
                </a:solidFill>
              </a:rPr>
              <a:t>is</a:t>
            </a:r>
            <a:r>
              <a:rPr lang="fr-CA" sz="3200" b="1" dirty="0">
                <a:solidFill>
                  <a:srgbClr val="FF0000"/>
                </a:solidFill>
              </a:rPr>
              <a:t> NOT to </a:t>
            </a:r>
            <a:r>
              <a:rPr lang="fr-CA" sz="3200" b="1" dirty="0" err="1">
                <a:solidFill>
                  <a:srgbClr val="FF0000"/>
                </a:solidFill>
              </a:rPr>
              <a:t>assign</a:t>
            </a:r>
            <a:r>
              <a:rPr lang="fr-CA" sz="3200" b="1" dirty="0">
                <a:solidFill>
                  <a:srgbClr val="FF0000"/>
                </a:solidFill>
              </a:rPr>
              <a:t> </a:t>
            </a:r>
            <a:r>
              <a:rPr lang="fr-CA" sz="3200" b="1" dirty="0" err="1">
                <a:solidFill>
                  <a:srgbClr val="FF0000"/>
                </a:solidFill>
              </a:rPr>
              <a:t>blame</a:t>
            </a:r>
            <a:r>
              <a:rPr lang="fr-CA" sz="3200" b="1" dirty="0">
                <a:solidFill>
                  <a:srgbClr val="FF0000"/>
                </a:solidFill>
              </a:rPr>
              <a:t> or </a:t>
            </a:r>
            <a:r>
              <a:rPr lang="fr-CA" sz="3200" b="1" dirty="0" err="1">
                <a:solidFill>
                  <a:srgbClr val="FF0000"/>
                </a:solidFill>
              </a:rPr>
              <a:t>finger</a:t>
            </a:r>
            <a:r>
              <a:rPr lang="fr-CA" sz="3200" b="1" dirty="0">
                <a:solidFill>
                  <a:srgbClr val="FF0000"/>
                </a:solidFill>
              </a:rPr>
              <a:t>-point!</a:t>
            </a:r>
          </a:p>
        </p:txBody>
      </p:sp>
    </p:spTree>
    <p:extLst>
      <p:ext uri="{BB962C8B-B14F-4D97-AF65-F5344CB8AC3E}">
        <p14:creationId xmlns:p14="http://schemas.microsoft.com/office/powerpoint/2010/main" val="2047614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A06972-DE43-439B-824D-CD42B3B3C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 err="1"/>
              <a:t>Aim</a:t>
            </a:r>
            <a:r>
              <a:rPr lang="fr-CA" sz="5400" dirty="0"/>
              <a:t> of M&amp;M </a:t>
            </a:r>
            <a:r>
              <a:rPr lang="fr-CA" sz="5400" dirty="0" err="1"/>
              <a:t>conference</a:t>
            </a:r>
            <a:endParaRPr lang="fr-CA" sz="5400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0BF2015-857D-4130-8D82-3888D30F38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10450891" cy="4078654"/>
          </a:xfrm>
        </p:spPr>
        <p:txBody>
          <a:bodyPr>
            <a:normAutofit/>
          </a:bodyPr>
          <a:lstStyle/>
          <a:p>
            <a:pPr>
              <a:buFont typeface="+mj-lt"/>
              <a:buAutoNum type="arabicPeriod"/>
            </a:pPr>
            <a:r>
              <a:rPr lang="fr-CA" sz="3200" b="1" dirty="0" err="1"/>
              <a:t>Describe</a:t>
            </a:r>
            <a:r>
              <a:rPr lang="fr-CA" sz="3200" b="1" dirty="0"/>
              <a:t> </a:t>
            </a:r>
            <a:r>
              <a:rPr lang="fr-CA" sz="3200" dirty="0"/>
              <a:t>an adverse </a:t>
            </a:r>
            <a:r>
              <a:rPr lang="fr-CA" sz="3200" dirty="0" err="1"/>
              <a:t>event</a:t>
            </a:r>
            <a:endParaRPr lang="fr-CA" sz="3200" dirty="0"/>
          </a:p>
          <a:p>
            <a:pPr>
              <a:buFont typeface="+mj-lt"/>
              <a:buAutoNum type="arabicPeriod"/>
            </a:pPr>
            <a:r>
              <a:rPr lang="fr-CA" sz="3200" b="1" dirty="0" err="1"/>
              <a:t>Identify</a:t>
            </a:r>
            <a:r>
              <a:rPr lang="fr-CA" sz="3200" b="1" dirty="0"/>
              <a:t> </a:t>
            </a:r>
            <a:r>
              <a:rPr lang="fr-CA" sz="3200" dirty="0" err="1"/>
              <a:t>contributing</a:t>
            </a:r>
            <a:r>
              <a:rPr lang="fr-CA" sz="3200" dirty="0"/>
              <a:t> </a:t>
            </a:r>
            <a:r>
              <a:rPr lang="fr-CA" sz="3200" dirty="0" err="1"/>
              <a:t>factors</a:t>
            </a:r>
            <a:endParaRPr lang="fr-CA" sz="3200" dirty="0"/>
          </a:p>
          <a:p>
            <a:pPr>
              <a:buFont typeface="+mj-lt"/>
              <a:buAutoNum type="arabicPeriod"/>
            </a:pPr>
            <a:r>
              <a:rPr lang="fr-CA" sz="3200" b="1" dirty="0" err="1"/>
              <a:t>Learn</a:t>
            </a:r>
            <a:r>
              <a:rPr lang="fr-CA" sz="3200" b="1" dirty="0"/>
              <a:t> </a:t>
            </a:r>
            <a:r>
              <a:rPr lang="fr-CA" sz="3200" dirty="0" err="1"/>
              <a:t>from</a:t>
            </a:r>
            <a:r>
              <a:rPr lang="fr-CA" sz="3200" dirty="0"/>
              <a:t> incident &amp; </a:t>
            </a:r>
            <a:r>
              <a:rPr lang="fr-CA" sz="3200" b="1" dirty="0"/>
              <a:t>Propose </a:t>
            </a:r>
            <a:r>
              <a:rPr lang="fr-CA" sz="3200" dirty="0"/>
              <a:t>solutions</a:t>
            </a:r>
          </a:p>
          <a:p>
            <a:pPr marL="0" indent="0">
              <a:buNone/>
            </a:pPr>
            <a:endParaRPr lang="fr-CA" sz="3200" b="1" dirty="0">
              <a:solidFill>
                <a:srgbClr val="FF0000"/>
              </a:solidFill>
            </a:endParaRPr>
          </a:p>
          <a:p>
            <a:pPr marL="0" indent="0">
              <a:buNone/>
            </a:pPr>
            <a:r>
              <a:rPr lang="fr-CA" sz="3200" b="1" dirty="0">
                <a:solidFill>
                  <a:srgbClr val="FF0000"/>
                </a:solidFill>
              </a:rPr>
              <a:t>The </a:t>
            </a:r>
            <a:r>
              <a:rPr lang="fr-CA" sz="3200" b="1" dirty="0" err="1">
                <a:solidFill>
                  <a:srgbClr val="FF0000"/>
                </a:solidFill>
              </a:rPr>
              <a:t>aim</a:t>
            </a:r>
            <a:r>
              <a:rPr lang="fr-CA" sz="3200" b="1" dirty="0">
                <a:solidFill>
                  <a:srgbClr val="FF0000"/>
                </a:solidFill>
              </a:rPr>
              <a:t> </a:t>
            </a:r>
            <a:r>
              <a:rPr lang="fr-CA" sz="3200" b="1" dirty="0" err="1">
                <a:solidFill>
                  <a:srgbClr val="FF0000"/>
                </a:solidFill>
              </a:rPr>
              <a:t>is</a:t>
            </a:r>
            <a:r>
              <a:rPr lang="fr-CA" sz="3200" b="1" dirty="0">
                <a:solidFill>
                  <a:srgbClr val="FF0000"/>
                </a:solidFill>
              </a:rPr>
              <a:t> NOT to </a:t>
            </a:r>
            <a:r>
              <a:rPr lang="fr-CA" sz="3200" b="1" dirty="0" err="1">
                <a:solidFill>
                  <a:srgbClr val="FF0000"/>
                </a:solidFill>
              </a:rPr>
              <a:t>assign</a:t>
            </a:r>
            <a:r>
              <a:rPr lang="fr-CA" sz="3200" b="1" dirty="0">
                <a:solidFill>
                  <a:srgbClr val="FF0000"/>
                </a:solidFill>
              </a:rPr>
              <a:t> </a:t>
            </a:r>
            <a:r>
              <a:rPr lang="fr-CA" sz="3200" b="1" dirty="0" err="1">
                <a:solidFill>
                  <a:srgbClr val="FF0000"/>
                </a:solidFill>
              </a:rPr>
              <a:t>blame</a:t>
            </a:r>
            <a:r>
              <a:rPr lang="fr-CA" sz="3200" b="1" dirty="0">
                <a:solidFill>
                  <a:srgbClr val="FF0000"/>
                </a:solidFill>
              </a:rPr>
              <a:t> or </a:t>
            </a:r>
            <a:r>
              <a:rPr lang="fr-CA" sz="3200" b="1" dirty="0" err="1">
                <a:solidFill>
                  <a:srgbClr val="FF0000"/>
                </a:solidFill>
              </a:rPr>
              <a:t>finger</a:t>
            </a:r>
            <a:r>
              <a:rPr lang="fr-CA" sz="3200" b="1" dirty="0">
                <a:solidFill>
                  <a:srgbClr val="FF0000"/>
                </a:solidFill>
              </a:rPr>
              <a:t>-point!</a:t>
            </a:r>
          </a:p>
        </p:txBody>
      </p:sp>
    </p:spTree>
    <p:extLst>
      <p:ext uri="{BB962C8B-B14F-4D97-AF65-F5344CB8AC3E}">
        <p14:creationId xmlns:p14="http://schemas.microsoft.com/office/powerpoint/2010/main" val="36820292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1">
            <a:extLst>
              <a:ext uri="{FF2B5EF4-FFF2-40B4-BE49-F238E27FC236}">
                <a16:creationId xmlns:a16="http://schemas.microsoft.com/office/drawing/2014/main" id="{7C343B43-4D86-4923-B507-CF584260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9600" b="1" dirty="0"/>
              <a:t>Questions?</a:t>
            </a:r>
          </a:p>
        </p:txBody>
      </p:sp>
    </p:spTree>
    <p:extLst>
      <p:ext uri="{BB962C8B-B14F-4D97-AF65-F5344CB8AC3E}">
        <p14:creationId xmlns:p14="http://schemas.microsoft.com/office/powerpoint/2010/main" val="99021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35A28F7-D892-4A65-9FAD-76F1FA755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SBAR </a:t>
            </a:r>
            <a:r>
              <a:rPr lang="fr-CA" sz="5400" dirty="0" err="1"/>
              <a:t>presentation</a:t>
            </a:r>
            <a:r>
              <a:rPr lang="fr-CA" sz="5400" dirty="0"/>
              <a:t> format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9401973-FD2C-440E-9667-859CAAA9F3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9438017" cy="3416300"/>
          </a:xfrm>
        </p:spPr>
        <p:txBody>
          <a:bodyPr>
            <a:normAutofit/>
          </a:bodyPr>
          <a:lstStyle/>
          <a:p>
            <a:r>
              <a:rPr lang="fr-CA" sz="3200" b="1" dirty="0"/>
              <a:t>S</a:t>
            </a:r>
            <a:r>
              <a:rPr lang="fr-CA" sz="3200" dirty="0"/>
              <a:t>ituation</a:t>
            </a:r>
          </a:p>
          <a:p>
            <a:r>
              <a:rPr lang="fr-CA" sz="3200" b="1" dirty="0"/>
              <a:t>B</a:t>
            </a:r>
            <a:r>
              <a:rPr lang="fr-CA" sz="3200" dirty="0"/>
              <a:t>ackground</a:t>
            </a:r>
          </a:p>
          <a:p>
            <a:r>
              <a:rPr lang="fr-CA" sz="3200" b="1" dirty="0" err="1"/>
              <a:t>A</a:t>
            </a:r>
            <a:r>
              <a:rPr lang="fr-CA" sz="3200" dirty="0" err="1"/>
              <a:t>ssessment</a:t>
            </a:r>
            <a:r>
              <a:rPr lang="fr-CA" sz="3200" dirty="0"/>
              <a:t> and </a:t>
            </a:r>
            <a:r>
              <a:rPr lang="fr-CA" sz="3200" b="1" dirty="0" err="1"/>
              <a:t>A</a:t>
            </a:r>
            <a:r>
              <a:rPr lang="fr-CA" sz="3200" dirty="0" err="1"/>
              <a:t>nalysis</a:t>
            </a:r>
            <a:endParaRPr lang="fr-CA" sz="3200" dirty="0"/>
          </a:p>
          <a:p>
            <a:r>
              <a:rPr lang="fr-CA" sz="3200" b="1" dirty="0" err="1"/>
              <a:t>R</a:t>
            </a:r>
            <a:r>
              <a:rPr lang="fr-CA" sz="3200" dirty="0" err="1"/>
              <a:t>eview</a:t>
            </a:r>
            <a:r>
              <a:rPr lang="fr-CA" sz="3200" dirty="0"/>
              <a:t> of </a:t>
            </a:r>
            <a:r>
              <a:rPr lang="fr-CA" sz="3200" dirty="0" err="1"/>
              <a:t>litterature</a:t>
            </a:r>
            <a:r>
              <a:rPr lang="fr-CA" sz="3200" dirty="0"/>
              <a:t> and </a:t>
            </a:r>
            <a:r>
              <a:rPr lang="fr-CA" sz="3200" b="1" dirty="0" err="1"/>
              <a:t>R</a:t>
            </a:r>
            <a:r>
              <a:rPr lang="fr-CA" sz="3200" dirty="0" err="1"/>
              <a:t>ecommendations</a:t>
            </a:r>
            <a:endParaRPr lang="fr-CA" sz="3200" dirty="0"/>
          </a:p>
          <a:p>
            <a:endParaRPr lang="fr-CA" sz="2800" dirty="0"/>
          </a:p>
        </p:txBody>
      </p:sp>
      <p:sp>
        <p:nvSpPr>
          <p:cNvPr id="4" name="TextBox 3"/>
          <p:cNvSpPr txBox="1"/>
          <p:nvPr/>
        </p:nvSpPr>
        <p:spPr>
          <a:xfrm>
            <a:off x="7098891" y="6272980"/>
            <a:ext cx="4943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chell et al. </a:t>
            </a:r>
            <a:r>
              <a:rPr lang="en-US" dirty="0" err="1"/>
              <a:t>Acad</a:t>
            </a:r>
            <a:r>
              <a:rPr lang="en-US" dirty="0"/>
              <a:t> Med (2013) 88:824-830</a:t>
            </a:r>
          </a:p>
        </p:txBody>
      </p:sp>
    </p:spTree>
    <p:extLst>
      <p:ext uri="{BB962C8B-B14F-4D97-AF65-F5344CB8AC3E}">
        <p14:creationId xmlns:p14="http://schemas.microsoft.com/office/powerpoint/2010/main" val="535617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62D34E-9D5A-4CA5-986D-BB8E64534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Situation (</a:t>
            </a:r>
            <a:r>
              <a:rPr lang="fr-CA" sz="5400" b="1" dirty="0"/>
              <a:t>S</a:t>
            </a:r>
            <a:r>
              <a:rPr lang="fr-CA" sz="5400" dirty="0"/>
              <a:t>BAR)</a:t>
            </a:r>
            <a:endParaRPr lang="fr-CA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506BD8D-30EB-489A-8BCA-131FF5EF6B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fr-CA" sz="3200" dirty="0"/>
              <a:t>Horse </a:t>
            </a:r>
            <a:r>
              <a:rPr lang="fr-CA" sz="3200" dirty="0" err="1"/>
              <a:t>admitted</a:t>
            </a:r>
            <a:r>
              <a:rPr lang="fr-CA" sz="3200" dirty="0"/>
              <a:t> for </a:t>
            </a:r>
            <a:r>
              <a:rPr lang="fr-CA" sz="3200" dirty="0" err="1"/>
              <a:t>bilateral</a:t>
            </a:r>
            <a:r>
              <a:rPr lang="fr-CA" sz="3200" dirty="0"/>
              <a:t> </a:t>
            </a:r>
            <a:r>
              <a:rPr lang="fr-CA" sz="3200" dirty="0" err="1"/>
              <a:t>thoracic</a:t>
            </a:r>
            <a:r>
              <a:rPr lang="fr-CA" sz="3200" dirty="0"/>
              <a:t> </a:t>
            </a:r>
            <a:r>
              <a:rPr lang="fr-CA" sz="3200" dirty="0" err="1"/>
              <a:t>limb</a:t>
            </a:r>
            <a:r>
              <a:rPr lang="fr-CA" sz="3200" dirty="0"/>
              <a:t> </a:t>
            </a:r>
            <a:r>
              <a:rPr lang="fr-CA" sz="3200" dirty="0" err="1"/>
              <a:t>lameness</a:t>
            </a:r>
            <a:r>
              <a:rPr lang="fr-CA" sz="3200" dirty="0"/>
              <a:t> </a:t>
            </a:r>
            <a:r>
              <a:rPr lang="fr-CA" sz="3200" dirty="0" err="1"/>
              <a:t>evaluation</a:t>
            </a:r>
            <a:endParaRPr lang="fr-CA" sz="3200" dirty="0"/>
          </a:p>
          <a:p>
            <a:pPr lvl="2"/>
            <a:r>
              <a:rPr lang="fr-CA" sz="2600" dirty="0" err="1"/>
              <a:t>Warmblood</a:t>
            </a:r>
            <a:r>
              <a:rPr lang="fr-CA" sz="2600" dirty="0"/>
              <a:t> mare: 12 </a:t>
            </a:r>
            <a:r>
              <a:rPr lang="fr-CA" sz="2600" dirty="0" err="1"/>
              <a:t>years</a:t>
            </a:r>
            <a:r>
              <a:rPr lang="fr-CA" sz="2600" dirty="0"/>
              <a:t>, 617 kg</a:t>
            </a:r>
          </a:p>
          <a:p>
            <a:r>
              <a:rPr lang="fr-CA" sz="3200" dirty="0" err="1"/>
              <a:t>Magnetic</a:t>
            </a:r>
            <a:r>
              <a:rPr lang="fr-CA" sz="3200" dirty="0"/>
              <a:t> </a:t>
            </a:r>
            <a:r>
              <a:rPr lang="fr-CA" sz="3200" dirty="0" err="1"/>
              <a:t>resonance</a:t>
            </a:r>
            <a:r>
              <a:rPr lang="fr-CA" sz="3200" dirty="0"/>
              <a:t> </a:t>
            </a:r>
            <a:r>
              <a:rPr lang="fr-CA" sz="3200" dirty="0" err="1"/>
              <a:t>imaging</a:t>
            </a:r>
            <a:r>
              <a:rPr lang="fr-CA" sz="3200" dirty="0"/>
              <a:t> (MRI) </a:t>
            </a:r>
            <a:r>
              <a:rPr lang="fr-CA" sz="3200" dirty="0" err="1"/>
              <a:t>study</a:t>
            </a:r>
            <a:r>
              <a:rPr lang="fr-CA" sz="3200" dirty="0"/>
              <a:t> </a:t>
            </a:r>
            <a:r>
              <a:rPr lang="fr-CA" sz="3200" dirty="0" err="1"/>
              <a:t>scheduled</a:t>
            </a:r>
            <a:endParaRPr lang="fr-CA" sz="3200" dirty="0"/>
          </a:p>
          <a:p>
            <a:r>
              <a:rPr lang="fr-CA" sz="3200" dirty="0"/>
              <a:t>Adverse </a:t>
            </a:r>
            <a:r>
              <a:rPr lang="fr-CA" sz="3200" dirty="0" err="1"/>
              <a:t>event</a:t>
            </a:r>
            <a:r>
              <a:rPr lang="fr-CA" sz="3200" dirty="0"/>
              <a:t>: </a:t>
            </a:r>
            <a:r>
              <a:rPr lang="fr-CA" sz="3200" dirty="0" err="1"/>
              <a:t>hypoxemia</a:t>
            </a:r>
            <a:r>
              <a:rPr lang="fr-CA" sz="3200" dirty="0"/>
              <a:t> </a:t>
            </a:r>
            <a:r>
              <a:rPr lang="fr-CA" sz="3200" dirty="0" err="1"/>
              <a:t>during</a:t>
            </a:r>
            <a:r>
              <a:rPr lang="fr-CA" sz="3200" dirty="0"/>
              <a:t> </a:t>
            </a:r>
            <a:r>
              <a:rPr lang="fr-CA" sz="3200" dirty="0" err="1"/>
              <a:t>recovery</a:t>
            </a:r>
            <a:r>
              <a:rPr lang="fr-CA" sz="3200" dirty="0"/>
              <a:t> </a:t>
            </a:r>
            <a:r>
              <a:rPr lang="fr-CA" sz="3200" dirty="0" err="1"/>
              <a:t>from</a:t>
            </a:r>
            <a:r>
              <a:rPr lang="fr-CA" sz="3200" dirty="0"/>
              <a:t> </a:t>
            </a:r>
            <a:r>
              <a:rPr lang="fr-CA" sz="3200" dirty="0" err="1"/>
              <a:t>general</a:t>
            </a:r>
            <a:r>
              <a:rPr lang="fr-CA" sz="3200" dirty="0"/>
              <a:t> </a:t>
            </a:r>
            <a:r>
              <a:rPr lang="fr-CA" sz="3200" dirty="0" err="1"/>
              <a:t>anaesthesia</a:t>
            </a:r>
            <a:endParaRPr lang="fr-CA" sz="3200" dirty="0"/>
          </a:p>
        </p:txBody>
      </p:sp>
    </p:spTree>
    <p:extLst>
      <p:ext uri="{BB962C8B-B14F-4D97-AF65-F5344CB8AC3E}">
        <p14:creationId xmlns:p14="http://schemas.microsoft.com/office/powerpoint/2010/main" val="11043768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E2F68B-2212-4FF0-8724-F12D284813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Background (S</a:t>
            </a:r>
            <a:r>
              <a:rPr lang="fr-CA" sz="5400" b="1" dirty="0"/>
              <a:t>B</a:t>
            </a:r>
            <a:r>
              <a:rPr lang="fr-CA" sz="5400" dirty="0"/>
              <a:t>AR)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0BB410D-380C-4251-AB81-5FBE80A39F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98600" y="2405575"/>
            <a:ext cx="9874117" cy="4501660"/>
          </a:xfrm>
        </p:spPr>
        <p:txBody>
          <a:bodyPr>
            <a:normAutofit fontScale="92500" lnSpcReduction="10000"/>
          </a:bodyPr>
          <a:lstStyle/>
          <a:p>
            <a:r>
              <a:rPr lang="fr-CA" sz="3100" dirty="0"/>
              <a:t>In good </a:t>
            </a:r>
            <a:r>
              <a:rPr lang="fr-CA" sz="3100" dirty="0" err="1"/>
              <a:t>health</a:t>
            </a:r>
            <a:r>
              <a:rPr lang="fr-CA" sz="3100" dirty="0"/>
              <a:t> </a:t>
            </a:r>
            <a:r>
              <a:rPr lang="fr-CA" sz="3100" dirty="0" err="1"/>
              <a:t>other</a:t>
            </a:r>
            <a:r>
              <a:rPr lang="fr-CA" sz="3100" dirty="0"/>
              <a:t> </a:t>
            </a:r>
            <a:r>
              <a:rPr lang="fr-CA" sz="3100" dirty="0" err="1"/>
              <a:t>than</a:t>
            </a:r>
            <a:r>
              <a:rPr lang="fr-CA" sz="3100" dirty="0"/>
              <a:t> </a:t>
            </a:r>
            <a:r>
              <a:rPr lang="fr-CA" sz="3100" dirty="0" err="1"/>
              <a:t>lameness</a:t>
            </a:r>
            <a:endParaRPr lang="fr-CA" sz="3100" dirty="0"/>
          </a:p>
          <a:p>
            <a:r>
              <a:rPr lang="fr-CA" sz="3100" dirty="0"/>
              <a:t>No </a:t>
            </a:r>
            <a:r>
              <a:rPr lang="fr-CA" sz="3100" dirty="0" err="1"/>
              <a:t>ongoing</a:t>
            </a:r>
            <a:r>
              <a:rPr lang="fr-CA" sz="3100" dirty="0"/>
              <a:t> </a:t>
            </a:r>
            <a:r>
              <a:rPr lang="fr-CA" sz="3100" dirty="0" err="1"/>
              <a:t>medication</a:t>
            </a:r>
            <a:endParaRPr lang="fr-CA" sz="3100" dirty="0"/>
          </a:p>
          <a:p>
            <a:r>
              <a:rPr lang="fr-CA" sz="3100" b="1" dirty="0"/>
              <a:t>ASA </a:t>
            </a:r>
            <a:r>
              <a:rPr lang="fr-CA" sz="3100" b="1" dirty="0" err="1"/>
              <a:t>physical</a:t>
            </a:r>
            <a:r>
              <a:rPr lang="fr-CA" sz="3100" b="1" dirty="0"/>
              <a:t> </a:t>
            </a:r>
            <a:r>
              <a:rPr lang="fr-CA" sz="3100" b="1" dirty="0" err="1"/>
              <a:t>status</a:t>
            </a:r>
            <a:r>
              <a:rPr lang="fr-CA" sz="3100" b="1" dirty="0"/>
              <a:t> classification 2</a:t>
            </a:r>
          </a:p>
          <a:p>
            <a:r>
              <a:rPr lang="fr-CA" sz="3100" dirty="0"/>
              <a:t>Physical exam</a:t>
            </a:r>
          </a:p>
          <a:p>
            <a:pPr lvl="2"/>
            <a:r>
              <a:rPr lang="fr-CA" sz="2600" i="1" dirty="0"/>
              <a:t>37</a:t>
            </a:r>
            <a:r>
              <a:rPr lang="fr-CA" sz="2600" i="1" dirty="0">
                <a:cs typeface="Calibri" panose="020F0502020204030204" pitchFamily="34" charset="0"/>
              </a:rPr>
              <a:t>°C, HR 44 </a:t>
            </a:r>
            <a:r>
              <a:rPr lang="fr-CA" sz="2600" i="1" dirty="0" err="1">
                <a:cs typeface="Calibri" panose="020F0502020204030204" pitchFamily="34" charset="0"/>
              </a:rPr>
              <a:t>bpm</a:t>
            </a:r>
            <a:r>
              <a:rPr lang="fr-CA" sz="2600" i="1" dirty="0">
                <a:cs typeface="Calibri" panose="020F0502020204030204" pitchFamily="34" charset="0"/>
              </a:rPr>
              <a:t>, 24 </a:t>
            </a:r>
            <a:r>
              <a:rPr lang="fr-CA" sz="2600" i="1" dirty="0" err="1">
                <a:cs typeface="Calibri" panose="020F0502020204030204" pitchFamily="34" charset="0"/>
              </a:rPr>
              <a:t>resp</a:t>
            </a:r>
            <a:r>
              <a:rPr lang="fr-CA" sz="2600" i="1" dirty="0">
                <a:cs typeface="Calibri" panose="020F0502020204030204" pitchFamily="34" charset="0"/>
              </a:rPr>
              <a:t>/min, </a:t>
            </a:r>
            <a:r>
              <a:rPr lang="fr-CA" sz="2600" i="1" dirty="0" err="1">
                <a:cs typeface="Calibri" panose="020F0502020204030204" pitchFamily="34" charset="0"/>
              </a:rPr>
              <a:t>mucous</a:t>
            </a:r>
            <a:r>
              <a:rPr lang="fr-CA" sz="2600" i="1" dirty="0">
                <a:cs typeface="Calibri" panose="020F0502020204030204" pitchFamily="34" charset="0"/>
              </a:rPr>
              <a:t> membranes </a:t>
            </a:r>
            <a:r>
              <a:rPr lang="fr-CA" sz="2600" i="1" dirty="0" err="1">
                <a:cs typeface="Calibri" panose="020F0502020204030204" pitchFamily="34" charset="0"/>
              </a:rPr>
              <a:t>pink</a:t>
            </a:r>
            <a:endParaRPr lang="fr-CA" sz="2600" i="1" dirty="0"/>
          </a:p>
          <a:p>
            <a:pPr lvl="1"/>
            <a:r>
              <a:rPr lang="fr-CA" sz="3100" dirty="0" err="1"/>
              <a:t>Laboratory</a:t>
            </a:r>
            <a:r>
              <a:rPr lang="fr-CA" sz="3100" dirty="0"/>
              <a:t> </a:t>
            </a:r>
            <a:r>
              <a:rPr lang="fr-CA" sz="3100" dirty="0" err="1"/>
              <a:t>results</a:t>
            </a:r>
            <a:endParaRPr lang="fr-CA" sz="3100" dirty="0"/>
          </a:p>
          <a:p>
            <a:pPr lvl="2"/>
            <a:r>
              <a:rPr lang="fr-CA" sz="2600" i="1" dirty="0" err="1"/>
              <a:t>Hct</a:t>
            </a:r>
            <a:r>
              <a:rPr lang="fr-CA" sz="2600" i="1" dirty="0"/>
              <a:t>: 34%</a:t>
            </a:r>
          </a:p>
          <a:p>
            <a:pPr lvl="2"/>
            <a:r>
              <a:rPr lang="fr-CA" sz="2600" i="1" dirty="0"/>
              <a:t>Total </a:t>
            </a:r>
            <a:r>
              <a:rPr lang="fr-CA" sz="2600" i="1" dirty="0" err="1"/>
              <a:t>protein</a:t>
            </a:r>
            <a:r>
              <a:rPr lang="fr-CA" sz="2600" i="1" dirty="0"/>
              <a:t>: 60g/L</a:t>
            </a:r>
          </a:p>
          <a:p>
            <a:pPr lvl="2"/>
            <a:r>
              <a:rPr lang="fr-CA" sz="2600" i="1" dirty="0" err="1"/>
              <a:t>Fibrinogen</a:t>
            </a:r>
            <a:r>
              <a:rPr lang="fr-CA" sz="2600" i="1" dirty="0"/>
              <a:t>: 2g/L</a:t>
            </a:r>
          </a:p>
          <a:p>
            <a:pPr lvl="1"/>
            <a:endParaRPr lang="fr-CA" dirty="0"/>
          </a:p>
        </p:txBody>
      </p:sp>
    </p:spTree>
    <p:extLst>
      <p:ext uri="{BB962C8B-B14F-4D97-AF65-F5344CB8AC3E}">
        <p14:creationId xmlns:p14="http://schemas.microsoft.com/office/powerpoint/2010/main" val="15899359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Anaesthsia</a:t>
            </a:r>
            <a:r>
              <a:rPr lang="en-US" dirty="0"/>
              <a:t> </a:t>
            </a:r>
            <a:r>
              <a:rPr lang="mr-IN" dirty="0"/>
              <a:t>–</a:t>
            </a:r>
            <a:r>
              <a:rPr lang="en-US" dirty="0"/>
              <a:t> premedication &amp; induc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CA" dirty="0" err="1"/>
              <a:t>Moderate</a:t>
            </a:r>
            <a:r>
              <a:rPr lang="fr-CA" dirty="0"/>
              <a:t> </a:t>
            </a:r>
            <a:r>
              <a:rPr lang="fr-CA" dirty="0" err="1"/>
              <a:t>sedation</a:t>
            </a:r>
            <a:r>
              <a:rPr lang="fr-CA" dirty="0"/>
              <a:t> (acepromazine 0.02 mg/kg @ 0830, </a:t>
            </a:r>
            <a:r>
              <a:rPr lang="fr-CA" dirty="0" err="1"/>
              <a:t>romifidine</a:t>
            </a:r>
            <a:r>
              <a:rPr lang="fr-CA" dirty="0"/>
              <a:t> 0.07 mg/kg @ 0900, IV)</a:t>
            </a:r>
          </a:p>
          <a:p>
            <a:r>
              <a:rPr lang="fr-CA" dirty="0"/>
              <a:t>No </a:t>
            </a:r>
            <a:r>
              <a:rPr lang="fr-CA" dirty="0" err="1"/>
              <a:t>resistance</a:t>
            </a:r>
            <a:r>
              <a:rPr lang="fr-CA" dirty="0"/>
              <a:t> to induction of </a:t>
            </a:r>
            <a:r>
              <a:rPr lang="fr-CA" dirty="0" err="1"/>
              <a:t>anaesthesia</a:t>
            </a:r>
            <a:r>
              <a:rPr lang="fr-CA" dirty="0"/>
              <a:t> (</a:t>
            </a:r>
            <a:r>
              <a:rPr lang="fr-CA" dirty="0" err="1"/>
              <a:t>ketamine</a:t>
            </a:r>
            <a:r>
              <a:rPr lang="fr-CA" dirty="0"/>
              <a:t> 2.2 mg/kg, </a:t>
            </a:r>
            <a:r>
              <a:rPr lang="fr-CA" dirty="0" err="1"/>
              <a:t>diazepam</a:t>
            </a:r>
            <a:r>
              <a:rPr lang="fr-CA" dirty="0"/>
              <a:t> 0.1 mg/kg @ 0910, IV)</a:t>
            </a:r>
          </a:p>
          <a:p>
            <a:r>
              <a:rPr lang="fr-CA" dirty="0"/>
              <a:t>Intubation </a:t>
            </a:r>
            <a:r>
              <a:rPr lang="fr-CA" dirty="0" err="1"/>
              <a:t>uneventful</a:t>
            </a:r>
            <a:r>
              <a:rPr lang="fr-CA" dirty="0"/>
              <a:t> </a:t>
            </a:r>
            <a:r>
              <a:rPr lang="mr-IN" dirty="0"/>
              <a:t>–</a:t>
            </a:r>
            <a:r>
              <a:rPr lang="en-CA" dirty="0"/>
              <a:t> </a:t>
            </a:r>
            <a:r>
              <a:rPr lang="fr-CA" dirty="0" err="1"/>
              <a:t>endotracheal</a:t>
            </a:r>
            <a:r>
              <a:rPr lang="fr-CA" dirty="0"/>
              <a:t> tube 26 mm ID</a:t>
            </a:r>
          </a:p>
          <a:p>
            <a:r>
              <a:rPr lang="fr-CA" dirty="0"/>
              <a:t>Total </a:t>
            </a:r>
            <a:r>
              <a:rPr lang="fr-CA" dirty="0" err="1"/>
              <a:t>anaesthesia</a:t>
            </a:r>
            <a:r>
              <a:rPr lang="fr-CA" dirty="0"/>
              <a:t> duration: 3 </a:t>
            </a:r>
            <a:r>
              <a:rPr lang="fr-CA" dirty="0" err="1"/>
              <a:t>hours</a:t>
            </a:r>
            <a:endParaRPr lang="fr-CA" dirty="0"/>
          </a:p>
        </p:txBody>
      </p:sp>
      <p:sp>
        <p:nvSpPr>
          <p:cNvPr id="4" name="TextBox 3"/>
          <p:cNvSpPr txBox="1"/>
          <p:nvPr/>
        </p:nvSpPr>
        <p:spPr>
          <a:xfrm>
            <a:off x="1762831" y="5650468"/>
            <a:ext cx="7545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uring actual presentation, copy of </a:t>
            </a:r>
            <a:r>
              <a:rPr lang="en-US" dirty="0" err="1"/>
              <a:t>anaesthetic</a:t>
            </a:r>
            <a:r>
              <a:rPr lang="en-US" dirty="0"/>
              <a:t> chart displayed)</a:t>
            </a:r>
          </a:p>
        </p:txBody>
      </p:sp>
    </p:spTree>
    <p:extLst>
      <p:ext uri="{BB962C8B-B14F-4D97-AF65-F5344CB8AC3E}">
        <p14:creationId xmlns:p14="http://schemas.microsoft.com/office/powerpoint/2010/main" val="18665276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ief review of relevant pulmonary physiology</a:t>
            </a:r>
          </a:p>
        </p:txBody>
      </p:sp>
    </p:spTree>
    <p:extLst>
      <p:ext uri="{BB962C8B-B14F-4D97-AF65-F5344CB8AC3E}">
        <p14:creationId xmlns:p14="http://schemas.microsoft.com/office/powerpoint/2010/main" val="10091506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50000"/>
            <a:lumOff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Circle"/>
          <p:cNvSpPr/>
          <p:nvPr/>
        </p:nvSpPr>
        <p:spPr>
          <a:xfrm>
            <a:off x="4301133" y="3920133"/>
            <a:ext cx="892969" cy="892969"/>
          </a:xfrm>
          <a:prstGeom prst="ellipse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59" name="Rectangle"/>
          <p:cNvSpPr/>
          <p:nvPr/>
        </p:nvSpPr>
        <p:spPr>
          <a:xfrm rot="18388154">
            <a:off x="4592810" y="3123932"/>
            <a:ext cx="1830587" cy="446485"/>
          </a:xfrm>
          <a:prstGeom prst="rect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0" name="Circle"/>
          <p:cNvSpPr/>
          <p:nvPr/>
        </p:nvSpPr>
        <p:spPr>
          <a:xfrm>
            <a:off x="5810250" y="4027289"/>
            <a:ext cx="892969" cy="892969"/>
          </a:xfrm>
          <a:prstGeom prst="ellipse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1" name="Rectangle"/>
          <p:cNvSpPr/>
          <p:nvPr/>
        </p:nvSpPr>
        <p:spPr>
          <a:xfrm>
            <a:off x="6042422" y="2607469"/>
            <a:ext cx="446484" cy="1509117"/>
          </a:xfrm>
          <a:prstGeom prst="rect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2" name="Oval"/>
          <p:cNvSpPr/>
          <p:nvPr/>
        </p:nvSpPr>
        <p:spPr>
          <a:xfrm rot="19893362">
            <a:off x="7449773" y="3657765"/>
            <a:ext cx="187524" cy="1205509"/>
          </a:xfrm>
          <a:prstGeom prst="ellipse">
            <a:avLst/>
          </a:prstGeom>
          <a:gradFill>
            <a:gsLst>
              <a:gs pos="0">
                <a:srgbClr val="0096FF"/>
              </a:gs>
              <a:gs pos="100000">
                <a:srgbClr val="58596B"/>
              </a:gs>
            </a:gsLst>
            <a:lin ang="4560000"/>
          </a:gra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3" name="Rectangle"/>
          <p:cNvSpPr/>
          <p:nvPr/>
        </p:nvSpPr>
        <p:spPr>
          <a:xfrm rot="19355678">
            <a:off x="6656658" y="2464169"/>
            <a:ext cx="446485" cy="1571626"/>
          </a:xfrm>
          <a:prstGeom prst="rect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4" name="Rectangle"/>
          <p:cNvSpPr/>
          <p:nvPr/>
        </p:nvSpPr>
        <p:spPr>
          <a:xfrm>
            <a:off x="5863828" y="1785937"/>
            <a:ext cx="723305" cy="1116211"/>
          </a:xfrm>
          <a:prstGeom prst="rect">
            <a:avLst/>
          </a:prstGeom>
          <a:gradFill>
            <a:gsLst>
              <a:gs pos="0">
                <a:srgbClr val="0096FF"/>
              </a:gs>
              <a:gs pos="100000">
                <a:srgbClr val="929292"/>
              </a:gs>
            </a:gsLst>
            <a:lin ang="16320000"/>
          </a:gra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5" name="Rectangle"/>
          <p:cNvSpPr/>
          <p:nvPr/>
        </p:nvSpPr>
        <p:spPr>
          <a:xfrm rot="2085566">
            <a:off x="3591582" y="4929485"/>
            <a:ext cx="1375173" cy="44649"/>
          </a:xfrm>
          <a:prstGeom prst="rect">
            <a:avLst/>
          </a:prstGeom>
          <a:solidFill>
            <a:srgbClr val="FF2600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6" name="Rectangle"/>
          <p:cNvSpPr/>
          <p:nvPr/>
        </p:nvSpPr>
        <p:spPr>
          <a:xfrm>
            <a:off x="5508879" y="5058651"/>
            <a:ext cx="1375173" cy="383977"/>
          </a:xfrm>
          <a:prstGeom prst="rect">
            <a:avLst/>
          </a:prstGeom>
          <a:solidFill>
            <a:srgbClr val="FF2600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7" name="Rectangle"/>
          <p:cNvSpPr/>
          <p:nvPr/>
        </p:nvSpPr>
        <p:spPr>
          <a:xfrm rot="19355680">
            <a:off x="7410902" y="4781830"/>
            <a:ext cx="1375173" cy="383977"/>
          </a:xfrm>
          <a:prstGeom prst="rect">
            <a:avLst/>
          </a:prstGeom>
          <a:solidFill>
            <a:srgbClr val="FF2600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8" name="Ventilation-Perfusion (V/Q) mismatch, shunt…"/>
          <p:cNvSpPr txBox="1"/>
          <p:nvPr/>
        </p:nvSpPr>
        <p:spPr>
          <a:xfrm>
            <a:off x="1599902" y="713871"/>
            <a:ext cx="8527852" cy="111088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35719" tIns="35719" rIns="35719" bIns="35719" anchor="ctr">
            <a:spAutoFit/>
          </a:bodyPr>
          <a:lstStyle/>
          <a:p>
            <a:pPr>
              <a:defRPr sz="4800">
                <a:solidFill>
                  <a:srgbClr val="FFFFFF"/>
                </a:solidFill>
              </a:defRPr>
            </a:pPr>
            <a:r>
              <a:rPr sz="3375" dirty="0"/>
              <a:t>Ventilation-Perfusion (V/Q) mismatch, shunt &amp; dead space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198582" y="5544001"/>
            <a:ext cx="159050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ead space</a:t>
            </a:r>
          </a:p>
          <a:p>
            <a:r>
              <a:rPr lang="en-US" dirty="0"/>
              <a:t>V/Q = </a:t>
            </a:r>
            <a:r>
              <a:rPr lang="en-US" sz="2400" dirty="0"/>
              <a:t>∞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617665" y="5614219"/>
            <a:ext cx="10438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deal</a:t>
            </a:r>
          </a:p>
          <a:p>
            <a:r>
              <a:rPr lang="en-US" dirty="0"/>
              <a:t>V/Q = 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932255" y="5614219"/>
            <a:ext cx="10438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unt</a:t>
            </a:r>
          </a:p>
          <a:p>
            <a:r>
              <a:rPr lang="en-US" dirty="0"/>
              <a:t>V/Q = 0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96645" y="3048000"/>
            <a:ext cx="325616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eneral </a:t>
            </a:r>
            <a:r>
              <a:rPr lang="en-US" dirty="0" err="1"/>
              <a:t>anaesthesia</a:t>
            </a:r>
            <a:r>
              <a:rPr lang="en-US" dirty="0"/>
              <a:t> associated with increased ventilation-perfusion mismatch with:</a:t>
            </a:r>
          </a:p>
          <a:p>
            <a:pPr marL="342900" indent="-342900">
              <a:buAutoNum type="arabicPeriod"/>
            </a:pPr>
            <a:r>
              <a:rPr lang="en-US" dirty="0"/>
              <a:t>Increased shunt fraction</a:t>
            </a:r>
          </a:p>
          <a:p>
            <a:pPr marL="342900" indent="-342900">
              <a:buAutoNum type="arabicPeriod"/>
            </a:pPr>
            <a:r>
              <a:rPr lang="en-US" dirty="0"/>
              <a:t>Increased alveolar dead space</a:t>
            </a:r>
          </a:p>
        </p:txBody>
      </p:sp>
    </p:spTree>
    <p:extLst>
      <p:ext uri="{BB962C8B-B14F-4D97-AF65-F5344CB8AC3E}">
        <p14:creationId xmlns:p14="http://schemas.microsoft.com/office/powerpoint/2010/main" val="532672774"/>
      </p:ext>
    </p:extLst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4B779918-B27D-4AA2-AFFA-94185EE713D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143" t="19173" r="42250" b="47160"/>
          <a:stretch/>
        </p:blipFill>
        <p:spPr>
          <a:xfrm>
            <a:off x="957943" y="0"/>
            <a:ext cx="10364680" cy="6858000"/>
          </a:xfrm>
          <a:prstGeom prst="rect">
            <a:avLst/>
          </a:prstGeom>
        </p:spPr>
      </p:pic>
      <p:sp>
        <p:nvSpPr>
          <p:cNvPr id="6" name="Forme libre : forme 5">
            <a:extLst>
              <a:ext uri="{FF2B5EF4-FFF2-40B4-BE49-F238E27FC236}">
                <a16:creationId xmlns:a16="http://schemas.microsoft.com/office/drawing/2014/main" id="{5868FEB1-E980-486F-8EBB-DDA377E38E76}"/>
              </a:ext>
            </a:extLst>
          </p:cNvPr>
          <p:cNvSpPr/>
          <p:nvPr/>
        </p:nvSpPr>
        <p:spPr>
          <a:xfrm>
            <a:off x="3045007" y="3541293"/>
            <a:ext cx="4097859" cy="2380536"/>
          </a:xfrm>
          <a:custGeom>
            <a:avLst/>
            <a:gdLst>
              <a:gd name="connsiteX0" fmla="*/ 206193 w 4097859"/>
              <a:gd name="connsiteY0" fmla="*/ 43736 h 2380536"/>
              <a:gd name="connsiteX1" fmla="*/ 278764 w 4097859"/>
              <a:gd name="connsiteY1" fmla="*/ 193 h 2380536"/>
              <a:gd name="connsiteX2" fmla="*/ 322307 w 4097859"/>
              <a:gd name="connsiteY2" fmla="*/ 29221 h 2380536"/>
              <a:gd name="connsiteX3" fmla="*/ 351336 w 4097859"/>
              <a:gd name="connsiteY3" fmla="*/ 116307 h 2380536"/>
              <a:gd name="connsiteX4" fmla="*/ 365850 w 4097859"/>
              <a:gd name="connsiteY4" fmla="*/ 159850 h 2380536"/>
              <a:gd name="connsiteX5" fmla="*/ 394879 w 4097859"/>
              <a:gd name="connsiteY5" fmla="*/ 334021 h 2380536"/>
              <a:gd name="connsiteX6" fmla="*/ 423907 w 4097859"/>
              <a:gd name="connsiteY6" fmla="*/ 450136 h 2380536"/>
              <a:gd name="connsiteX7" fmla="*/ 452936 w 4097859"/>
              <a:gd name="connsiteY7" fmla="*/ 551736 h 2380536"/>
              <a:gd name="connsiteX8" fmla="*/ 496479 w 4097859"/>
              <a:gd name="connsiteY8" fmla="*/ 566250 h 2380536"/>
              <a:gd name="connsiteX9" fmla="*/ 510993 w 4097859"/>
              <a:gd name="connsiteY9" fmla="*/ 609793 h 2380536"/>
              <a:gd name="connsiteX10" fmla="*/ 569050 w 4097859"/>
              <a:gd name="connsiteY10" fmla="*/ 696878 h 2380536"/>
              <a:gd name="connsiteX11" fmla="*/ 583564 w 4097859"/>
              <a:gd name="connsiteY11" fmla="*/ 856536 h 2380536"/>
              <a:gd name="connsiteX12" fmla="*/ 656136 w 4097859"/>
              <a:gd name="connsiteY12" fmla="*/ 943621 h 2380536"/>
              <a:gd name="connsiteX13" fmla="*/ 728707 w 4097859"/>
              <a:gd name="connsiteY13" fmla="*/ 1030707 h 2380536"/>
              <a:gd name="connsiteX14" fmla="*/ 772250 w 4097859"/>
              <a:gd name="connsiteY14" fmla="*/ 1117793 h 2380536"/>
              <a:gd name="connsiteX15" fmla="*/ 801279 w 4097859"/>
              <a:gd name="connsiteY15" fmla="*/ 1204878 h 2380536"/>
              <a:gd name="connsiteX16" fmla="*/ 902879 w 4097859"/>
              <a:gd name="connsiteY16" fmla="*/ 1291964 h 2380536"/>
              <a:gd name="connsiteX17" fmla="*/ 1077050 w 4097859"/>
              <a:gd name="connsiteY17" fmla="*/ 1335507 h 2380536"/>
              <a:gd name="connsiteX18" fmla="*/ 1164136 w 4097859"/>
              <a:gd name="connsiteY18" fmla="*/ 1364536 h 2380536"/>
              <a:gd name="connsiteX19" fmla="*/ 1251222 w 4097859"/>
              <a:gd name="connsiteY19" fmla="*/ 1408078 h 2380536"/>
              <a:gd name="connsiteX20" fmla="*/ 1265736 w 4097859"/>
              <a:gd name="connsiteY20" fmla="*/ 1451621 h 2380536"/>
              <a:gd name="connsiteX21" fmla="*/ 1338307 w 4097859"/>
              <a:gd name="connsiteY21" fmla="*/ 1466136 h 2380536"/>
              <a:gd name="connsiteX22" fmla="*/ 1425393 w 4097859"/>
              <a:gd name="connsiteY22" fmla="*/ 1509678 h 2380536"/>
              <a:gd name="connsiteX23" fmla="*/ 1556022 w 4097859"/>
              <a:gd name="connsiteY23" fmla="*/ 1538707 h 2380536"/>
              <a:gd name="connsiteX24" fmla="*/ 1599564 w 4097859"/>
              <a:gd name="connsiteY24" fmla="*/ 1553221 h 2380536"/>
              <a:gd name="connsiteX25" fmla="*/ 1657622 w 4097859"/>
              <a:gd name="connsiteY25" fmla="*/ 1567736 h 2380536"/>
              <a:gd name="connsiteX26" fmla="*/ 1788250 w 4097859"/>
              <a:gd name="connsiteY26" fmla="*/ 1611278 h 2380536"/>
              <a:gd name="connsiteX27" fmla="*/ 2252707 w 4097859"/>
              <a:gd name="connsiteY27" fmla="*/ 1640307 h 2380536"/>
              <a:gd name="connsiteX28" fmla="*/ 2339793 w 4097859"/>
              <a:gd name="connsiteY28" fmla="*/ 1669336 h 2380536"/>
              <a:gd name="connsiteX29" fmla="*/ 2426879 w 4097859"/>
              <a:gd name="connsiteY29" fmla="*/ 1683850 h 2380536"/>
              <a:gd name="connsiteX30" fmla="*/ 2992936 w 4097859"/>
              <a:gd name="connsiteY30" fmla="*/ 1669336 h 2380536"/>
              <a:gd name="connsiteX31" fmla="*/ 3021964 w 4097859"/>
              <a:gd name="connsiteY31" fmla="*/ 1625793 h 2380536"/>
              <a:gd name="connsiteX32" fmla="*/ 3080022 w 4097859"/>
              <a:gd name="connsiteY32" fmla="*/ 1611278 h 2380536"/>
              <a:gd name="connsiteX33" fmla="*/ 3588022 w 4097859"/>
              <a:gd name="connsiteY33" fmla="*/ 1596764 h 2380536"/>
              <a:gd name="connsiteX34" fmla="*/ 3646079 w 4097859"/>
              <a:gd name="connsiteY34" fmla="*/ 1582250 h 2380536"/>
              <a:gd name="connsiteX35" fmla="*/ 3689622 w 4097859"/>
              <a:gd name="connsiteY35" fmla="*/ 1567736 h 2380536"/>
              <a:gd name="connsiteX36" fmla="*/ 3849279 w 4097859"/>
              <a:gd name="connsiteY36" fmla="*/ 1553221 h 2380536"/>
              <a:gd name="connsiteX37" fmla="*/ 4096022 w 4097859"/>
              <a:gd name="connsiteY37" fmla="*/ 1553221 h 2380536"/>
              <a:gd name="connsiteX38" fmla="*/ 4052479 w 4097859"/>
              <a:gd name="connsiteY38" fmla="*/ 1770936 h 2380536"/>
              <a:gd name="connsiteX39" fmla="*/ 3965393 w 4097859"/>
              <a:gd name="connsiteY39" fmla="*/ 1799964 h 2380536"/>
              <a:gd name="connsiteX40" fmla="*/ 3834764 w 4097859"/>
              <a:gd name="connsiteY40" fmla="*/ 1916078 h 2380536"/>
              <a:gd name="connsiteX41" fmla="*/ 3805736 w 4097859"/>
              <a:gd name="connsiteY41" fmla="*/ 1959621 h 2380536"/>
              <a:gd name="connsiteX42" fmla="*/ 3718650 w 4097859"/>
              <a:gd name="connsiteY42" fmla="*/ 1988650 h 2380536"/>
              <a:gd name="connsiteX43" fmla="*/ 3646079 w 4097859"/>
              <a:gd name="connsiteY43" fmla="*/ 2046707 h 2380536"/>
              <a:gd name="connsiteX44" fmla="*/ 3442879 w 4097859"/>
              <a:gd name="connsiteY44" fmla="*/ 2119278 h 2380536"/>
              <a:gd name="connsiteX45" fmla="*/ 3399336 w 4097859"/>
              <a:gd name="connsiteY45" fmla="*/ 2148307 h 2380536"/>
              <a:gd name="connsiteX46" fmla="*/ 3268707 w 4097859"/>
              <a:gd name="connsiteY46" fmla="*/ 2177336 h 2380536"/>
              <a:gd name="connsiteX47" fmla="*/ 3225164 w 4097859"/>
              <a:gd name="connsiteY47" fmla="*/ 2191850 h 2380536"/>
              <a:gd name="connsiteX48" fmla="*/ 3181622 w 4097859"/>
              <a:gd name="connsiteY48" fmla="*/ 2220878 h 2380536"/>
              <a:gd name="connsiteX49" fmla="*/ 3109050 w 4097859"/>
              <a:gd name="connsiteY49" fmla="*/ 2235393 h 2380536"/>
              <a:gd name="connsiteX50" fmla="*/ 3050993 w 4097859"/>
              <a:gd name="connsiteY50" fmla="*/ 2249907 h 2380536"/>
              <a:gd name="connsiteX51" fmla="*/ 2963907 w 4097859"/>
              <a:gd name="connsiteY51" fmla="*/ 2278936 h 2380536"/>
              <a:gd name="connsiteX52" fmla="*/ 2920364 w 4097859"/>
              <a:gd name="connsiteY52" fmla="*/ 2293450 h 2380536"/>
              <a:gd name="connsiteX53" fmla="*/ 2818764 w 4097859"/>
              <a:gd name="connsiteY53" fmla="*/ 2322478 h 2380536"/>
              <a:gd name="connsiteX54" fmla="*/ 2775222 w 4097859"/>
              <a:gd name="connsiteY54" fmla="*/ 2351507 h 2380536"/>
              <a:gd name="connsiteX55" fmla="*/ 2339793 w 4097859"/>
              <a:gd name="connsiteY55" fmla="*/ 2380536 h 2380536"/>
              <a:gd name="connsiteX56" fmla="*/ 1222193 w 4097859"/>
              <a:gd name="connsiteY56" fmla="*/ 2366021 h 2380536"/>
              <a:gd name="connsiteX57" fmla="*/ 1149622 w 4097859"/>
              <a:gd name="connsiteY57" fmla="*/ 2307964 h 2380536"/>
              <a:gd name="connsiteX58" fmla="*/ 902879 w 4097859"/>
              <a:gd name="connsiteY58" fmla="*/ 2293450 h 2380536"/>
              <a:gd name="connsiteX59" fmla="*/ 772250 w 4097859"/>
              <a:gd name="connsiteY59" fmla="*/ 2235393 h 2380536"/>
              <a:gd name="connsiteX60" fmla="*/ 714193 w 4097859"/>
              <a:gd name="connsiteY60" fmla="*/ 2206364 h 2380536"/>
              <a:gd name="connsiteX61" fmla="*/ 670650 w 4097859"/>
              <a:gd name="connsiteY61" fmla="*/ 2177336 h 2380536"/>
              <a:gd name="connsiteX62" fmla="*/ 525507 w 4097859"/>
              <a:gd name="connsiteY62" fmla="*/ 2133793 h 2380536"/>
              <a:gd name="connsiteX63" fmla="*/ 409393 w 4097859"/>
              <a:gd name="connsiteY63" fmla="*/ 2075736 h 2380536"/>
              <a:gd name="connsiteX64" fmla="*/ 365850 w 4097859"/>
              <a:gd name="connsiteY64" fmla="*/ 2046707 h 2380536"/>
              <a:gd name="connsiteX65" fmla="*/ 322307 w 4097859"/>
              <a:gd name="connsiteY65" fmla="*/ 2032193 h 2380536"/>
              <a:gd name="connsiteX66" fmla="*/ 278764 w 4097859"/>
              <a:gd name="connsiteY66" fmla="*/ 1988650 h 2380536"/>
              <a:gd name="connsiteX67" fmla="*/ 235222 w 4097859"/>
              <a:gd name="connsiteY67" fmla="*/ 1959621 h 2380536"/>
              <a:gd name="connsiteX68" fmla="*/ 177164 w 4097859"/>
              <a:gd name="connsiteY68" fmla="*/ 1872536 h 2380536"/>
              <a:gd name="connsiteX69" fmla="*/ 162650 w 4097859"/>
              <a:gd name="connsiteY69" fmla="*/ 1814478 h 2380536"/>
              <a:gd name="connsiteX70" fmla="*/ 61050 w 4097859"/>
              <a:gd name="connsiteY70" fmla="*/ 1683850 h 2380536"/>
              <a:gd name="connsiteX71" fmla="*/ 61050 w 4097859"/>
              <a:gd name="connsiteY71" fmla="*/ 1509678 h 2380536"/>
              <a:gd name="connsiteX72" fmla="*/ 75564 w 4097859"/>
              <a:gd name="connsiteY72" fmla="*/ 1466136 h 2380536"/>
              <a:gd name="connsiteX73" fmla="*/ 206193 w 4097859"/>
              <a:gd name="connsiteY73" fmla="*/ 1393564 h 2380536"/>
              <a:gd name="connsiteX74" fmla="*/ 307793 w 4097859"/>
              <a:gd name="connsiteY74" fmla="*/ 1277450 h 2380536"/>
              <a:gd name="connsiteX75" fmla="*/ 322307 w 4097859"/>
              <a:gd name="connsiteY75" fmla="*/ 1233907 h 2380536"/>
              <a:gd name="connsiteX76" fmla="*/ 351336 w 4097859"/>
              <a:gd name="connsiteY76" fmla="*/ 1088764 h 2380536"/>
              <a:gd name="connsiteX77" fmla="*/ 336822 w 4097859"/>
              <a:gd name="connsiteY77" fmla="*/ 1030707 h 2380536"/>
              <a:gd name="connsiteX78" fmla="*/ 293279 w 4097859"/>
              <a:gd name="connsiteY78" fmla="*/ 1016193 h 2380536"/>
              <a:gd name="connsiteX79" fmla="*/ 264250 w 4097859"/>
              <a:gd name="connsiteY79" fmla="*/ 972650 h 2380536"/>
              <a:gd name="connsiteX80" fmla="*/ 177164 w 4097859"/>
              <a:gd name="connsiteY80" fmla="*/ 943621 h 2380536"/>
              <a:gd name="connsiteX81" fmla="*/ 90079 w 4097859"/>
              <a:gd name="connsiteY81" fmla="*/ 900078 h 2380536"/>
              <a:gd name="connsiteX82" fmla="*/ 75564 w 4097859"/>
              <a:gd name="connsiteY82" fmla="*/ 856536 h 2380536"/>
              <a:gd name="connsiteX83" fmla="*/ 32022 w 4097859"/>
              <a:gd name="connsiteY83" fmla="*/ 827507 h 2380536"/>
              <a:gd name="connsiteX84" fmla="*/ 2993 w 4097859"/>
              <a:gd name="connsiteY84" fmla="*/ 740421 h 2380536"/>
              <a:gd name="connsiteX85" fmla="*/ 17507 w 4097859"/>
              <a:gd name="connsiteY85" fmla="*/ 188878 h 2380536"/>
              <a:gd name="connsiteX86" fmla="*/ 104593 w 4097859"/>
              <a:gd name="connsiteY86" fmla="*/ 159850 h 2380536"/>
              <a:gd name="connsiteX87" fmla="*/ 148136 w 4097859"/>
              <a:gd name="connsiteY87" fmla="*/ 145336 h 2380536"/>
              <a:gd name="connsiteX88" fmla="*/ 177164 w 4097859"/>
              <a:gd name="connsiteY88" fmla="*/ 101793 h 2380536"/>
              <a:gd name="connsiteX89" fmla="*/ 249736 w 4097859"/>
              <a:gd name="connsiteY89" fmla="*/ 87278 h 23805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4097859" h="2380536">
                <a:moveTo>
                  <a:pt x="206193" y="43736"/>
                </a:moveTo>
                <a:cubicBezTo>
                  <a:pt x="230383" y="29222"/>
                  <a:pt x="250771" y="3692"/>
                  <a:pt x="278764" y="193"/>
                </a:cubicBezTo>
                <a:cubicBezTo>
                  <a:pt x="296073" y="-1971"/>
                  <a:pt x="313062" y="14429"/>
                  <a:pt x="322307" y="29221"/>
                </a:cubicBezTo>
                <a:cubicBezTo>
                  <a:pt x="338525" y="55169"/>
                  <a:pt x="341660" y="87278"/>
                  <a:pt x="351336" y="116307"/>
                </a:cubicBezTo>
                <a:cubicBezTo>
                  <a:pt x="356174" y="130821"/>
                  <a:pt x="363335" y="144759"/>
                  <a:pt x="365850" y="159850"/>
                </a:cubicBezTo>
                <a:cubicBezTo>
                  <a:pt x="375526" y="217907"/>
                  <a:pt x="376267" y="278183"/>
                  <a:pt x="394879" y="334021"/>
                </a:cubicBezTo>
                <a:cubicBezTo>
                  <a:pt x="420816" y="411835"/>
                  <a:pt x="400552" y="345039"/>
                  <a:pt x="423907" y="450136"/>
                </a:cubicBezTo>
                <a:cubicBezTo>
                  <a:pt x="424014" y="450618"/>
                  <a:pt x="446010" y="544810"/>
                  <a:pt x="452936" y="551736"/>
                </a:cubicBezTo>
                <a:cubicBezTo>
                  <a:pt x="463754" y="562554"/>
                  <a:pt x="481965" y="561412"/>
                  <a:pt x="496479" y="566250"/>
                </a:cubicBezTo>
                <a:cubicBezTo>
                  <a:pt x="501317" y="580764"/>
                  <a:pt x="502506" y="597063"/>
                  <a:pt x="510993" y="609793"/>
                </a:cubicBezTo>
                <a:cubicBezTo>
                  <a:pt x="583475" y="718516"/>
                  <a:pt x="534539" y="593345"/>
                  <a:pt x="569050" y="696878"/>
                </a:cubicBezTo>
                <a:cubicBezTo>
                  <a:pt x="573888" y="750097"/>
                  <a:pt x="572367" y="804283"/>
                  <a:pt x="583564" y="856536"/>
                </a:cubicBezTo>
                <a:cubicBezTo>
                  <a:pt x="589801" y="885640"/>
                  <a:pt x="640477" y="924830"/>
                  <a:pt x="656136" y="943621"/>
                </a:cubicBezTo>
                <a:cubicBezTo>
                  <a:pt x="757172" y="1064865"/>
                  <a:pt x="601495" y="903495"/>
                  <a:pt x="728707" y="1030707"/>
                </a:cubicBezTo>
                <a:cubicBezTo>
                  <a:pt x="781645" y="1189515"/>
                  <a:pt x="697216" y="948967"/>
                  <a:pt x="772250" y="1117793"/>
                </a:cubicBezTo>
                <a:cubicBezTo>
                  <a:pt x="784677" y="1145754"/>
                  <a:pt x="779643" y="1183242"/>
                  <a:pt x="801279" y="1204878"/>
                </a:cubicBezTo>
                <a:cubicBezTo>
                  <a:pt x="825814" y="1229413"/>
                  <a:pt x="870960" y="1278664"/>
                  <a:pt x="902879" y="1291964"/>
                </a:cubicBezTo>
                <a:cubicBezTo>
                  <a:pt x="960956" y="1316163"/>
                  <a:pt x="1018983" y="1316151"/>
                  <a:pt x="1077050" y="1335507"/>
                </a:cubicBezTo>
                <a:cubicBezTo>
                  <a:pt x="1106079" y="1345183"/>
                  <a:pt x="1138676" y="1347563"/>
                  <a:pt x="1164136" y="1364536"/>
                </a:cubicBezTo>
                <a:cubicBezTo>
                  <a:pt x="1220409" y="1402050"/>
                  <a:pt x="1191130" y="1388048"/>
                  <a:pt x="1251222" y="1408078"/>
                </a:cubicBezTo>
                <a:cubicBezTo>
                  <a:pt x="1256060" y="1422592"/>
                  <a:pt x="1253006" y="1443134"/>
                  <a:pt x="1265736" y="1451621"/>
                </a:cubicBezTo>
                <a:cubicBezTo>
                  <a:pt x="1286262" y="1465305"/>
                  <a:pt x="1314374" y="1460153"/>
                  <a:pt x="1338307" y="1466136"/>
                </a:cubicBezTo>
                <a:cubicBezTo>
                  <a:pt x="1411272" y="1484377"/>
                  <a:pt x="1354443" y="1474203"/>
                  <a:pt x="1425393" y="1509678"/>
                </a:cubicBezTo>
                <a:cubicBezTo>
                  <a:pt x="1461128" y="1527545"/>
                  <a:pt x="1522567" y="1533131"/>
                  <a:pt x="1556022" y="1538707"/>
                </a:cubicBezTo>
                <a:cubicBezTo>
                  <a:pt x="1570536" y="1543545"/>
                  <a:pt x="1584854" y="1549018"/>
                  <a:pt x="1599564" y="1553221"/>
                </a:cubicBezTo>
                <a:cubicBezTo>
                  <a:pt x="1618745" y="1558701"/>
                  <a:pt x="1639287" y="1559878"/>
                  <a:pt x="1657622" y="1567736"/>
                </a:cubicBezTo>
                <a:cubicBezTo>
                  <a:pt x="1787493" y="1623395"/>
                  <a:pt x="1579624" y="1576508"/>
                  <a:pt x="1788250" y="1611278"/>
                </a:cubicBezTo>
                <a:cubicBezTo>
                  <a:pt x="1974811" y="1673468"/>
                  <a:pt x="1726257" y="1595183"/>
                  <a:pt x="2252707" y="1640307"/>
                </a:cubicBezTo>
                <a:cubicBezTo>
                  <a:pt x="2283194" y="1642920"/>
                  <a:pt x="2309610" y="1664306"/>
                  <a:pt x="2339793" y="1669336"/>
                </a:cubicBezTo>
                <a:lnTo>
                  <a:pt x="2426879" y="1683850"/>
                </a:lnTo>
                <a:cubicBezTo>
                  <a:pt x="2615565" y="1679012"/>
                  <a:pt x="2805080" y="1687663"/>
                  <a:pt x="2992936" y="1669336"/>
                </a:cubicBezTo>
                <a:cubicBezTo>
                  <a:pt x="3010298" y="1667642"/>
                  <a:pt x="3007450" y="1635469"/>
                  <a:pt x="3021964" y="1625793"/>
                </a:cubicBezTo>
                <a:cubicBezTo>
                  <a:pt x="3038562" y="1614728"/>
                  <a:pt x="3060100" y="1612300"/>
                  <a:pt x="3080022" y="1611278"/>
                </a:cubicBezTo>
                <a:cubicBezTo>
                  <a:pt x="3249202" y="1602602"/>
                  <a:pt x="3418689" y="1601602"/>
                  <a:pt x="3588022" y="1596764"/>
                </a:cubicBezTo>
                <a:cubicBezTo>
                  <a:pt x="3607374" y="1591926"/>
                  <a:pt x="3626899" y="1587730"/>
                  <a:pt x="3646079" y="1582250"/>
                </a:cubicBezTo>
                <a:cubicBezTo>
                  <a:pt x="3660790" y="1578047"/>
                  <a:pt x="3674476" y="1569900"/>
                  <a:pt x="3689622" y="1567736"/>
                </a:cubicBezTo>
                <a:cubicBezTo>
                  <a:pt x="3742523" y="1560179"/>
                  <a:pt x="3796060" y="1558059"/>
                  <a:pt x="3849279" y="1553221"/>
                </a:cubicBezTo>
                <a:cubicBezTo>
                  <a:pt x="3922965" y="1528660"/>
                  <a:pt x="4029705" y="1486904"/>
                  <a:pt x="4096022" y="1553221"/>
                </a:cubicBezTo>
                <a:cubicBezTo>
                  <a:pt x="4097442" y="1554641"/>
                  <a:pt x="4108618" y="1735850"/>
                  <a:pt x="4052479" y="1770936"/>
                </a:cubicBezTo>
                <a:cubicBezTo>
                  <a:pt x="4026531" y="1787153"/>
                  <a:pt x="3965393" y="1799964"/>
                  <a:pt x="3965393" y="1799964"/>
                </a:cubicBezTo>
                <a:cubicBezTo>
                  <a:pt x="3913042" y="1834865"/>
                  <a:pt x="3874529" y="1856429"/>
                  <a:pt x="3834764" y="1916078"/>
                </a:cubicBezTo>
                <a:cubicBezTo>
                  <a:pt x="3825088" y="1930592"/>
                  <a:pt x="3820528" y="1950376"/>
                  <a:pt x="3805736" y="1959621"/>
                </a:cubicBezTo>
                <a:cubicBezTo>
                  <a:pt x="3779788" y="1975839"/>
                  <a:pt x="3718650" y="1988650"/>
                  <a:pt x="3718650" y="1988650"/>
                </a:cubicBezTo>
                <a:cubicBezTo>
                  <a:pt x="3665015" y="2069105"/>
                  <a:pt x="3720310" y="2005468"/>
                  <a:pt x="3646079" y="2046707"/>
                </a:cubicBezTo>
                <a:cubicBezTo>
                  <a:pt x="3495688" y="2130257"/>
                  <a:pt x="3628103" y="2096125"/>
                  <a:pt x="3442879" y="2119278"/>
                </a:cubicBezTo>
                <a:cubicBezTo>
                  <a:pt x="3428365" y="2128954"/>
                  <a:pt x="3414938" y="2140506"/>
                  <a:pt x="3399336" y="2148307"/>
                </a:cubicBezTo>
                <a:cubicBezTo>
                  <a:pt x="3360131" y="2167910"/>
                  <a:pt x="3308837" y="2168418"/>
                  <a:pt x="3268707" y="2177336"/>
                </a:cubicBezTo>
                <a:cubicBezTo>
                  <a:pt x="3253772" y="2180655"/>
                  <a:pt x="3239678" y="2187012"/>
                  <a:pt x="3225164" y="2191850"/>
                </a:cubicBezTo>
                <a:cubicBezTo>
                  <a:pt x="3210650" y="2201526"/>
                  <a:pt x="3197955" y="2214753"/>
                  <a:pt x="3181622" y="2220878"/>
                </a:cubicBezTo>
                <a:cubicBezTo>
                  <a:pt x="3158523" y="2229540"/>
                  <a:pt x="3133132" y="2230041"/>
                  <a:pt x="3109050" y="2235393"/>
                </a:cubicBezTo>
                <a:cubicBezTo>
                  <a:pt x="3089577" y="2239720"/>
                  <a:pt x="3070100" y="2244175"/>
                  <a:pt x="3050993" y="2249907"/>
                </a:cubicBezTo>
                <a:cubicBezTo>
                  <a:pt x="3021685" y="2258700"/>
                  <a:pt x="2992936" y="2269260"/>
                  <a:pt x="2963907" y="2278936"/>
                </a:cubicBezTo>
                <a:cubicBezTo>
                  <a:pt x="2949393" y="2283774"/>
                  <a:pt x="2935207" y="2289739"/>
                  <a:pt x="2920364" y="2293450"/>
                </a:cubicBezTo>
                <a:cubicBezTo>
                  <a:pt x="2847464" y="2311675"/>
                  <a:pt x="2881231" y="2301656"/>
                  <a:pt x="2818764" y="2322478"/>
                </a:cubicBezTo>
                <a:cubicBezTo>
                  <a:pt x="2804250" y="2332154"/>
                  <a:pt x="2792579" y="2349771"/>
                  <a:pt x="2775222" y="2351507"/>
                </a:cubicBezTo>
                <a:cubicBezTo>
                  <a:pt x="2258179" y="2403212"/>
                  <a:pt x="2520205" y="2320396"/>
                  <a:pt x="2339793" y="2380536"/>
                </a:cubicBezTo>
                <a:lnTo>
                  <a:pt x="1222193" y="2366021"/>
                </a:lnTo>
                <a:cubicBezTo>
                  <a:pt x="1033277" y="2361298"/>
                  <a:pt x="1334018" y="2346784"/>
                  <a:pt x="1149622" y="2307964"/>
                </a:cubicBezTo>
                <a:cubicBezTo>
                  <a:pt x="1068999" y="2290991"/>
                  <a:pt x="985127" y="2298288"/>
                  <a:pt x="902879" y="2293450"/>
                </a:cubicBezTo>
                <a:cubicBezTo>
                  <a:pt x="774789" y="2208056"/>
                  <a:pt x="979531" y="2339035"/>
                  <a:pt x="772250" y="2235393"/>
                </a:cubicBezTo>
                <a:cubicBezTo>
                  <a:pt x="752898" y="2225717"/>
                  <a:pt x="732979" y="2217099"/>
                  <a:pt x="714193" y="2206364"/>
                </a:cubicBezTo>
                <a:cubicBezTo>
                  <a:pt x="699047" y="2197709"/>
                  <a:pt x="686590" y="2184421"/>
                  <a:pt x="670650" y="2177336"/>
                </a:cubicBezTo>
                <a:cubicBezTo>
                  <a:pt x="625213" y="2157142"/>
                  <a:pt x="573761" y="2145856"/>
                  <a:pt x="525507" y="2133793"/>
                </a:cubicBezTo>
                <a:cubicBezTo>
                  <a:pt x="471324" y="2052516"/>
                  <a:pt x="528584" y="2115466"/>
                  <a:pt x="409393" y="2075736"/>
                </a:cubicBezTo>
                <a:cubicBezTo>
                  <a:pt x="392844" y="2070220"/>
                  <a:pt x="381452" y="2054508"/>
                  <a:pt x="365850" y="2046707"/>
                </a:cubicBezTo>
                <a:cubicBezTo>
                  <a:pt x="352166" y="2039865"/>
                  <a:pt x="336821" y="2037031"/>
                  <a:pt x="322307" y="2032193"/>
                </a:cubicBezTo>
                <a:cubicBezTo>
                  <a:pt x="307793" y="2017679"/>
                  <a:pt x="294533" y="2001791"/>
                  <a:pt x="278764" y="1988650"/>
                </a:cubicBezTo>
                <a:cubicBezTo>
                  <a:pt x="265363" y="1977483"/>
                  <a:pt x="246709" y="1972749"/>
                  <a:pt x="235222" y="1959621"/>
                </a:cubicBezTo>
                <a:cubicBezTo>
                  <a:pt x="212248" y="1933365"/>
                  <a:pt x="177164" y="1872536"/>
                  <a:pt x="177164" y="1872536"/>
                </a:cubicBezTo>
                <a:cubicBezTo>
                  <a:pt x="172326" y="1853183"/>
                  <a:pt x="171571" y="1832320"/>
                  <a:pt x="162650" y="1814478"/>
                </a:cubicBezTo>
                <a:cubicBezTo>
                  <a:pt x="127930" y="1745037"/>
                  <a:pt x="108833" y="1731633"/>
                  <a:pt x="61050" y="1683850"/>
                </a:cubicBezTo>
                <a:cubicBezTo>
                  <a:pt x="34568" y="1604403"/>
                  <a:pt x="39445" y="1639309"/>
                  <a:pt x="61050" y="1509678"/>
                </a:cubicBezTo>
                <a:cubicBezTo>
                  <a:pt x="63565" y="1494587"/>
                  <a:pt x="64746" y="1476954"/>
                  <a:pt x="75564" y="1466136"/>
                </a:cubicBezTo>
                <a:cubicBezTo>
                  <a:pt x="125474" y="1416226"/>
                  <a:pt x="151437" y="1411816"/>
                  <a:pt x="206193" y="1393564"/>
                </a:cubicBezTo>
                <a:cubicBezTo>
                  <a:pt x="273926" y="1291964"/>
                  <a:pt x="235221" y="1325830"/>
                  <a:pt x="307793" y="1277450"/>
                </a:cubicBezTo>
                <a:cubicBezTo>
                  <a:pt x="312631" y="1262936"/>
                  <a:pt x="319306" y="1248909"/>
                  <a:pt x="322307" y="1233907"/>
                </a:cubicBezTo>
                <a:cubicBezTo>
                  <a:pt x="355663" y="1067127"/>
                  <a:pt x="318545" y="1187138"/>
                  <a:pt x="351336" y="1088764"/>
                </a:cubicBezTo>
                <a:cubicBezTo>
                  <a:pt x="346498" y="1069412"/>
                  <a:pt x="349283" y="1046284"/>
                  <a:pt x="336822" y="1030707"/>
                </a:cubicBezTo>
                <a:cubicBezTo>
                  <a:pt x="327265" y="1018760"/>
                  <a:pt x="305226" y="1025750"/>
                  <a:pt x="293279" y="1016193"/>
                </a:cubicBezTo>
                <a:cubicBezTo>
                  <a:pt x="279657" y="1005296"/>
                  <a:pt x="279043" y="981895"/>
                  <a:pt x="264250" y="972650"/>
                </a:cubicBezTo>
                <a:cubicBezTo>
                  <a:pt x="238302" y="956433"/>
                  <a:pt x="202624" y="960594"/>
                  <a:pt x="177164" y="943621"/>
                </a:cubicBezTo>
                <a:cubicBezTo>
                  <a:pt x="120892" y="906106"/>
                  <a:pt x="150170" y="920109"/>
                  <a:pt x="90079" y="900078"/>
                </a:cubicBezTo>
                <a:cubicBezTo>
                  <a:pt x="85241" y="885564"/>
                  <a:pt x="85121" y="868483"/>
                  <a:pt x="75564" y="856536"/>
                </a:cubicBezTo>
                <a:cubicBezTo>
                  <a:pt x="64667" y="842915"/>
                  <a:pt x="41267" y="842299"/>
                  <a:pt x="32022" y="827507"/>
                </a:cubicBezTo>
                <a:cubicBezTo>
                  <a:pt x="15805" y="801559"/>
                  <a:pt x="2993" y="740421"/>
                  <a:pt x="2993" y="740421"/>
                </a:cubicBezTo>
                <a:cubicBezTo>
                  <a:pt x="7831" y="556573"/>
                  <a:pt x="-14196" y="370036"/>
                  <a:pt x="17507" y="188878"/>
                </a:cubicBezTo>
                <a:cubicBezTo>
                  <a:pt x="22782" y="158737"/>
                  <a:pt x="75564" y="169526"/>
                  <a:pt x="104593" y="159850"/>
                </a:cubicBezTo>
                <a:lnTo>
                  <a:pt x="148136" y="145336"/>
                </a:lnTo>
                <a:cubicBezTo>
                  <a:pt x="157812" y="130822"/>
                  <a:pt x="163543" y="112690"/>
                  <a:pt x="177164" y="101793"/>
                </a:cubicBezTo>
                <a:cubicBezTo>
                  <a:pt x="199132" y="84218"/>
                  <a:pt x="224858" y="87278"/>
                  <a:pt x="249736" y="87278"/>
                </a:cubicBezTo>
              </a:path>
            </a:pathLst>
          </a:cu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" name="TextBox 1"/>
          <p:cNvSpPr txBox="1"/>
          <p:nvPr/>
        </p:nvSpPr>
        <p:spPr>
          <a:xfrm>
            <a:off x="1556426" y="554477"/>
            <a:ext cx="6466697" cy="1477328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telectasis </a:t>
            </a:r>
            <a:r>
              <a:rPr lang="mr-IN" dirty="0">
                <a:solidFill>
                  <a:schemeClr val="bg1"/>
                </a:solidFill>
              </a:rPr>
              <a:t>–</a:t>
            </a:r>
            <a:r>
              <a:rPr lang="en-US" dirty="0">
                <a:solidFill>
                  <a:schemeClr val="bg1"/>
                </a:solidFill>
              </a:rPr>
              <a:t> CT scan </a:t>
            </a:r>
            <a:r>
              <a:rPr lang="en-US">
                <a:solidFill>
                  <a:schemeClr val="bg1"/>
                </a:solidFill>
              </a:rPr>
              <a:t>image from (with author permission):</a:t>
            </a:r>
            <a:endParaRPr lang="en-US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Nyman et al. Equine Vet J (1990) 22:317-324</a:t>
            </a:r>
          </a:p>
          <a:p>
            <a:r>
              <a:rPr lang="en-US" dirty="0">
                <a:solidFill>
                  <a:schemeClr val="bg1"/>
                </a:solidFill>
              </a:rPr>
              <a:t>Atelectasis remains during changes in body position unless corrected with ventilation</a:t>
            </a:r>
          </a:p>
        </p:txBody>
      </p:sp>
    </p:spTree>
    <p:extLst>
      <p:ext uri="{BB962C8B-B14F-4D97-AF65-F5344CB8AC3E}">
        <p14:creationId xmlns:p14="http://schemas.microsoft.com/office/powerpoint/2010/main" val="42376313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</p:bld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Salle d’ions">
  <a:themeElements>
    <a:clrScheme name="Ion Boardroom">
      <a:dk1>
        <a:sysClr val="windowText" lastClr="000000"/>
      </a:dk1>
      <a:lt1>
        <a:sysClr val="window" lastClr="FFFFFF"/>
      </a:lt1>
      <a:dk2>
        <a:srgbClr val="0E5580"/>
      </a:dk2>
      <a:lt2>
        <a:srgbClr val="EBEBEB"/>
      </a:lt2>
      <a:accent1>
        <a:srgbClr val="ACD433"/>
      </a:accent1>
      <a:accent2>
        <a:srgbClr val="E6C133"/>
      </a:accent2>
      <a:accent3>
        <a:srgbClr val="EF7A24"/>
      </a:accent3>
      <a:accent4>
        <a:srgbClr val="5AA0F5"/>
      </a:accent4>
      <a:accent5>
        <a:srgbClr val="75CEEC"/>
      </a:accent5>
      <a:accent6>
        <a:srgbClr val="65D6A0"/>
      </a:accent6>
      <a:hlink>
        <a:srgbClr val="C4E46E"/>
      </a:hlink>
      <a:folHlink>
        <a:srgbClr val="BDE0FB"/>
      </a:folHlink>
    </a:clrScheme>
    <a:fontScheme name="Ion Boardroom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 Boardroom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2000"/>
                <a:hueMod val="96000"/>
                <a:satMod val="128000"/>
                <a:lumMod val="114000"/>
              </a:schemeClr>
            </a:gs>
            <a:gs pos="100000">
              <a:schemeClr val="phClr">
                <a:shade val="62000"/>
                <a:hueMod val="100000"/>
                <a:satMod val="134000"/>
                <a:lumMod val="5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2000"/>
                <a:hueMod val="108000"/>
                <a:satMod val="164000"/>
                <a:lumMod val="69000"/>
              </a:schemeClr>
              <a:schemeClr val="phClr">
                <a:tint val="96000"/>
                <a:hueMod val="90000"/>
                <a:satMod val="130000"/>
                <a:lumMod val="134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 Boardroom" id="{FC33163D-4339-46B1-8EED-24C834239D99}" vid="{A3AB87EF-B655-4FFF-8D05-F333AD7F2789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 Boardroom</Template>
  <TotalTime>0</TotalTime>
  <Words>1016</Words>
  <Application>Microsoft Office PowerPoint</Application>
  <PresentationFormat>Widescreen</PresentationFormat>
  <Paragraphs>148</Paragraphs>
  <Slides>2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7" baseType="lpstr">
      <vt:lpstr>Arial</vt:lpstr>
      <vt:lpstr>Calibri</vt:lpstr>
      <vt:lpstr>Century Gothic</vt:lpstr>
      <vt:lpstr>Hoefler Text</vt:lpstr>
      <vt:lpstr>Mangal</vt:lpstr>
      <vt:lpstr>Wingdings 3</vt:lpstr>
      <vt:lpstr>Salle d’ions</vt:lpstr>
      <vt:lpstr>Morbidity &amp; mortality conference</vt:lpstr>
      <vt:lpstr>Aim of M&amp;M conference</vt:lpstr>
      <vt:lpstr>SBAR presentation format</vt:lpstr>
      <vt:lpstr>Situation (SBAR)</vt:lpstr>
      <vt:lpstr>Background (SBAR)</vt:lpstr>
      <vt:lpstr>Anaesthsia – premedication &amp; induction</vt:lpstr>
      <vt:lpstr>Brief review of relevant pulmonary physiology</vt:lpstr>
      <vt:lpstr>PowerPoint Presentation</vt:lpstr>
      <vt:lpstr>PowerPoint Presentation</vt:lpstr>
      <vt:lpstr>Predicted PaO2 from FIO2</vt:lpstr>
      <vt:lpstr>Anaesthesia - maintenance</vt:lpstr>
      <vt:lpstr>Assessment &amp; analysis (SBAR) - Adverse event </vt:lpstr>
      <vt:lpstr>Assessment &amp; analysis (SBAR)  - Transfer</vt:lpstr>
      <vt:lpstr>PowerPoint Presentation</vt:lpstr>
      <vt:lpstr>Assessment &amp; analysis (SBAR)  - Recovery box</vt:lpstr>
      <vt:lpstr>Review of the Literature (SBAR)</vt:lpstr>
      <vt:lpstr>Considerations for managing hypoxemia</vt:lpstr>
      <vt:lpstr>Recommendations (SBAR)</vt:lpstr>
      <vt:lpstr>Aim of M&amp;M conference</vt:lpstr>
      <vt:lpstr>Questions?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onde morbidité &amp; mortalité</dc:title>
  <dc:creator>Frédérik Rousseau-Blass</dc:creator>
  <cp:lastModifiedBy>Daniel Gilfillan</cp:lastModifiedBy>
  <cp:revision>132</cp:revision>
  <dcterms:created xsi:type="dcterms:W3CDTF">2017-10-31T01:04:15Z</dcterms:created>
  <dcterms:modified xsi:type="dcterms:W3CDTF">2018-02-20T09:55:21Z</dcterms:modified>
</cp:coreProperties>
</file>